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webextensions/webextension2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70" r:id="rId2"/>
    <p:sldId id="366" r:id="rId3"/>
    <p:sldId id="36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6314988-9075-4547-DCC7-7EF8E28B7E16}" name="Ben Wielockx" initials="BW" userId="ca51338419742875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6247" autoAdjust="0"/>
  </p:normalViewPr>
  <p:slideViewPr>
    <p:cSldViewPr snapToGrid="0">
      <p:cViewPr varScale="1">
        <p:scale>
          <a:sx n="99" d="100"/>
          <a:sy n="99" d="100"/>
        </p:scale>
        <p:origin x="774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BF6BD9-04AF-4BD6-B3F8-F26463D080DB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D4BE68-D1F7-4644-B4EA-B91B3B69B6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045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469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557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90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594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630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391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482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903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987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225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606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DFE87-B1B2-4C4F-97FF-AB51706A1616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D8382-82FB-4199-AE3A-3BDD60256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923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6.png"/><Relationship Id="rId18" Type="http://schemas.openxmlformats.org/officeDocument/2006/relationships/oleObject" Target="../embeddings/oleObject8.bin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0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8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tags" Target="../tags/tag1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emf"/><Relationship Id="rId10" Type="http://schemas.openxmlformats.org/officeDocument/2006/relationships/image" Target="../media/image4.emf"/><Relationship Id="rId19" Type="http://schemas.openxmlformats.org/officeDocument/2006/relationships/image" Target="../media/image9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15.bin"/><Relationship Id="rId18" Type="http://schemas.openxmlformats.org/officeDocument/2006/relationships/oleObject" Target="../embeddings/oleObject16.bin"/><Relationship Id="rId3" Type="http://schemas.openxmlformats.org/officeDocument/2006/relationships/oleObject" Target="../embeddings/oleObject10.bin"/><Relationship Id="rId21" Type="http://schemas.openxmlformats.org/officeDocument/2006/relationships/image" Target="../media/image22.emf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16.emf"/><Relationship Id="rId17" Type="http://schemas.openxmlformats.org/officeDocument/2006/relationships/image" Target="../media/image20.png"/><Relationship Id="rId25" Type="http://schemas.openxmlformats.org/officeDocument/2006/relationships/image" Target="../media/image25.tiff"/><Relationship Id="rId2" Type="http://schemas.openxmlformats.org/officeDocument/2006/relationships/image" Target="../media/image11.png"/><Relationship Id="rId16" Type="http://schemas.openxmlformats.org/officeDocument/2006/relationships/image" Target="../media/image19.png"/><Relationship Id="rId20" Type="http://schemas.openxmlformats.org/officeDocument/2006/relationships/oleObject" Target="../embeddings/oleObject17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4.bin"/><Relationship Id="rId24" Type="http://schemas.openxmlformats.org/officeDocument/2006/relationships/image" Target="../media/image24.tiff"/><Relationship Id="rId5" Type="http://schemas.openxmlformats.org/officeDocument/2006/relationships/oleObject" Target="../embeddings/oleObject11.bin"/><Relationship Id="rId15" Type="http://schemas.openxmlformats.org/officeDocument/2006/relationships/image" Target="../media/image18.png"/><Relationship Id="rId23" Type="http://schemas.openxmlformats.org/officeDocument/2006/relationships/image" Target="../media/image23.emf"/><Relationship Id="rId10" Type="http://schemas.openxmlformats.org/officeDocument/2006/relationships/image" Target="../media/image15.emf"/><Relationship Id="rId19" Type="http://schemas.openxmlformats.org/officeDocument/2006/relationships/image" Target="../media/image21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17.emf"/><Relationship Id="rId22" Type="http://schemas.openxmlformats.org/officeDocument/2006/relationships/oleObject" Target="../embeddings/oleObject18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13" Type="http://schemas.openxmlformats.org/officeDocument/2006/relationships/image" Target="../media/image31.emf"/><Relationship Id="rId18" Type="http://schemas.openxmlformats.org/officeDocument/2006/relationships/oleObject" Target="../embeddings/oleObject27.bin"/><Relationship Id="rId3" Type="http://schemas.openxmlformats.org/officeDocument/2006/relationships/image" Target="../media/image26.emf"/><Relationship Id="rId7" Type="http://schemas.openxmlformats.org/officeDocument/2006/relationships/image" Target="../media/image28.emf"/><Relationship Id="rId12" Type="http://schemas.openxmlformats.org/officeDocument/2006/relationships/oleObject" Target="../embeddings/oleObject24.bin"/><Relationship Id="rId17" Type="http://schemas.openxmlformats.org/officeDocument/2006/relationships/image" Target="../media/image33.emf"/><Relationship Id="rId2" Type="http://schemas.openxmlformats.org/officeDocument/2006/relationships/oleObject" Target="../embeddings/oleObject19.bin"/><Relationship Id="rId16" Type="http://schemas.openxmlformats.org/officeDocument/2006/relationships/oleObject" Target="../embeddings/oleObject2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1.bin"/><Relationship Id="rId11" Type="http://schemas.openxmlformats.org/officeDocument/2006/relationships/image" Target="../media/image30.emf"/><Relationship Id="rId5" Type="http://schemas.openxmlformats.org/officeDocument/2006/relationships/image" Target="../media/image27.emf"/><Relationship Id="rId15" Type="http://schemas.openxmlformats.org/officeDocument/2006/relationships/image" Target="../media/image32.emf"/><Relationship Id="rId10" Type="http://schemas.openxmlformats.org/officeDocument/2006/relationships/oleObject" Target="../embeddings/oleObject23.bin"/><Relationship Id="rId19" Type="http://schemas.openxmlformats.org/officeDocument/2006/relationships/image" Target="../media/image34.emf"/><Relationship Id="rId4" Type="http://schemas.openxmlformats.org/officeDocument/2006/relationships/oleObject" Target="../embeddings/oleObject20.bin"/><Relationship Id="rId9" Type="http://schemas.openxmlformats.org/officeDocument/2006/relationships/image" Target="../media/image29.emf"/><Relationship Id="rId14" Type="http://schemas.openxmlformats.org/officeDocument/2006/relationships/oleObject" Target="../embeddings/oleObject2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>
            <a:extLst>
              <a:ext uri="{FF2B5EF4-FFF2-40B4-BE49-F238E27FC236}">
                <a16:creationId xmlns:a16="http://schemas.microsoft.com/office/drawing/2014/main" id="{53B5D20A-5D72-4B91-A320-3C75C2345A61}"/>
              </a:ext>
            </a:extLst>
          </p:cNvPr>
          <p:cNvSpPr txBox="1"/>
          <p:nvPr/>
        </p:nvSpPr>
        <p:spPr>
          <a:xfrm>
            <a:off x="4083713" y="305825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69344C-0BB6-461E-A986-5AAEEFB57796}"/>
              </a:ext>
            </a:extLst>
          </p:cNvPr>
          <p:cNvSpPr txBox="1"/>
          <p:nvPr/>
        </p:nvSpPr>
        <p:spPr>
          <a:xfrm>
            <a:off x="1765106" y="3493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D1B8F8FB-07D5-4A57-BB02-49B4E86B83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4093894"/>
              </p:ext>
            </p:extLst>
          </p:nvPr>
        </p:nvGraphicFramePr>
        <p:xfrm>
          <a:off x="7069738" y="613602"/>
          <a:ext cx="1530350" cy="1728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283981" imgH="2581224" progId="Prism10.Document">
                  <p:embed/>
                </p:oleObj>
              </mc:Choice>
              <mc:Fallback>
                <p:oleObj name="Prism 10" r:id="rId3" imgW="2283981" imgH="2581224" progId="Prism10.Document">
                  <p:embed/>
                  <p:pic>
                    <p:nvPicPr>
                      <p:cNvPr id="62" name="Object 61">
                        <a:extLst>
                          <a:ext uri="{FF2B5EF4-FFF2-40B4-BE49-F238E27FC236}">
                            <a16:creationId xmlns:a16="http://schemas.microsoft.com/office/drawing/2014/main" id="{D1B8F8FB-07D5-4A57-BB02-49B4E86B83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069738" y="613602"/>
                        <a:ext cx="1530350" cy="1728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7" name="Object 66">
            <a:extLst>
              <a:ext uri="{FF2B5EF4-FFF2-40B4-BE49-F238E27FC236}">
                <a16:creationId xmlns:a16="http://schemas.microsoft.com/office/drawing/2014/main" id="{906F5EB7-98F7-40F2-AE16-BB68194F38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1713678"/>
              </p:ext>
            </p:extLst>
          </p:nvPr>
        </p:nvGraphicFramePr>
        <p:xfrm>
          <a:off x="5660038" y="632652"/>
          <a:ext cx="1550987" cy="172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297948" imgH="2561487" progId="Prism10.Document">
                  <p:embed/>
                </p:oleObj>
              </mc:Choice>
              <mc:Fallback>
                <p:oleObj name="Prism 10" r:id="rId5" imgW="2297948" imgH="2561487" progId="Prism10.Document">
                  <p:embed/>
                  <p:pic>
                    <p:nvPicPr>
                      <p:cNvPr id="67" name="Object 66">
                        <a:extLst>
                          <a:ext uri="{FF2B5EF4-FFF2-40B4-BE49-F238E27FC236}">
                            <a16:creationId xmlns:a16="http://schemas.microsoft.com/office/drawing/2014/main" id="{906F5EB7-98F7-40F2-AE16-BB68194F38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660038" y="632652"/>
                        <a:ext cx="1550987" cy="172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9" name="Object 68">
            <a:extLst>
              <a:ext uri="{FF2B5EF4-FFF2-40B4-BE49-F238E27FC236}">
                <a16:creationId xmlns:a16="http://schemas.microsoft.com/office/drawing/2014/main" id="{20E2DBA3-BD71-4424-9103-CF482394FA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5026241"/>
              </p:ext>
            </p:extLst>
          </p:nvPr>
        </p:nvGraphicFramePr>
        <p:xfrm>
          <a:off x="8454038" y="624715"/>
          <a:ext cx="1530350" cy="1728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283981" imgH="2581224" progId="Prism10.Document">
                  <p:embed/>
                </p:oleObj>
              </mc:Choice>
              <mc:Fallback>
                <p:oleObj name="Prism 10" r:id="rId7" imgW="2283981" imgH="2581224" progId="Prism10.Document">
                  <p:embed/>
                  <p:pic>
                    <p:nvPicPr>
                      <p:cNvPr id="69" name="Object 68">
                        <a:extLst>
                          <a:ext uri="{FF2B5EF4-FFF2-40B4-BE49-F238E27FC236}">
                            <a16:creationId xmlns:a16="http://schemas.microsoft.com/office/drawing/2014/main" id="{20E2DBA3-BD71-4424-9103-CF482394FA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454038" y="624715"/>
                        <a:ext cx="1530350" cy="1728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" name="Object 70">
            <a:extLst>
              <a:ext uri="{FF2B5EF4-FFF2-40B4-BE49-F238E27FC236}">
                <a16:creationId xmlns:a16="http://schemas.microsoft.com/office/drawing/2014/main" id="{1A3E1A31-C40B-4DF4-8465-D87E1145B7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7195758"/>
              </p:ext>
            </p:extLst>
          </p:nvPr>
        </p:nvGraphicFramePr>
        <p:xfrm>
          <a:off x="4219489" y="648781"/>
          <a:ext cx="1544637" cy="1728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297948" imgH="2572286" progId="Prism10.Document">
                  <p:embed/>
                </p:oleObj>
              </mc:Choice>
              <mc:Fallback>
                <p:oleObj name="Prism 10" r:id="rId9" imgW="2297948" imgH="2572286" progId="Prism10.Document">
                  <p:embed/>
                  <p:pic>
                    <p:nvPicPr>
                      <p:cNvPr id="71" name="Object 70">
                        <a:extLst>
                          <a:ext uri="{FF2B5EF4-FFF2-40B4-BE49-F238E27FC236}">
                            <a16:creationId xmlns:a16="http://schemas.microsoft.com/office/drawing/2014/main" id="{1A3E1A31-C40B-4DF4-8465-D87E1145B7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19489" y="648781"/>
                        <a:ext cx="1544637" cy="1728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DF1125B-32FE-0D9A-87A8-561DD9368E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5449206"/>
              </p:ext>
            </p:extLst>
          </p:nvPr>
        </p:nvGraphicFramePr>
        <p:xfrm>
          <a:off x="1969609" y="613602"/>
          <a:ext cx="1459607" cy="172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305507" imgH="2729229" progId="Prism10.Document">
                  <p:embed/>
                </p:oleObj>
              </mc:Choice>
              <mc:Fallback>
                <p:oleObj name="Prism 10" r:id="rId11" imgW="2305507" imgH="2729229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DF1125B-32FE-0D9A-87A8-561DD9368E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969609" y="613602"/>
                        <a:ext cx="1459607" cy="172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0FD98E58-189B-DD96-AEC1-D908D5376385}"/>
              </a:ext>
            </a:extLst>
          </p:cNvPr>
          <p:cNvSpPr txBox="1"/>
          <p:nvPr/>
        </p:nvSpPr>
        <p:spPr>
          <a:xfrm>
            <a:off x="-6303" y="-1952"/>
            <a:ext cx="1921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ry Figur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06453C-3500-6A7C-ED77-8A4FE820CA14}"/>
              </a:ext>
            </a:extLst>
          </p:cNvPr>
          <p:cNvSpPr txBox="1"/>
          <p:nvPr/>
        </p:nvSpPr>
        <p:spPr>
          <a:xfrm>
            <a:off x="249453" y="2837289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7321D1F2-125D-BFEE-6BAE-36C95D2BE01D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3"/>
          <a:srcRect l="33019" t="22063" r="35683" b="22443"/>
          <a:stretch/>
        </p:blipFill>
        <p:spPr>
          <a:xfrm>
            <a:off x="700220" y="2605882"/>
            <a:ext cx="2579104" cy="319509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1CB8347-ABCE-7E0B-2535-BD42544A39FE}"/>
              </a:ext>
            </a:extLst>
          </p:cNvPr>
          <p:cNvSpPr txBox="1"/>
          <p:nvPr/>
        </p:nvSpPr>
        <p:spPr>
          <a:xfrm>
            <a:off x="3827169" y="3142644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54ADA747-AACC-BDF8-C520-CDF14E9618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1884851"/>
              </p:ext>
            </p:extLst>
          </p:nvPr>
        </p:nvGraphicFramePr>
        <p:xfrm>
          <a:off x="8173951" y="3314194"/>
          <a:ext cx="1843088" cy="215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2353847" imgH="2756619" progId="Prism10.Document">
                  <p:embed/>
                </p:oleObj>
              </mc:Choice>
              <mc:Fallback>
                <p:oleObj name="Prism 10" r:id="rId14" imgW="2353847" imgH="2756619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4ADA747-AACC-BDF8-C520-CDF14E96187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173951" y="3314194"/>
                        <a:ext cx="1843088" cy="2159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B09F9B33-C7DA-F1D2-7CDB-88E96A9EA1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3020826"/>
              </p:ext>
            </p:extLst>
          </p:nvPr>
        </p:nvGraphicFramePr>
        <p:xfrm>
          <a:off x="9813916" y="3313866"/>
          <a:ext cx="185516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2366339" imgH="2755146" progId="Prism10.Document">
                  <p:embed/>
                </p:oleObj>
              </mc:Choice>
              <mc:Fallback>
                <p:oleObj name="Prism 10" r:id="rId16" imgW="2366339" imgH="2755146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B09F9B33-C7DA-F1D2-7CDB-88E96A9EA1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9813916" y="3313866"/>
                        <a:ext cx="185516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EFD2CB1D-574B-5C48-BA60-AFC7C77D4B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2249873"/>
              </p:ext>
            </p:extLst>
          </p:nvPr>
        </p:nvGraphicFramePr>
        <p:xfrm>
          <a:off x="3995486" y="3313866"/>
          <a:ext cx="1725583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2270592" imgH="2841897" progId="Prism10.Document">
                  <p:embed/>
                </p:oleObj>
              </mc:Choice>
              <mc:Fallback>
                <p:oleObj name="Prism 10" r:id="rId18" imgW="2270592" imgH="2841897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EFD2CB1D-574B-5C48-BA60-AFC7C77D4B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995486" y="3313866"/>
                        <a:ext cx="1725583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C2F52CBA-3015-2A67-312A-4967794AD4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9337400"/>
              </p:ext>
            </p:extLst>
          </p:nvPr>
        </p:nvGraphicFramePr>
        <p:xfrm>
          <a:off x="5685280" y="3283074"/>
          <a:ext cx="1778894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0" imgW="2386137" imgH="2896971" progId="Prism10.Document">
                  <p:embed/>
                </p:oleObj>
              </mc:Choice>
              <mc:Fallback>
                <p:oleObj name="Prism 10" r:id="rId20" imgW="2386137" imgH="2896971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C2F52CBA-3015-2A67-312A-4967794AD4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685280" y="3283074"/>
                        <a:ext cx="1778894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1F314542-0F4B-8644-3697-DD5CBCA408EE}"/>
              </a:ext>
            </a:extLst>
          </p:cNvPr>
          <p:cNvSpPr txBox="1"/>
          <p:nvPr/>
        </p:nvSpPr>
        <p:spPr>
          <a:xfrm>
            <a:off x="8032096" y="3159977"/>
            <a:ext cx="272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4E77215-6A4A-1342-B5E2-A2B515693DDB}"/>
              </a:ext>
            </a:extLst>
          </p:cNvPr>
          <p:cNvSpPr txBox="1"/>
          <p:nvPr/>
        </p:nvSpPr>
        <p:spPr>
          <a:xfrm>
            <a:off x="1" y="5713545"/>
            <a:ext cx="1219199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HIF1α-associated steroidogenesis affects the number of hematopoietic stem and progenitor cells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Total bone marrow cell number. (B) Normalized number of LSK and three different HSPC populations in the bone marrow from WT mice and P2H1 littermate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ach graph represents data from at least three independent experiments. (C) Schematic overview of the RNAseq approach representing the sorting of HSC cells from the bone marrow of 5 individual P2H1 mice and 4 individual WT littermates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D) Apoptosis (early/late)/Necrosis of HSCs (from 2 independent experiments) and (E) HSC fractions in G</a:t>
            </a:r>
            <a:r>
              <a:rPr lang="en-GB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r non-G</a:t>
            </a:r>
            <a:r>
              <a:rPr lang="en-GB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hases of the cell cycle measured via FACS (from 3 independent experiments)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ata are presented either as mean ± SEM or as box &amp; whisker plots showing all data points with whiskers from min to max. Statistical significance was determined using a Mann–Whitney U-test or unpaired t-test with Welch’s correction (*p&lt;0.05).  </a:t>
            </a:r>
            <a:endParaRPr lang="en-D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3267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4386659-FDF5-BDE0-4279-EBC742F61BDE}"/>
              </a:ext>
            </a:extLst>
          </p:cNvPr>
          <p:cNvSpPr txBox="1"/>
          <p:nvPr/>
        </p:nvSpPr>
        <p:spPr>
          <a:xfrm>
            <a:off x="-6303" y="-1952"/>
            <a:ext cx="1921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ry Figure 2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5CAC7AB2-96D3-7A6F-A137-69EA8C14EB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819" y="2718588"/>
            <a:ext cx="2031454" cy="190230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5C55B59-DC18-4BDF-7282-B53277DA833F}"/>
              </a:ext>
            </a:extLst>
          </p:cNvPr>
          <p:cNvSpPr txBox="1"/>
          <p:nvPr/>
        </p:nvSpPr>
        <p:spPr>
          <a:xfrm>
            <a:off x="344896" y="2575856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A751B9-57C1-18B4-F3A8-BDD72F1B7870}"/>
              </a:ext>
            </a:extLst>
          </p:cNvPr>
          <p:cNvSpPr txBox="1"/>
          <p:nvPr/>
        </p:nvSpPr>
        <p:spPr>
          <a:xfrm>
            <a:off x="382535" y="54991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E5C38C-9E67-6D61-0D7B-3D7C8CFAEDED}"/>
              </a:ext>
            </a:extLst>
          </p:cNvPr>
          <p:cNvSpPr txBox="1"/>
          <p:nvPr/>
        </p:nvSpPr>
        <p:spPr>
          <a:xfrm>
            <a:off x="437475" y="4741936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graphicFrame>
        <p:nvGraphicFramePr>
          <p:cNvPr id="19" name="Objec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2053386"/>
              </p:ext>
            </p:extLst>
          </p:nvPr>
        </p:nvGraphicFramePr>
        <p:xfrm>
          <a:off x="3168668" y="585876"/>
          <a:ext cx="1585913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314232" imgH="2599592" progId="Prism10.Document">
                  <p:embed/>
                </p:oleObj>
              </mc:Choice>
              <mc:Fallback>
                <p:oleObj name="Prism 10" r:id="rId3" imgW="2314232" imgH="2599592" progId="Prism10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68668" y="585876"/>
                        <a:ext cx="1585913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0" name="TextBox 69"/>
          <p:cNvSpPr txBox="1"/>
          <p:nvPr/>
        </p:nvSpPr>
        <p:spPr>
          <a:xfrm>
            <a:off x="2946775" y="195780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AE8B2FB-40C6-9CB7-DD7C-200C21221704}"/>
              </a:ext>
            </a:extLst>
          </p:cNvPr>
          <p:cNvSpPr txBox="1"/>
          <p:nvPr/>
        </p:nvSpPr>
        <p:spPr>
          <a:xfrm>
            <a:off x="4961299" y="165003"/>
            <a:ext cx="998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Blood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6E41767C-E355-2F78-E276-E6C7AEDA7F5C}"/>
              </a:ext>
            </a:extLst>
          </p:cNvPr>
          <p:cNvCxnSpPr>
            <a:cxnSpLocks/>
          </p:cNvCxnSpPr>
          <p:nvPr/>
        </p:nvCxnSpPr>
        <p:spPr>
          <a:xfrm>
            <a:off x="3197846" y="534181"/>
            <a:ext cx="41589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A8BDDC75-7721-E360-7E62-9740C7EED050}"/>
              </a:ext>
            </a:extLst>
          </p:cNvPr>
          <p:cNvSpPr txBox="1"/>
          <p:nvPr/>
        </p:nvSpPr>
        <p:spPr>
          <a:xfrm>
            <a:off x="5097834" y="2367458"/>
            <a:ext cx="817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leen</a:t>
            </a:r>
          </a:p>
        </p:txBody>
      </p:sp>
      <p:graphicFrame>
        <p:nvGraphicFramePr>
          <p:cNvPr id="93" name="Object 92">
            <a:extLst>
              <a:ext uri="{FF2B5EF4-FFF2-40B4-BE49-F238E27FC236}">
                <a16:creationId xmlns:a16="http://schemas.microsoft.com/office/drawing/2014/main" id="{93A880D2-0596-15B8-692F-21C25B32CD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0862971"/>
              </p:ext>
            </p:extLst>
          </p:nvPr>
        </p:nvGraphicFramePr>
        <p:xfrm>
          <a:off x="6076067" y="2787801"/>
          <a:ext cx="1346200" cy="1549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288302" imgH="2630205" progId="Prism9.Document">
                  <p:embed/>
                </p:oleObj>
              </mc:Choice>
              <mc:Fallback>
                <p:oleObj name="Prism 9" r:id="rId5" imgW="2288302" imgH="2630205" progId="Prism9.Document">
                  <p:embed/>
                  <p:pic>
                    <p:nvPicPr>
                      <p:cNvPr id="93" name="Object 92">
                        <a:extLst>
                          <a:ext uri="{FF2B5EF4-FFF2-40B4-BE49-F238E27FC236}">
                            <a16:creationId xmlns:a16="http://schemas.microsoft.com/office/drawing/2014/main" id="{93A880D2-0596-15B8-692F-21C25B32CD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76067" y="2787801"/>
                        <a:ext cx="1346200" cy="1549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4" name="Object 93">
            <a:extLst>
              <a:ext uri="{FF2B5EF4-FFF2-40B4-BE49-F238E27FC236}">
                <a16:creationId xmlns:a16="http://schemas.microsoft.com/office/drawing/2014/main" id="{E613FBA4-431A-FB38-750A-94C39270B0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3085413"/>
              </p:ext>
            </p:extLst>
          </p:nvPr>
        </p:nvGraphicFramePr>
        <p:xfrm>
          <a:off x="4650877" y="2795739"/>
          <a:ext cx="1350963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288302" imgH="2593469" progId="Prism9.Document">
                  <p:embed/>
                </p:oleObj>
              </mc:Choice>
              <mc:Fallback>
                <p:oleObj name="Prism 9" r:id="rId7" imgW="2288302" imgH="2593469" progId="Prism9.Document">
                  <p:embed/>
                  <p:pic>
                    <p:nvPicPr>
                      <p:cNvPr id="94" name="Object 93">
                        <a:extLst>
                          <a:ext uri="{FF2B5EF4-FFF2-40B4-BE49-F238E27FC236}">
                            <a16:creationId xmlns:a16="http://schemas.microsoft.com/office/drawing/2014/main" id="{E613FBA4-431A-FB38-750A-94C39270B0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50877" y="2795739"/>
                        <a:ext cx="1350963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5" name="Object 94">
            <a:extLst>
              <a:ext uri="{FF2B5EF4-FFF2-40B4-BE49-F238E27FC236}">
                <a16:creationId xmlns:a16="http://schemas.microsoft.com/office/drawing/2014/main" id="{C4B922D8-9DDE-868D-B3DD-C7E8B64B09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7736786"/>
              </p:ext>
            </p:extLst>
          </p:nvPr>
        </p:nvGraphicFramePr>
        <p:xfrm>
          <a:off x="3263195" y="2780954"/>
          <a:ext cx="1350963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288302" imgH="2593469" progId="Prism9.Document">
                  <p:embed/>
                </p:oleObj>
              </mc:Choice>
              <mc:Fallback>
                <p:oleObj name="Prism 9" r:id="rId9" imgW="2288302" imgH="2593469" progId="Prism9.Document">
                  <p:embed/>
                  <p:pic>
                    <p:nvPicPr>
                      <p:cNvPr id="95" name="Object 94">
                        <a:extLst>
                          <a:ext uri="{FF2B5EF4-FFF2-40B4-BE49-F238E27FC236}">
                            <a16:creationId xmlns:a16="http://schemas.microsoft.com/office/drawing/2014/main" id="{C4B922D8-9DDE-868D-B3DD-C7E8B64B09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63195" y="2780954"/>
                        <a:ext cx="1350963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6" name="TextBox 95">
            <a:extLst>
              <a:ext uri="{FF2B5EF4-FFF2-40B4-BE49-F238E27FC236}">
                <a16:creationId xmlns:a16="http://schemas.microsoft.com/office/drawing/2014/main" id="{8D1A1DEA-F3B8-303F-5DAB-5990E18228D8}"/>
              </a:ext>
            </a:extLst>
          </p:cNvPr>
          <p:cNvSpPr txBox="1"/>
          <p:nvPr/>
        </p:nvSpPr>
        <p:spPr>
          <a:xfrm>
            <a:off x="3010886" y="2438633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98524BD-77C8-3F2F-46C3-A6A0E0FD5E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5213009"/>
              </p:ext>
            </p:extLst>
          </p:nvPr>
        </p:nvGraphicFramePr>
        <p:xfrm>
          <a:off x="6033921" y="573256"/>
          <a:ext cx="14400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311351" imgH="2599592" progId="Prism10.Document">
                  <p:embed/>
                </p:oleObj>
              </mc:Choice>
              <mc:Fallback>
                <p:oleObj name="Prism 10" r:id="rId11" imgW="2311351" imgH="2599592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98524BD-77C8-3F2F-46C3-A6A0E0FD5E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033921" y="573256"/>
                        <a:ext cx="144000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44AE8800-14DF-BF0F-72B8-DA18A737F9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0689136"/>
              </p:ext>
            </p:extLst>
          </p:nvPr>
        </p:nvGraphicFramePr>
        <p:xfrm>
          <a:off x="4628160" y="579566"/>
          <a:ext cx="1447907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323596" imgH="2599592" progId="Prism10.Document">
                  <p:embed/>
                </p:oleObj>
              </mc:Choice>
              <mc:Fallback>
                <p:oleObj name="Prism 10" r:id="rId13" imgW="2323596" imgH="2599592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4AE8800-14DF-BF0F-72B8-DA18A737F9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628160" y="579566"/>
                        <a:ext cx="1447907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5EB27251-EEE7-806F-209B-ECBC1BF8CD2F}"/>
              </a:ext>
            </a:extLst>
          </p:cNvPr>
          <p:cNvCxnSpPr>
            <a:cxnSpLocks/>
          </p:cNvCxnSpPr>
          <p:nvPr/>
        </p:nvCxnSpPr>
        <p:spPr>
          <a:xfrm>
            <a:off x="3276385" y="2740860"/>
            <a:ext cx="41589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7975627" y="703800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G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7979086" y="2696185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CAFCC5EF-88CD-C287-0D2D-381C429DB8E4}"/>
              </a:ext>
            </a:extLst>
          </p:cNvPr>
          <p:cNvGrpSpPr/>
          <p:nvPr/>
        </p:nvGrpSpPr>
        <p:grpSpPr>
          <a:xfrm>
            <a:off x="8193424" y="737860"/>
            <a:ext cx="3443682" cy="1943541"/>
            <a:chOff x="8376448" y="1548063"/>
            <a:chExt cx="3443682" cy="1943541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8376448" y="1802282"/>
              <a:ext cx="1598984" cy="1574000"/>
            </a:xfrm>
            <a:prstGeom prst="rect">
              <a:avLst/>
            </a:prstGeom>
          </p:spPr>
        </p:pic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6569BB7A-C70A-7D69-D550-BD6D32954D83}"/>
                </a:ext>
              </a:extLst>
            </p:cNvPr>
            <p:cNvGrpSpPr/>
            <p:nvPr/>
          </p:nvGrpSpPr>
          <p:grpSpPr>
            <a:xfrm>
              <a:off x="8376448" y="1548063"/>
              <a:ext cx="3443682" cy="1943541"/>
              <a:chOff x="8376448" y="1548063"/>
              <a:chExt cx="3443682" cy="1943541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10221146" y="1845511"/>
                <a:ext cx="1598984" cy="1574000"/>
              </a:xfrm>
              <a:prstGeom prst="rect">
                <a:avLst/>
              </a:prstGeom>
            </p:spPr>
          </p:pic>
          <p:cxnSp>
            <p:nvCxnSpPr>
              <p:cNvPr id="30" name="Straight Arrow Connector 29"/>
              <p:cNvCxnSpPr>
                <a:cxnSpLocks/>
              </p:cNvCxnSpPr>
              <p:nvPr/>
            </p:nvCxnSpPr>
            <p:spPr>
              <a:xfrm flipV="1">
                <a:off x="8525391" y="2697081"/>
                <a:ext cx="0" cy="642320"/>
              </a:xfrm>
              <a:prstGeom prst="straightConnector1">
                <a:avLst/>
              </a:prstGeom>
              <a:ln w="222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9098702" y="3214605"/>
                <a:ext cx="4853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API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6200000">
                <a:off x="8107977" y="2161107"/>
                <a:ext cx="8139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/>
                  <a:t>Annexin</a:t>
                </a:r>
                <a:r>
                  <a:rPr lang="en-US" sz="1200" dirty="0"/>
                  <a:t> V</a:t>
                </a:r>
              </a:p>
            </p:txBody>
          </p:sp>
          <p:cxnSp>
            <p:nvCxnSpPr>
              <p:cNvPr id="33" name="Straight Arrow Connector 32"/>
              <p:cNvCxnSpPr>
                <a:cxnSpLocks/>
              </p:cNvCxnSpPr>
              <p:nvPr/>
            </p:nvCxnSpPr>
            <p:spPr>
              <a:xfrm>
                <a:off x="10210200" y="3329493"/>
                <a:ext cx="613762" cy="0"/>
              </a:xfrm>
              <a:prstGeom prst="straightConnector1">
                <a:avLst/>
              </a:prstGeom>
              <a:ln w="222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Arrow Connector 33"/>
              <p:cNvCxnSpPr>
                <a:cxnSpLocks/>
              </p:cNvCxnSpPr>
              <p:nvPr/>
            </p:nvCxnSpPr>
            <p:spPr>
              <a:xfrm flipV="1">
                <a:off x="10221146" y="2646589"/>
                <a:ext cx="0" cy="686547"/>
              </a:xfrm>
              <a:prstGeom prst="straightConnector1">
                <a:avLst/>
              </a:prstGeom>
              <a:ln w="222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>
                <a:off x="9040130" y="1548063"/>
                <a:ext cx="5020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WT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0728471" y="1552197"/>
                <a:ext cx="6815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2H1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0823962" y="3182698"/>
                <a:ext cx="4853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API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6200000">
                <a:off x="9803669" y="2092420"/>
                <a:ext cx="8139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/>
                  <a:t>Annexin</a:t>
                </a:r>
                <a:r>
                  <a:rPr lang="en-US" sz="1200" dirty="0"/>
                  <a:t> V</a:t>
                </a:r>
              </a:p>
            </p:txBody>
          </p: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C0A6D0AA-E77C-27AA-B074-82BD5BECD2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13810" y="3348827"/>
                <a:ext cx="613762" cy="0"/>
              </a:xfrm>
              <a:prstGeom prst="straightConnector1">
                <a:avLst/>
              </a:prstGeom>
              <a:ln w="222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2" name="TextBox 21"/>
          <p:cNvSpPr txBox="1"/>
          <p:nvPr/>
        </p:nvSpPr>
        <p:spPr>
          <a:xfrm>
            <a:off x="2976280" y="4491517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</a:t>
            </a:r>
          </a:p>
        </p:txBody>
      </p:sp>
      <p:pic>
        <p:nvPicPr>
          <p:cNvPr id="21" name="Grafik 250">
            <a:extLst>
              <a:ext uri="{FF2B5EF4-FFF2-40B4-BE49-F238E27FC236}">
                <a16:creationId xmlns:a16="http://schemas.microsoft.com/office/drawing/2014/main" id="{39C6A604-7E43-289F-52AC-15FAB91E603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283718" y="4668333"/>
            <a:ext cx="2108040" cy="2024903"/>
          </a:xfrm>
          <a:prstGeom prst="rect">
            <a:avLst/>
          </a:prstGeom>
        </p:spPr>
      </p:pic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EEED2FCC-E145-3561-A330-FA787A7B43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9567807"/>
              </p:ext>
            </p:extLst>
          </p:nvPr>
        </p:nvGraphicFramePr>
        <p:xfrm>
          <a:off x="8202995" y="2811824"/>
          <a:ext cx="1282671" cy="15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2288302" imgH="2758060" progId="Prism10.Document">
                  <p:embed/>
                </p:oleObj>
              </mc:Choice>
              <mc:Fallback>
                <p:oleObj name="Prism 10" r:id="rId18" imgW="2288302" imgH="2758060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EEED2FCC-E145-3561-A330-FA787A7B43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8202995" y="2811824"/>
                        <a:ext cx="1282671" cy="15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0BE9B9B6-12DD-4E15-DAED-92F42F10B3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8121485"/>
              </p:ext>
            </p:extLst>
          </p:nvPr>
        </p:nvGraphicFramePr>
        <p:xfrm>
          <a:off x="9356721" y="2804073"/>
          <a:ext cx="1284217" cy="15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0" imgW="2288302" imgH="2758060" progId="Prism10.Document">
                  <p:embed/>
                </p:oleObj>
              </mc:Choice>
              <mc:Fallback>
                <p:oleObj name="Prism 10" r:id="rId20" imgW="2288302" imgH="2758060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0BE9B9B6-12DD-4E15-DAED-92F42F10B3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9356721" y="2804073"/>
                        <a:ext cx="1284217" cy="15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02C2BE7E-311F-0D27-3B4D-E1DC4F82F0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6381282"/>
              </p:ext>
            </p:extLst>
          </p:nvPr>
        </p:nvGraphicFramePr>
        <p:xfrm>
          <a:off x="10674544" y="2806438"/>
          <a:ext cx="1284217" cy="15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2" imgW="2288302" imgH="2758060" progId="Prism10.Document">
                  <p:embed/>
                </p:oleObj>
              </mc:Choice>
              <mc:Fallback>
                <p:oleObj name="Prism 10" r:id="rId22" imgW="2288302" imgH="2758060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02C2BE7E-311F-0D27-3B4D-E1DC4F82F0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0674544" y="2806438"/>
                        <a:ext cx="1284217" cy="15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924FFD0-C995-0D31-33E7-BE94E2CC0AF0}"/>
              </a:ext>
            </a:extLst>
          </p:cNvPr>
          <p:cNvSpPr txBox="1"/>
          <p:nvPr/>
        </p:nvSpPr>
        <p:spPr>
          <a:xfrm>
            <a:off x="1008219" y="2155989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/>
              <a:t>CD4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DD2746-1959-6F83-5ECB-4D929ECD1CB4}"/>
              </a:ext>
            </a:extLst>
          </p:cNvPr>
          <p:cNvSpPr txBox="1"/>
          <p:nvPr/>
        </p:nvSpPr>
        <p:spPr>
          <a:xfrm rot="16200000">
            <a:off x="400140" y="1650241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/>
              <a:t>CD16/32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14991C02-F2CC-184E-BA70-31EDD8DEE90A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864274" y="735119"/>
            <a:ext cx="1438197" cy="1438197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7935686-F026-257C-7724-9B593322B9C1}"/>
              </a:ext>
            </a:extLst>
          </p:cNvPr>
          <p:cNvSpPr txBox="1"/>
          <p:nvPr/>
        </p:nvSpPr>
        <p:spPr>
          <a:xfrm>
            <a:off x="954994" y="585876"/>
            <a:ext cx="14189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G</a:t>
            </a:r>
            <a:r>
              <a:rPr lang="en-DE" sz="1000" dirty="0"/>
              <a:t>ated on Lin-Sca1-cKit+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5B6D6AD-4F65-AC63-7C4E-4AF0DE052E65}"/>
              </a:ext>
            </a:extLst>
          </p:cNvPr>
          <p:cNvCxnSpPr/>
          <p:nvPr/>
        </p:nvCxnSpPr>
        <p:spPr>
          <a:xfrm>
            <a:off x="1470011" y="2289768"/>
            <a:ext cx="37768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ECE27AAC-1789-9EE4-AE75-0F05C189120B}"/>
              </a:ext>
            </a:extLst>
          </p:cNvPr>
          <p:cNvCxnSpPr>
            <a:cxnSpLocks/>
          </p:cNvCxnSpPr>
          <p:nvPr/>
        </p:nvCxnSpPr>
        <p:spPr>
          <a:xfrm flipH="1" flipV="1">
            <a:off x="756049" y="1172542"/>
            <a:ext cx="7301" cy="2887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ACF484D-CC01-BE0B-F9A4-1AB1A533E814}"/>
              </a:ext>
            </a:extLst>
          </p:cNvPr>
          <p:cNvGrpSpPr/>
          <p:nvPr/>
        </p:nvGrpSpPr>
        <p:grpSpPr>
          <a:xfrm>
            <a:off x="624612" y="4796199"/>
            <a:ext cx="1773350" cy="1881329"/>
            <a:chOff x="569672" y="4892819"/>
            <a:chExt cx="1773350" cy="1881329"/>
          </a:xfrm>
        </p:grpSpPr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E682045A-1152-58F1-7FA6-21F97C7AD479}"/>
                </a:ext>
              </a:extLst>
            </p:cNvPr>
            <p:cNvGrpSpPr/>
            <p:nvPr/>
          </p:nvGrpSpPr>
          <p:grpSpPr>
            <a:xfrm>
              <a:off x="569672" y="4892819"/>
              <a:ext cx="1747912" cy="1881329"/>
              <a:chOff x="4606603" y="3132085"/>
              <a:chExt cx="1747912" cy="1881329"/>
            </a:xfrm>
          </p:grpSpPr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941FD1AE-4A08-FB21-4D72-B42728BF61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4833854" y="3291799"/>
                <a:ext cx="1449745" cy="1449745"/>
              </a:xfrm>
              <a:prstGeom prst="rect">
                <a:avLst/>
              </a:prstGeom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677815A2-12F6-FB2D-83B4-5BE13CA9C3DB}"/>
                  </a:ext>
                </a:extLst>
              </p:cNvPr>
              <p:cNvSpPr txBox="1"/>
              <p:nvPr/>
            </p:nvSpPr>
            <p:spPr>
              <a:xfrm>
                <a:off x="4954773" y="3132085"/>
                <a:ext cx="13997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G</a:t>
                </a:r>
                <a:r>
                  <a:rPr lang="en-DE" sz="1000" dirty="0"/>
                  <a:t>ated on CD11b+Ly6G-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253DCD51-AE21-234A-19AF-39AA8C38C924}"/>
                  </a:ext>
                </a:extLst>
              </p:cNvPr>
              <p:cNvSpPr txBox="1"/>
              <p:nvPr/>
            </p:nvSpPr>
            <p:spPr>
              <a:xfrm rot="16200000">
                <a:off x="4473233" y="4350960"/>
                <a:ext cx="5437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DE" sz="1200" dirty="0"/>
                  <a:t>SSC-A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5FAB34A0-CF80-C556-C494-656E1016089C}"/>
                  </a:ext>
                </a:extLst>
              </p:cNvPr>
              <p:cNvSpPr txBox="1"/>
              <p:nvPr/>
            </p:nvSpPr>
            <p:spPr>
              <a:xfrm>
                <a:off x="4954773" y="4736415"/>
                <a:ext cx="4720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DE" sz="1200" dirty="0"/>
                  <a:t>Ly6C</a:t>
                </a:r>
              </a:p>
            </p:txBody>
          </p:sp>
          <p:cxnSp>
            <p:nvCxnSpPr>
              <p:cNvPr id="47" name="Straight Arrow Connector 46">
                <a:extLst>
                  <a:ext uri="{FF2B5EF4-FFF2-40B4-BE49-F238E27FC236}">
                    <a16:creationId xmlns:a16="http://schemas.microsoft.com/office/drawing/2014/main" id="{2F59247C-801C-A3F8-349C-293360838ED9}"/>
                  </a:ext>
                </a:extLst>
              </p:cNvPr>
              <p:cNvCxnSpPr/>
              <p:nvPr/>
            </p:nvCxnSpPr>
            <p:spPr>
              <a:xfrm>
                <a:off x="5430470" y="4864975"/>
                <a:ext cx="37768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>
                <a:extLst>
                  <a:ext uri="{FF2B5EF4-FFF2-40B4-BE49-F238E27FC236}">
                    <a16:creationId xmlns:a16="http://schemas.microsoft.com/office/drawing/2014/main" id="{22F3BA01-3871-3F56-C24B-4EC6715BEE9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733067" y="3985289"/>
                <a:ext cx="7301" cy="28870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2C3EEBE-EE0C-DEF2-1556-5F606839FDA0}"/>
                </a:ext>
              </a:extLst>
            </p:cNvPr>
            <p:cNvGrpSpPr/>
            <p:nvPr/>
          </p:nvGrpSpPr>
          <p:grpSpPr>
            <a:xfrm>
              <a:off x="1829061" y="5098820"/>
              <a:ext cx="513961" cy="169277"/>
              <a:chOff x="1829061" y="5098820"/>
              <a:chExt cx="513961" cy="169277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12103CA8-8CE7-F341-9716-5163E3A448F5}"/>
                  </a:ext>
                </a:extLst>
              </p:cNvPr>
              <p:cNvSpPr/>
              <p:nvPr/>
            </p:nvSpPr>
            <p:spPr>
              <a:xfrm>
                <a:off x="1896455" y="5146333"/>
                <a:ext cx="331163" cy="7717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DE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EE56A41-D802-1835-8B65-2A41D2414151}"/>
                  </a:ext>
                </a:extLst>
              </p:cNvPr>
              <p:cNvSpPr txBox="1"/>
              <p:nvPr/>
            </p:nvSpPr>
            <p:spPr>
              <a:xfrm>
                <a:off x="1829061" y="5098820"/>
                <a:ext cx="51396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 b="1" dirty="0"/>
                  <a:t>Eosinophils</a:t>
                </a:r>
                <a:endParaRPr lang="en-DE" sz="500" b="1" dirty="0"/>
              </a:p>
            </p:txBody>
          </p:sp>
        </p:grp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EF667407-1631-7B0C-9CCF-5157C589A595}"/>
              </a:ext>
            </a:extLst>
          </p:cNvPr>
          <p:cNvSpPr txBox="1"/>
          <p:nvPr/>
        </p:nvSpPr>
        <p:spPr>
          <a:xfrm>
            <a:off x="5789980" y="4434289"/>
            <a:ext cx="6108700" cy="2492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HIF1α-associated steroidogenesis affects mature myeloid cells and lymphocytes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-C and F) FACS gating strategy for identification of hematopoietic progenitor cells in the BM or spleen by staining surface markers as detailed in the Methods section. (D-E) Normalized number of myeloid cells in the blood and spleen from WT mice and P2H1 littermate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ata points represent individual mice from at least three different experiments - normalized values against average of WT controls. Data are presented either as mean ± SEM or as box &amp; whisker plots showing all data points with whiskers from min to max. Statistical significance was determined using a Mann–Whitney U-test or unpaired t-test with Welch’s correction (*p&lt;0.05). (G-H) FACS gating strategy of the apoptosis experiment (lower left quadrant: viable cells – higher left quadrant: early apoptotic cells and upper right quadrant: late apoptotic and necrotic cells). Graphs represent the % of Treg cells (normalized) in one of the three quadrants from P2H1 and WT littermates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Data representative of at least 2 independent experiments)</a:t>
            </a:r>
            <a:endParaRPr lang="en-D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54535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6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36D0FF1E-92DD-4810-955D-208CB43E60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7339282"/>
              </p:ext>
            </p:extLst>
          </p:nvPr>
        </p:nvGraphicFramePr>
        <p:xfrm>
          <a:off x="7711684" y="1248971"/>
          <a:ext cx="1350963" cy="1611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283981" imgH="2727447" progId="Prism9.Document">
                  <p:embed/>
                </p:oleObj>
              </mc:Choice>
              <mc:Fallback>
                <p:oleObj name="Prism 9" r:id="rId2" imgW="2283981" imgH="2727447" progId="Prism9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36D0FF1E-92DD-4810-955D-208CB43E60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711684" y="1248971"/>
                        <a:ext cx="1350963" cy="1611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3CB32479-89B0-4DA4-B1D5-8316426B36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9480795"/>
              </p:ext>
            </p:extLst>
          </p:nvPr>
        </p:nvGraphicFramePr>
        <p:xfrm>
          <a:off x="6260709" y="1258496"/>
          <a:ext cx="1349375" cy="1611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283981" imgH="2727447" progId="Prism9.Document">
                  <p:embed/>
                </p:oleObj>
              </mc:Choice>
              <mc:Fallback>
                <p:oleObj name="Prism 9" r:id="rId4" imgW="2283981" imgH="2727447" progId="Prism9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3CB32479-89B0-4DA4-B1D5-8316426B36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60709" y="1258496"/>
                        <a:ext cx="1349375" cy="1611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2C6054F9-6509-4C74-BEE6-0B1E3964C5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5066654"/>
              </p:ext>
            </p:extLst>
          </p:nvPr>
        </p:nvGraphicFramePr>
        <p:xfrm>
          <a:off x="1420436" y="1200371"/>
          <a:ext cx="1349375" cy="161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283981" imgH="2727447" progId="Prism10.Document">
                  <p:embed/>
                </p:oleObj>
              </mc:Choice>
              <mc:Fallback>
                <p:oleObj name="Prism 10" r:id="rId6" imgW="2283981" imgH="2727447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2C6054F9-6509-4C74-BEE6-0B1E3964C5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20436" y="1200371"/>
                        <a:ext cx="1349375" cy="161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2FA875BC-EC2D-4485-9DEF-0F0D06921D39}"/>
              </a:ext>
            </a:extLst>
          </p:cNvPr>
          <p:cNvSpPr txBox="1"/>
          <p:nvPr/>
        </p:nvSpPr>
        <p:spPr>
          <a:xfrm>
            <a:off x="1029974" y="104648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7367D34-2989-27B5-0889-64EE297934AF}"/>
              </a:ext>
            </a:extLst>
          </p:cNvPr>
          <p:cNvSpPr txBox="1"/>
          <p:nvPr/>
        </p:nvSpPr>
        <p:spPr>
          <a:xfrm>
            <a:off x="-6303" y="-1952"/>
            <a:ext cx="1921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ry Figure 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3D3DD76-723B-E14C-21DB-17B24E3732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804107"/>
              </p:ext>
            </p:extLst>
          </p:nvPr>
        </p:nvGraphicFramePr>
        <p:xfrm>
          <a:off x="9062647" y="1240284"/>
          <a:ext cx="1361632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292984" imgH="2727447" progId="Prism10.Document">
                  <p:embed/>
                </p:oleObj>
              </mc:Choice>
              <mc:Fallback>
                <p:oleObj name="Prism 10" r:id="rId8" imgW="2292984" imgH="2727447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3D3DD76-723B-E14C-21DB-17B24E3732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062647" y="1240284"/>
                        <a:ext cx="1361632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A7CD0D3-92A1-534C-FEA9-67966C85E2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690271"/>
              </p:ext>
            </p:extLst>
          </p:nvPr>
        </p:nvGraphicFramePr>
        <p:xfrm>
          <a:off x="4714766" y="1258496"/>
          <a:ext cx="1444343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2283981" imgH="2562856" progId="Prism10.Document">
                  <p:embed/>
                </p:oleObj>
              </mc:Choice>
              <mc:Fallback>
                <p:oleObj name="Prism 10" r:id="rId10" imgW="2283981" imgH="2562856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A7CD0D3-92A1-534C-FEA9-67966C85E2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714766" y="1258496"/>
                        <a:ext cx="1444343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04A96DD6-0CF1-4FDE-B605-0637A725A517}"/>
              </a:ext>
            </a:extLst>
          </p:cNvPr>
          <p:cNvCxnSpPr>
            <a:cxnSpLocks/>
          </p:cNvCxnSpPr>
          <p:nvPr/>
        </p:nvCxnSpPr>
        <p:spPr>
          <a:xfrm>
            <a:off x="4690018" y="1104661"/>
            <a:ext cx="55354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ECE8B993-6FAB-472D-AEA9-F62BC47AB70F}"/>
              </a:ext>
            </a:extLst>
          </p:cNvPr>
          <p:cNvSpPr txBox="1"/>
          <p:nvPr/>
        </p:nvSpPr>
        <p:spPr>
          <a:xfrm>
            <a:off x="6897120" y="677151"/>
            <a:ext cx="1472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one Marrow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55009BC-4681-4EB9-9F98-00A0C1EBD0A7}"/>
              </a:ext>
            </a:extLst>
          </p:cNvPr>
          <p:cNvSpPr txBox="1"/>
          <p:nvPr/>
        </p:nvSpPr>
        <p:spPr>
          <a:xfrm>
            <a:off x="4216239" y="624236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graphicFrame>
        <p:nvGraphicFramePr>
          <p:cNvPr id="51" name="Object 50">
            <a:extLst>
              <a:ext uri="{FF2B5EF4-FFF2-40B4-BE49-F238E27FC236}">
                <a16:creationId xmlns:a16="http://schemas.microsoft.com/office/drawing/2014/main" id="{318A1D97-CC77-80CA-B2C0-5CBC89645B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740444"/>
              </p:ext>
            </p:extLst>
          </p:nvPr>
        </p:nvGraphicFramePr>
        <p:xfrm>
          <a:off x="2711884" y="3829683"/>
          <a:ext cx="1341912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2282180" imgH="2755178" progId="Prism10.Document">
                  <p:embed/>
                </p:oleObj>
              </mc:Choice>
              <mc:Fallback>
                <p:oleObj name="Prism 10" r:id="rId12" imgW="2282180" imgH="2755178" progId="Prism10.Document">
                  <p:embed/>
                  <p:pic>
                    <p:nvPicPr>
                      <p:cNvPr id="51" name="Object 50">
                        <a:extLst>
                          <a:ext uri="{FF2B5EF4-FFF2-40B4-BE49-F238E27FC236}">
                            <a16:creationId xmlns:a16="http://schemas.microsoft.com/office/drawing/2014/main" id="{318A1D97-CC77-80CA-B2C0-5CBC89645B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711884" y="3829683"/>
                        <a:ext cx="1341912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51">
            <a:extLst>
              <a:ext uri="{FF2B5EF4-FFF2-40B4-BE49-F238E27FC236}">
                <a16:creationId xmlns:a16="http://schemas.microsoft.com/office/drawing/2014/main" id="{3126A89D-A387-4F49-98E6-A7F6D5E26A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2059744"/>
              </p:ext>
            </p:extLst>
          </p:nvPr>
        </p:nvGraphicFramePr>
        <p:xfrm>
          <a:off x="4009587" y="3829682"/>
          <a:ext cx="1341912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2282180" imgH="2755178" progId="Prism10.Document">
                  <p:embed/>
                </p:oleObj>
              </mc:Choice>
              <mc:Fallback>
                <p:oleObj name="Prism 10" r:id="rId14" imgW="2282180" imgH="2755178" progId="Prism10.Document">
                  <p:embed/>
                  <p:pic>
                    <p:nvPicPr>
                      <p:cNvPr id="52" name="Object 51">
                        <a:extLst>
                          <a:ext uri="{FF2B5EF4-FFF2-40B4-BE49-F238E27FC236}">
                            <a16:creationId xmlns:a16="http://schemas.microsoft.com/office/drawing/2014/main" id="{3126A89D-A387-4F49-98E6-A7F6D5E26A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009587" y="3829682"/>
                        <a:ext cx="1341912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B563FC0B-8E1F-BB06-3146-4CB283A21A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4796602"/>
              </p:ext>
            </p:extLst>
          </p:nvPr>
        </p:nvGraphicFramePr>
        <p:xfrm>
          <a:off x="5313277" y="3835282"/>
          <a:ext cx="1346567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2282180" imgH="2745814" progId="Prism10.Document">
                  <p:embed/>
                </p:oleObj>
              </mc:Choice>
              <mc:Fallback>
                <p:oleObj name="Prism 10" r:id="rId16" imgW="2282180" imgH="2745814" progId="Prism10.Document">
                  <p:embed/>
                  <p:pic>
                    <p:nvPicPr>
                      <p:cNvPr id="59" name="Object 58">
                        <a:extLst>
                          <a:ext uri="{FF2B5EF4-FFF2-40B4-BE49-F238E27FC236}">
                            <a16:creationId xmlns:a16="http://schemas.microsoft.com/office/drawing/2014/main" id="{B563FC0B-8E1F-BB06-3146-4CB283A21A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313277" y="3835282"/>
                        <a:ext cx="1346567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Box 59">
            <a:extLst>
              <a:ext uri="{FF2B5EF4-FFF2-40B4-BE49-F238E27FC236}">
                <a16:creationId xmlns:a16="http://schemas.microsoft.com/office/drawing/2014/main" id="{19A4E252-7ABB-9CEA-478B-D57D829FC999}"/>
              </a:ext>
            </a:extLst>
          </p:cNvPr>
          <p:cNvSpPr txBox="1"/>
          <p:nvPr/>
        </p:nvSpPr>
        <p:spPr>
          <a:xfrm>
            <a:off x="4369757" y="3314409"/>
            <a:ext cx="838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Spleen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15F2882F-05F5-597C-E8D7-75C28E918020}"/>
              </a:ext>
            </a:extLst>
          </p:cNvPr>
          <p:cNvCxnSpPr>
            <a:cxnSpLocks/>
          </p:cNvCxnSpPr>
          <p:nvPr/>
        </p:nvCxnSpPr>
        <p:spPr>
          <a:xfrm>
            <a:off x="2799606" y="3689341"/>
            <a:ext cx="37808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A42972B-4276-F7ED-CAA0-A5BFA866F1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1082857"/>
              </p:ext>
            </p:extLst>
          </p:nvPr>
        </p:nvGraphicFramePr>
        <p:xfrm>
          <a:off x="8150580" y="3683741"/>
          <a:ext cx="1430338" cy="1620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2286862" imgH="2593469" progId="Prism10.Document">
                  <p:embed/>
                </p:oleObj>
              </mc:Choice>
              <mc:Fallback>
                <p:oleObj name="Prism 10" r:id="rId18" imgW="2286862" imgH="259346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A42972B-4276-F7ED-CAA0-A5BFA866F1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8150580" y="3683741"/>
                        <a:ext cx="1430338" cy="1620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0D45B4D2-32B9-9642-1C89-9538F899D975}"/>
              </a:ext>
            </a:extLst>
          </p:cNvPr>
          <p:cNvSpPr txBox="1"/>
          <p:nvPr/>
        </p:nvSpPr>
        <p:spPr>
          <a:xfrm>
            <a:off x="2226972" y="3191298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779ED7-8683-A00A-B575-CF8A8E7D805F}"/>
              </a:ext>
            </a:extLst>
          </p:cNvPr>
          <p:cNvSpPr txBox="1"/>
          <p:nvPr/>
        </p:nvSpPr>
        <p:spPr>
          <a:xfrm>
            <a:off x="7783189" y="3160520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65FCAB-B3F8-C407-24B3-D208A4E9C656}"/>
              </a:ext>
            </a:extLst>
          </p:cNvPr>
          <p:cNvSpPr txBox="1"/>
          <p:nvPr/>
        </p:nvSpPr>
        <p:spPr>
          <a:xfrm>
            <a:off x="1165441" y="5773693"/>
            <a:ext cx="1006621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. HIF1α reduced steroidogenesis marginally affects the number of hematopoietic progenitor cells and mature cell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A-D) FACS analysis of mature hematopoietic populations and progenitors in BM or spleen. Data points represent individual mice from at least two different experiments - normalized values against WT control. Data are presented as box &amp; whisker plots showing all data points with whiskers from min to max.</a:t>
            </a:r>
            <a:endParaRPr lang="en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80116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0" grpId="0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6f52decf0b7b326262ee29f"/>
  <p:tag name="TRANSPARENTBACKGROUND" val="true"/>
  <p:tag name="DATEINSERTED" val="1727345293130"/>
  <p:tag name="VERSION" val="1727345278263"/>
  <p:tag name="SETTINGSKEY" val="66f52decf0b7b326262ee29f_1727344842863"/>
  <p:tag name="TITLE" val="Watts Jaykar P2H1-HSC paper"/>
  <p:tag name="CREATORNAME" val="Ben Wielockx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2" Type="http://schemas.microsoft.com/office/2011/relationships/webextension" Target="webextension2.xml"/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  <wetp:taskpane dockstate="right" visibility="0" width="350" row="1">
    <wetp:webextensionref xmlns:r="http://schemas.openxmlformats.org/officeDocument/2006/relationships" r:id="rId2"/>
  </wetp:taskpane>
</wetp:taskpanes>
</file>

<file path=ppt/webextensions/webextension1.xml><?xml version="1.0" encoding="utf-8"?>
<we:webextension xmlns:we="http://schemas.microsoft.com/office/webextensions/webextension/2010/11" id="{C83DDA31-76DB-4A45-A5AE-3BF265158FFA}">
  <we:reference id="wa200006038" version="1.0.0.3" store="en-US" storeType="OMEX"/>
  <we:alternateReferences>
    <we:reference id="wa200006038" version="1.0.0.3" store="" storeType="OMEX"/>
  </we:alternateReferences>
  <we:properties>
    <we:property name="65f2b00198557d616c8f75f2_1710488433418" value="{&quot;id&quot;:&quot;61aaac59-55e6-4d6a-bfdb-1abf2c9a6671&quot;,&quot;objects&quot;:{&quot;61aaac59-55e6-4d6a-bfdb-1abf2c9a6671&quot;:{&quot;id&quot;:&quot;61aaac59-55e6-4d6a-bfdb-1abf2c9a6671&quot;,&quot;type&quot;:&quot;FIGURE_OBJECT&quot;,&quot;document&quot;:{&quot;type&quot;:&quot;DOCUMENT_GROUP&quot;,&quot;canvasType&quot;:&quot;FIGURE&quot;,&quot;units&quot;:&quot;in&quot;}},&quot;c535fc97-b801-4581-a1a7-ed84806ca590&quot;:{&quot;id&quot;:&quot;c535fc97-b801-4581-a1a7-ed84806ca590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61aaac59-55e6-4d6a-bfdb-1abf2c9a6671&quot;,&quot;type&quot;:&quot;FRAME&quot;,&quot;order&quot;:&quot;5&quot;}},&quot;df2ac314-d8c7-45c8-8b7c-ac9510057d19&quot;:{&quot;id&quot;:&quot;df2ac314-d8c7-45c8-8b7c-ac9510057d19&quot;,&quot;type&quot;:&quot;FIGURE_OBJECT&quot;,&quot;document&quot;:{&quot;type&quot;:&quot;FIGURE&quot;,&quot;canvasType&quot;:&quot;FIGURE&quot;,&quot;units&quot;:&quot;in&quot;},&quot;parent&quot;:{&quot;parentId&quot;:&quot;61aaac59-55e6-4d6a-bfdb-1abf2c9a6671&quot;,&quot;type&quot;:&quot;DOCUMENT&quot;,&quot;order&quot;:&quot;5&quot;}},&quot;8dcd5594-62c4-42c6-ae1c-a8746d283151&quot;:{&quot;id&quot;:&quot;8dcd5594-62c4-42c6-ae1c-a8746d283151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df2ac314-d8c7-45c8-8b7c-ac9510057d19&quot;,&quot;order&quot;:&quot;5&quot;}},&quot;2049c572-9d28-452b-8a1d-4b2a70176e1e&quot;:{&quot;id&quot;:&quot;2049c572-9d28-452b-8a1d-4b2a70176e1e&quot;,&quot;type&quot;:&quot;FIGURE_OBJECT&quot;,&quot;guide&quot;:{&quot;type&quot;:&quot;GRID&quot;,&quot;distance&quot;:0.5,&quot;units&quot;:&quot;in&quot;},&quot;parent&quot;:{&quot;parentId&quot;:&quot;61aaac59-55e6-4d6a-bfdb-1abf2c9a6671&quot;,&quot;type&quot;:&quot;GUIDE&quot;,&quot;order&quot;:&quot;5&quot;}},&quot;20c28ce5-6b88-48a3-9cbf-b5a5f2f4cb60&quot;:{&quot;id&quot;:&quot;20c28ce5-6b88-48a3-9cbf-b5a5f2f4cb60&quot;,&quot;name&quot;:&quot;Mouse (symbol)&quot;,&quot;displayName&quot;:&quot;&quot;,&quot;type&quot;:&quot;FIGURE_OBJECT&quot;,&quot;relativeTransform&quot;:{&quot;translate&quot;:{&quot;x&quot;:-88.77100000000003,&quot;y&quot;:-5.521000000000015},&quot;rotate&quot;:0,&quot;skewX&quot;:0,&quot;scale&quot;:{&quot;x&quot;:1,&quot;y&quot;:1}},&quot;image&quot;:{&quot;url&quot;:&quot;https://icons.biorender.com/biorender/601c2818b376e300280e707d/mouse-icon.png&quot;,&quot;fallbackUrl&quot;:&quot;https://res.cloudinary.com/dlcjuc3ej/image/upload/v1612458006/kn3jq2u5chw7uq36babw.svg#/keystone/api/icons/601c2818b376e300280e707d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df2ac314-d8c7-45c8-8b7c-ac9510057d19&quot;,&quot;order&quot;:&quot;12&quot;}},&quot;6099d7f6-bf3d-48e1-87ec-8f9ffc1e9f4a&quot;:{&quot;id&quot;:&quot;6099d7f6-bf3d-48e1-87ec-8f9ffc1e9f4a&quot;,&quot;name&quot;:&quot;Mouse (symbol)&quot;,&quot;displayName&quot;:&quot;&quot;,&quot;type&quot;:&quot;FIGURE_OBJECT&quot;,&quot;relativeTransform&quot;:{&quot;translate&quot;:{&quot;x&quot;:40.623000000000005,&quot;y&quot;:-5.521000000000015},&quot;rotate&quot;:0,&quot;skewX&quot;:0,&quot;scale&quot;:{&quot;x&quot;:1,&quot;y&quot;:1}},&quot;image&quot;:{&quot;url&quot;:&quot;https://icons.biorender.com/biorender/5fb58802d6bd96002858258b/mouse-icon.png&quot;,&quot;fallbackUrl&quot;:&quot;https://res.cloudinary.com/dlcjuc3ej/image/upload/v1605732349/rimrj4n97wjez1yibmcx.svg#/keystone/api/icons/5fb58802d6bd96002858258b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df2ac314-d8c7-45c8-8b7c-ac9510057d19&quot;,&quot;order&quot;:&quot;15&quot;}},&quot;556aec68-0402-43b1-83a3-6329d88df2b6&quot;:{&quot;id&quot;:&quot;556aec68-0402-43b1-83a3-6329d88df2b6&quot;,&quot;name&quot;:&quot;Femur (anterior)&quot;,&quot;displayName&quot;:&quot;&quot;,&quot;type&quot;:&quot;FIGURE_OBJECT&quot;,&quot;relativeTransform&quot;:{&quot;translate&quot;:{&quot;x&quot;:-35.980502824858846,&quot;y&quot;:-177.78515254237297},&quot;rotate&quot;:-1.570796326794897,&quot;skewX&quot;:0,&quot;scale&quot;:{&quot;x&quot;:0.480225988700565,&quot;y&quot;:0.480225988700565}},&quot;image&quot;:{&quot;url&quot;:&quot;https://icons.biorender.com/biorender/5ac24b903bb10c00148f4a35/femur-anterior.png&quot;,&quot;fallbackUrl&quot;:&quot;https://res.cloudinary.com/dlcjuc3ej/image/upload/v1522682765/kyt1tgo60hyqgseixm0g.svg#/keystone/api/icons/5ac24b903bb10c00148f4a35/femur-anterior.svg#/keystone/api/icons/5ac24b903bb10c00148f4a35/femur-anterior.svg#/keystone/api/icons/5ac24b903bb10c00148f4a35/femur-anterior.svg#/keystone/api/icons/5ac24b903bb10c00148f4a35/femur-anterior.svg#/keystone/api/icons/5ac24b903bb10c00148f4a35/femur-anterior.svg#/keystone/api/icons/5ac24b903bb10c00148f4a35/femur-anterior.svg&quot;,&quot;isPremium&quot;:false,&quot;size&quot;:{&quot;x&quot;:50,&quot;y&quot;:153.91304347826087}},&quot;source&quot;:{&quot;id&quot;:&quot;5a3a7d12f7f6f20014e0db98&quot;,&quot;type&quot;:&quot;ASSETS&quot;},&quot;isPremium&quot;:false,&quot;parent&quot;:{&quot;type&quot;:&quot;CHILD&quot;,&quot;parentId&quot;:&quot;df2ac314-d8c7-45c8-8b7c-ac9510057d19&quot;,&quot;order&quot;:&quot;22&quot;}},&quot;14ec833c-6250-4c7c-8465-597c5f539007&quot;:{&quot;id&quot;:&quot;14ec833c-6250-4c7c-8465-597c5f539007&quot;,&quot;type&quot;:&quot;FIGURE_OBJECT&quot;,&quot;relativeTransform&quot;:{&quot;translate&quot;:{&quot;x&quot;:-4.270111328125026,&quot;y&quot;:58.18166666666667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23]},{&quot;style&quot;:{&quot;fontFamily&quot;:&quot;Roboto&quot;,&quot;fontSize&quot;:18.666666666666664,&quot;color&quot;:&quot;black&quot;,&quot;fontWeight&quot;:&quot;normal&quot;,&quot;fontStyle&quot;:&quot;normal&quot;,&quot;decoration&quot;:&quot;none&quot;,&quot;script&quot;:&quot;super&quot;},&quot;range&quot;:[24,32]}],&quot;text&quot;:&quot;WT                  P2H1Ad.cortex&quot;}],&quot;_lastCaretLocation&quot;:{&quot;lineIndex&quot;:0,&quot;runIndex&quot;:0,&quot;charIndex&quot;:20}},&quot;format&quot;:&quot;BETTER_TEXT&quot;,&quot;size&quot;:{&quot;x&quot;:216.82177734375,&quot;y&quot;:43.093333333333334},&quot;targetSize&quot;:{&quot;x&quot;:216.82177734375,&quot;y&quot;:43.093333333333334}},&quot;parent&quot;:{&quot;type&quot;:&quot;CHILD&quot;,&quot;parentId&quot;:&quot;df2ac314-d8c7-45c8-8b7c-ac9510057d19&quot;,&quot;order&quot;:&quot;25&quot;}},&quot;f07949aa-1d7f-43f0-8e28-6a468b2ff0f6&quot;:{&quot;id&quot;:&quot;f07949aa-1d7f-43f0-8e28-6a468b2ff0f6&quot;,&quot;name&quot;:&quot;Mouse (symbol)&quot;,&quot;displayName&quot;:&quot;&quot;,&quot;type&quot;:&quot;FIGURE_OBJECT&quot;,&quot;relativeTransform&quot;:{&quot;translate&quot;:{&quot;x&quot;:16.850846011114555,&quot;y&quot;:-223.12544728717785},&quot;rotate&quot;:0,&quot;skewX&quot;:0,&quot;scale&quot;:{&quot;x&quot;:0.6796230797777087,&quot;y&quot;:0.6796230797777087}},&quot;image&quot;:{&quot;url&quot;:&quot;https://icons.biorender.com/biorender/601c2818b376e300280e707d/mouse-icon.png&quot;,&quot;fallbackUrl&quot;:&quot;https://res.cloudinary.com/dlcjuc3ej/image/upload/v1612458006/kn3jq2u5chw7uq36babw.svg#/keystone/api/icons/601c2818b376e300280e707d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a301a742-156d-43e0-9c49-cdfeff87e228&quot;,&quot;order&quot;:&quot;2&quot;}},&quot;0aaf11c5-b21d-49b3-a237-12bdc6818f54&quot;:{&quot;id&quot;:&quot;0aaf11c5-b21d-49b3-a237-12bdc6818f54&quot;,&quot;name&quot;:&quot;Mouse (symbol)&quot;,&quot;displayName&quot;:&quot;&quot;,&quot;type&quot;:&quot;FIGURE_OBJECT&quot;,&quot;relativeTransform&quot;:{&quot;translate&quot;:{&quot;x&quot;:-104.04415398888545,&quot;y&quot;:-114.97955271282206},&quot;rotate&quot;:0,&quot;skewX&quot;:0,&quot;scale&quot;:{&quot;x&quot;:0.6796230797777087,&quot;y&quot;:0.6796230797777087}},&quot;image&quot;:{&quot;url&quot;:&quot;https://icons.biorender.com/biorender/5fb58802d6bd960028582592/mouse-icon.png&quot;,&quot;fallbackUrl&quot;:&quot;https://res.cloudinary.com/dlcjuc3ej/image/upload/v1605732349/ymkk3jf4ramyvf4osgjd.svg#/keystone/api/icons/5fb58802d6bd960028582592/mouse-icon.svg#/keystone/api/icons/5fb58802d6bd960028582592/mouse-icon.svg#/keystone/api/icons/5fb58802d6bd960028582592/mouse-icon.svg#/keystone/api/icons/5fb58802d6bd960028582592/mouse-icon.svg#/keystone/api/icons/5fb58802d6bd960028582592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3f322c23-284a-41cb-90ff-fa610cd76d9f&quot;,&quot;order&quot;:&quot;2&quot;}},&quot;07341810-3389-4d8a-a9f1-f4a20e68da61&quot;:{&quot;id&quot;:&quot;07341810-3389-4d8a-a9f1-f4a20e68da61&quot;,&quot;type&quot;:&quot;FIGURE_OBJECT&quot;,&quot;relativeTransform&quot;:{&quot;translate&quot;:{&quot;x&quot;:61.616999999999976,&quot;y&quot;:-187.541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6,&quot;color&quot;:&quot;black&quot;,&quot;fontWeight&quot;:&quot;normal&quot;,&quot;fontStyle&quot;:&quot;normal&quot;,&quot;decoration&quot;:&quot;none&quot;},&quot;range&quot;:[0,1]}],&quot;text&quot;:&quot;WT&quot;}],&quot;_lastCaretLocation&quot;:{&quot;lineIndex&quot;:0,&quot;runIndex&quot;:-1,&quot;charIndex&quot;:-1,&quot;endOfLine&quot;:true}},&quot;format&quot;:&quot;BETTER_TEXT&quot;,&quot;size&quot;:{&quot;x&quot;:120,&quot;y&quot;:19},&quot;targetSize&quot;:{&quot;x&quot;:120,&quot;y&quot;:18.439999999999998}},&quot;parent&quot;:{&quot;type&quot;:&quot;CHILD&quot;,&quot;parentId&quot;:&quot;a301a742-156d-43e0-9c49-cdfeff87e228&quot;,&quot;order&quot;:&quot;5&quot;}},&quot;925630b0-ffbf-4ef3-8226-4252bcfaff85&quot;:{&quot;id&quot;:&quot;925630b0-ffbf-4ef3-8226-4252bcfaff85&quot;,&quot;type&quot;:&quot;FIGURE_OBJECT&quot;,&quot;relativeTransform&quot;:{&quot;translate&quot;:{&quot;x&quot;:-59.23000000000002,&quot;y&quot;:-78.6049999999999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7.333333333333332,&quot;color&quot;:&quot;black&quot;,&quot;fontWeight&quot;:&quot;normal&quot;,&quot;fontStyle&quot;:&quot;normal&quot;,&quot;decoration&quot;:&quot;none&quot;},&quot;range&quot;:[0,1]},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super&quot;},&quot;range&quot;:[2,4]}],&quot;text&quot;:&quot;GRHSC&quot;}],&quot;_lastCaretLocation&quot;:{&quot;lineIndex&quot;:0,&quot;runIndex&quot;:-1,&quot;charIndex&quot;:-1,&quot;endOfLine&quot;:true}},&quot;format&quot;:&quot;BETTER_TEXT&quot;,&quot;size&quot;:{&quot;x&quot;:120,&quot;y&quot;:20},&quot;targetSize&quot;:{&quot;x&quot;:120,&quot;y&quot;:18.439999999999998}},&quot;parent&quot;:{&quot;type&quot;:&quot;CHILD&quot;,&quot;parentId&quot;:&quot;3f322c23-284a-41cb-90ff-fa610cd76d9f&quot;,&quot;order&quot;:&quot;5&quot;}},&quot;44b8de7b-8514-4c61-8dc9-d85f9b91a57e&quot;:{&quot;relativeTransform&quot;:{&quot;translate&quot;:{&quot;x&quot;:-102.24334000000002,&quot;y&quot;:165.77356000000003},&quot;rotate&quot;:0,&quot;skewX&quot;:0,&quot;scale&quot;:{&quot;x&quot;:1,&quot;y&quot;:1}},&quot;type&quot;:&quot;FIGURE_OBJECT&quot;,&quot;id&quot;:&quot;44b8de7b-8514-4c61-8dc9-d85f9b91a57e&quot;,&quot;parent&quot;:{&quot;type&quot;:&quot;CHILD&quot;,&quot;parentId&quot;:&quot;df2ac314-d8c7-45c8-8b7c-ac9510057d19&quot;,&quot;order&quot;:&quot;72&quot;},&quot;name&quot;:&quot;Clock&quot;,&quot;displayName&quot;:&quot;Clock&quot;,&quot;source&quot;:{&quot;id&quot;:&quot;61eb03a724d1c700a3a723ca&quot;,&quot;type&quot;:&quot;ASSETS&quot;},&quot;isPremium&quot;:true},&quot;a7785016-0c14-4a39-bded-78aab6b646aa&quot;:{&quot;type&quot;:&quot;FIGURE_OBJECT&quot;,&quot;id&quot;:&quot;a7785016-0c14-4a39-bded-78aab6b646aa&quot;,&quot;parent&quot;:{&quot;type&quot;:&quot;CHILD&quot;,&quot;parentId&quot;:&quot;44b8de7b-8514-4c61-8dc9-d85f9b91a57e&quot;,&quot;order&quot;:&quot;5&quot;},&quot;relativeTransform&quot;:{&quot;translate&quot;:{&quot;x&quot;:0,&quot;y&quot;:0},&quot;rotate&quot;:0}},&quot;11fb0748-a907-493e-98b7-41fd91ae82c2&quot;:{&quot;type&quot;:&quot;FIGURE_OBJECT&quot;,&quot;id&quot;:&quot;11fb0748-a907-493e-98b7-41fd91ae82c2&quot;,&quot;relativeTransform&quot;:{&quot;translate&quot;:{&quot;x&quot;:73.84934860665481,&quot;y&quot;:-60.3735730501387},&quot;rotate&quot;:0},&quot;opacity&quot;:1,&quot;path&quot;:{&quot;type&quot;:&quot;POLY_LINE&quot;,&quot;points&quot;:[{&quot;x&quot;:0,&quot;y&quot;:-4.936288877652206},{&quot;x&quot;:0,&quot;y&quot;:4.936288877652206}],&quot;closed&quot;:false},&quot;pathStyles&quot;:[{&quot;type&quot;:&quot;FILL&quot;,&quot;fillStyle&quot;:&quot;rgba(0,0,0,0)&quot;},{&quot;type&quot;:&quot;STROKE&quot;,&quot;strokeStyle&quot;:&quot;rgba(61, 61, 61, 1)&quot;,&quot;lineWidth&quot;:0.9750000000000001,&quot;lineJoin&quot;:&quot;round&quot;,&quot;dashArray&quot;:[0]}],&quot;isLocked&quot;:false,&quot;parent&quot;:{&quot;type&quot;:&quot;CHILD&quot;,&quot;parentId&quot;:&quot;a7785016-0c14-4a39-bded-78aab6b646aa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1fa50cb7-3b6e-4f02-920b-e03b788816c0&quot;:{&quot;type&quot;:&quot;FIGURE_OBJECT&quot;,&quot;id&quot;:&quot;1fa50cb7-3b6e-4f02-920b-e03b788816c0&quot;,&quot;parent&quot;:{&quot;type&quot;:&quot;CROP&quot;,&quot;parentId&quot;:&quot;a7785016-0c14-4a39-bded-78aab6b646aa&quot;,&quot;order&quot;:&quot;5&quot;},&quot;relativeTransform&quot;:{&quot;translate&quot;:{&quot;x&quot;:73.84934860665481,&quot;y&quot;:-54.3675730501387},&quot;rotate&quot;:0,&quot;skewX&quot;:0,&quot;scale&quot;:{&quot;x&quot;:0.7215,&quot;y&quot;:11.468788877652205}},&quot;path&quot;:{&quot;type&quot;:&quot;RECT&quot;,&quot;size&quot;:{&quot;x&quot;:2,&quot;y&quot;:2}},&quot;pathStyles&quot;:[{&quot;type&quot;:&quot;FILL&quot;,&quot;fillStyle&quot;:&quot;#fff&quot;}],&quot;isFrozen&quot;:true},&quot;332c1007-9070-4ba4-a989-0f20bb6d681f&quot;:{&quot;type&quot;:&quot;FIGURE_OBJECT&quot;,&quot;id&quot;:&quot;332c1007-9070-4ba4-a989-0f20bb6d681f&quot;,&quot;parent&quot;:{&quot;type&quot;:&quot;CHILD&quot;,&quot;parentId&quot;:&quot;44b8de7b-8514-4c61-8dc9-d85f9b91a57e&quot;,&quot;order&quot;:&quot;7&quot;},&quot;relativeTransform&quot;:{&quot;translate&quot;:{&quot;x&quot;:0,&quot;y&quot;:0},&quot;rotate&quot;:0}},&quot;d2b95043-8b1e-4e3f-91ee-243fa31d8c8a&quot;:{&quot;type&quot;:&quot;FIGURE_OBJECT&quot;,&quot;id&quot;:&quot;d2b95043-8b1e-4e3f-91ee-243fa31d8c8a&quot;,&quot;relativeTransform&quot;:{&quot;translate&quot;:{&quot;x&quot;:79.99460177141975,&quot;y&quot;:-54.384517117000165},&quot;rotate&quot;:1.5707963267948966},&quot;opacity&quot;:1,&quot;path&quot;:{&quot;type&quot;:&quot;POLY_LINE&quot;,&quot;points&quot;:[{&quot;x&quot;:-0.08092277111932206,&quot;y&quot;:-2.589528515191806},{&quot;x&quot;:0,&quot;y&quot;:4.936288877652206}],&quot;closed&quot;:false},&quot;pathStyles&quot;:[{&quot;type&quot;:&quot;FILL&quot;,&quot;fillStyle&quot;:&quot;rgba(0,0,0,0)&quot;},{&quot;type&quot;:&quot;STROKE&quot;,&quot;strokeStyle&quot;:&quot;rgba(61, 61, 61, 1)&quot;,&quot;lineWidth&quot;:0.9750000000000001,&quot;lineJoin&quot;:&quot;round&quot;,&quot;dashArray&quot;:[0]}],&quot;isLocked&quot;:false,&quot;parent&quot;:{&quot;type&quot;:&quot;CHILD&quot;,&quot;parentId&quot;:&quot;332c1007-9070-4ba4-a989-0f20bb6d681f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1c2239d6-c603-43c9-82c4-5cbea5dced03&quot;:{&quot;type&quot;:&quot;FIGURE_OBJECT&quot;,&quot;id&quot;:&quot;1c2239d6-c603-43c9-82c4-5cbea5dced03&quot;,&quot;parent&quot;:{&quot;type&quot;:&quot;CROP&quot;,&quot;parentId&quot;:&quot;332c1007-9070-4ba4-a989-0f20bb6d681f&quot;,&quot;order&quot;:&quot;5&quot;},&quot;relativeTransform&quot;:{&quot;translate&quot;:{&quot;x&quot;:74.02422159018955,&quot;y&quot;:-54.424978502559824},&quot;rotate&quot;:0,&quot;skewX&quot;:0,&quot;scale&quot;:{&quot;x&quot;:9.163678003642174,&quot;y&quot;:0.6442306927798291}},&quot;path&quot;:{&quot;type&quot;:&quot;RECT&quot;,&quot;size&quot;:{&quot;x&quot;:2,&quot;y&quot;:2}},&quot;pathStyles&quot;:[{&quot;type&quot;:&quot;FILL&quot;,&quot;fillStyle&quot;:&quot;#fff&quot;}],&quot;isFrozen&quot;:true},&quot;40a3f736-9361-486a-b475-8c0ed8bda772&quot;:{&quot;id&quot;:&quot;40a3f736-9361-486a-b475-8c0ed8bda772&quot;,&quot;name&quot;:&quot;Clock (no hands)&quot;,&quot;type&quot;:&quot;FIGURE_OBJECT&quot;,&quot;relativeTransform&quot;:{&quot;translate&quot;:{&quot;x&quot;:74.02434000000002,&quot;y&quot;:-54.36756},&quot;rotate&quot;:0,&quot;skewX&quot;:0,&quot;scale&quot;:{&quot;x&quot;:0.39,&quot;y&quot;:0.39}},&quot;image&quot;:{&quot;url&quot;:&quot;https://icons.biorender.com/biorender/61eafb6fa57cec0029a1480b/20220121183627/image/clock-no-hands-1.png&quot;,&quot;fallbackUrl&quot;:&quot;https://res.cloudinary.com/dlcjuc3ej/image/upload/v1642790187/jnm2u1bo1dpkmdmlx92k.svg#/keystone/api/icons/61eafb6fa57cec0029a1480b/20220121183627/image/clock-no-hands-1.svg&quot;,&quot;isPremium&quot;:false,&quot;isPacked&quot;:true,&quot;size&quot;:{&quot;x&quot;:100,&quot;y&quot;:100}},&quot;source&quot;:{&quot;id&quot;:&quot;61eafb6fa57cec0029a1480b&quot;,&quot;type&quot;:&quot;ASSETS&quot;},&quot;isPremium&quot;:false,&quot;parent&quot;:{&quot;type&quot;:&quot;CHILD&quot;,&quot;parentId&quot;:&quot;44b8de7b-8514-4c61-8dc9-d85f9b91a57e&quot;,&quot;order&quot;:&quot;2&quot;}},&quot;5f631815-d5d2-4538-9c8b-5f8e046aaf57&quot;:{&quot;id&quot;:&quot;5f631815-d5d2-4538-9c8b-5f8e046aaf57&quot;,&quot;type&quot;:&quot;FIGURE_OBJECT&quot;,&quot;relativeTransform&quot;:{&quot;translate&quot;:{&quot;x&quot;:-34.98050000000002,&quot;y&quot;:-184.162055876685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830229073003633,&quot;color&quot;:&quot;black&quot;,&quot;fontWeight&quot;:&quot;normal&quot;,&quot;fontStyle&quot;:&quot;normal&quot;,&quot;decoration&quot;:&quot;none&quot;},&quot;range&quot;:[0,1]}],&quot;text&quot;:&quot;BM&quot;}],&quot;_lastCaretLocation&quot;:{&quot;lineIndex&quot;:0,&quot;runIndex&quot;:-1,&quot;charIndex&quot;:-1,&quot;endOfLine&quot;:true}},&quot;format&quot;:&quot;BETTER_TEXT&quot;,&quot;size&quot;:{&quot;x&quot;:30.92499999999999,&quot;y&quot;:19.25811175337186},&quot;targetSize&quot;:{&quot;x&quot;:30.92499999999999,&quot;y&quot;:19.25811175337186}},&quot;parent&quot;:{&quot;type&quot;:&quot;CHILD&quot;,&quot;parentId&quot;:&quot;df2ac314-d8c7-45c8-8b7c-ac9510057d19&quot;,&quot;order&quot;:&quot;95&quot;}},&quot;3f322c23-284a-41cb-90ff-fa610cd76d9f&quot;:{&quot;type&quot;:&quot;FIGURE_OBJECT&quot;,&quot;id&quot;:&quot;3f322c23-284a-41cb-90ff-fa610cd76d9f&quot;,&quot;parent&quot;:{&quot;type&quot;:&quot;CHILD&quot;,&quot;parentId&quot;:&quot;df2ac314-d8c7-45c8-8b7c-ac9510057d19&quot;,&quot;order&quot;:&quot;65&quot;},&quot;relativeTransform&quot;:{&quot;translate&quot;:{&quot;x&quot;:138.001,&quot;y&quot;:-93.29699999999997},&quot;rotate&quot;:0,&quot;skewX&quot;:0,&quot;scale&quot;:{&quot;x&quot;:1,&quot;y&quot;:1}}},&quot;a301a742-156d-43e0-9c49-cdfeff87e228&quot;:{&quot;type&quot;:&quot;FIGURE_OBJECT&quot;,&quot;id&quot;:&quot;a301a742-156d-43e0-9c49-cdfeff87e228&quot;,&quot;parent&quot;:{&quot;type&quot;:&quot;CHILD&quot;,&quot;parentId&quot;:&quot;df2ac314-d8c7-45c8-8b7c-ac9510057d19&quot;,&quot;order&quot;:&quot;62&quot;},&quot;relativeTransform&quot;:{&quot;translate&quot;:{&quot;x&quot;:-121.64100000000003,&quot;y&quot;:15.13900000000001},&quot;rotate&quot;:0,&quot;skewX&quot;:0,&quot;scale&quot;:{&quot;x&quot;:1,&quot;y&quot;:1}}},&quot;8c44f5c1-c97b-49d2-a940-f623081bfeff&quot;:{&quot;type&quot;:&quot;FIGURE_OBJECT&quot;,&quot;id&quot;:&quot;8c44f5c1-c97b-49d2-a940-f623081bfeff&quot;,&quot;relativeTransform&quot;:{&quot;translate&quot;:{&quot;x&quot;:79.319,&quot;y&quot;:-55},&quot;rotate&quot;:0,&quot;skewX&quot;:0,&quot;scale&quot;:{&quot;x&quot;:1,&quot;y&quot;:1}},&quot;opacity&quot;:1,&quot;path&quot;:{&quot;type&quot;:&quot;POLY_LINE&quot;,&quot;points&quot;:[{&quot;x&quot;:-186,&quot;y&quot;:-107.90199999999999},{&quot;x&quot;:-186,&quot;y&quot;:-4.5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df2ac314-d8c7-45c8-8b7c-ac9510057d19&quot;,&quot;order&quot;:&quot;97&quot;},&quot;connectorInfo&quot;:{&quot;connectedObjects&quot;:[],&quot;type&quot;:&quot;LINE&quot;,&quot;offset&quot;:{&quot;x&quot;:0,&quot;y&quot;:0},&quot;bending&quot;:0.1,&quot;firstElementIsHead&quot;:true,&quot;customized&quot;:false}},&quot;95d6c8a2-1c20-4410-8643-058fe1e77d9f&quot;:{&quot;type&quot;:&quot;FIGURE_OBJECT&quot;,&quot;id&quot;:&quot;95d6c8a2-1c20-4410-8643-058fe1e77d9f&quot;,&quot;relativeTransform&quot;:{&quot;translate&quot;:{&quot;x&quot;:212.344,&quot;y&quot;:-55},&quot;rotate&quot;:0,&quot;skewX&quot;:0,&quot;scale&quot;:{&quot;x&quot;:1,&quot;y&quot;:1}},&quot;opacity&quot;:1,&quot;path&quot;:{&quot;type&quot;:&quot;POLY_LINE&quot;,&quot;points&quot;:[{&quot;x&quot;:-186,&quot;y&quot;:-108.46199999999999},{&quot;x&quot;:-186,&quot;y&quot;:-4.5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df2ac314-d8c7-45c8-8b7c-ac9510057d19&quot;,&quot;order&quot;:&quot;98&quot;},&quot;connectorInfo&quot;:{&quot;connectedObjects&quot;:[],&quot;type&quot;:&quot;LINE&quot;,&quot;offset&quot;:{&quot;x&quot;:0,&quot;y&quot;:0},&quot;bending&quot;:0.1,&quot;firstElementIsHead&quot;:false,&quot;customized&quot;:false}},&quot;c77e5bf8-b438-459b-9835-4d8f88065d6f&quot;:{&quot;id&quot;:&quot;c77e5bf8-b438-459b-9835-4d8f88065d6f&quot;,&quot;name&quot;:&quot;Syringe (symbol)&quot;,&quot;displayName&quot;:&quot;&quot;,&quot;type&quot;:&quot;FIGURE_OBJECT&quot;,&quot;relativeTransform&quot;:{&quot;translate&quot;:{&quot;x&quot;:-48.937000000000054,&quot;y&quot;:-83.5},&quot;rotate&quot;:0,&quot;skewX&quot;:0,&quot;scale&quot;:{&quot;x&quot;:0.48,&quot;y&quot;:0.48}},&quot;image&quot;:{&quot;url&quot;:&quot;https://icons.biorender.com/biorender/6329d8138dc9890028b7ac18/20220920151714/image/syringe-symbol.png&quot;,&quot;fallbackUrl&quot;:&quot;https://res.cloudinary.com/dlcjuc3ej/image/upload/v1663687034/m5hsqtsruhjwxxci76ns.svg#/keystone/api/icons/6329d8138dc9890028b7ac18/20220920151714/image/syringe-symbol.svg&quot;,&quot;isPremium&quot;:false,&quot;size&quot;:{&quot;x&quot;:100,&quot;y&quot;:100}},&quot;source&quot;:{&quot;id&quot;:&quot;6329d8138dc9890028b7ac18&quot;,&quot;type&quot;:&quot;ASSETS&quot;},&quot;isPremium&quot;:false,&quot;parent&quot;:{&quot;type&quot;:&quot;CHILD&quot;,&quot;parentId&quot;:&quot;df2ac314-d8c7-45c8-8b7c-ac9510057d19&quot;,&quot;order&quot;:&quot;99&quot;}},&quot;4419b811-a740-46da-ae36-3e0e89f24e20&quot;:{&quot;type&quot;:&quot;FIGURE_OBJECT&quot;,&quot;id&quot;:&quot;4419b811-a740-46da-ae36-3e0e89f24e20&quot;,&quot;relativeTransform&quot;:{&quot;translate&quot;:{&quot;x&quot;:-175.85242857142862,&quot;y&quot;:-56},&quot;rotate&quot;:-2.4492935982947064e-16,&quot;skewX&quot;:0,&quot;scale&quot;:{&quot;x&quot;:1,&quot;y&quot;:1}},&quot;opacity&quot;:1,&quot;path&quot;:{&quot;type&quot;:&quot;POLY_LINE&quot;,&quot;points&quot;:[{&quot;x&quot;:192.1714285714286,&quot;y&quot;:-108.46199999999999},{&quot;x&quot;:123.88412571428574,&quot;y&quot;:-66.981},{&quot;x&quot;:78.17142857142858,&quot;y&quot;:-4.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&quot;translate&quot;:{&quot;x&quot;:0,&quot;y&quot;:0},&quot;rotate&quot;:3.141592653589793,&quot;skewX&quot;:0,&quot;scale&quot;:{&quot;x&quot;:-1,&quot;y&quot;:1}},&quot;xUnits&quot;:&quot;PATH_LENGTH&quot;,&quot;yUnits&quot;:&quot;STROKE_WIDTH&quot;,&quot;isPremium&quot;:false},&quot;parent&quot;:{&quot;type&quot;:&quot;CHILD&quot;,&quot;parentId&quot;:&quot;df2ac314-d8c7-45c8-8b7c-ac9510057d19&quot;,&quot;order&quot;:&quot;997&quot;},&quot;connectorInfo&quot;:{&quot;connectedObjects&quot;:[],&quot;type&quot;:&quot;QUADRATIC&quot;,&quot;offset&quot;:{&quot;x&quot;:0,&quot;y&quot;:0},&quot;bending&quot;:-0.1,&quot;firstElementIsHead&quot;:false,&quot;customized&quot;:false}},&quot;3eadf0c6-2e43-4c51-9072-21bd38f4b2c3&quot;:{&quot;type&quot;:&quot;FIGURE_OBJECT&quot;,&quot;id&quot;:&quot;3eadf0c6-2e43-4c51-9072-21bd38f4b2c3&quot;,&quot;relativeTransform&quot;:{&quot;translate&quot;:{&quot;x&quot;:94.49042857142855,&quot;y&quot;:-56},&quot;rotate&quot;:0,&quot;skewX&quot;:0,&quot;scale&quot;:{&quot;x&quot;:1,&quot;y&quot;:1}},&quot;opacity&quot;:1,&quot;path&quot;:{&quot;type&quot;:&quot;POLY_LINE&quot;,&quot;points&quot;:[{&quot;x&quot;:-192.1714285714286,&quot;y&quot;:-108.46199999999999},{&quot;x&quot;:-123.88412571428574,&quot;y&quot;:-66.981},{&quot;x&quot;:-78.17142857142858,&quot;y&quot;:-4.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&quot;translate&quot;:{&quot;x&quot;:0,&quot;y&quot;:0},&quot;rotate&quot;:1.2246467991473532e-16,&quot;skewX&quot;:0,&quot;scale&quot;:{&quot;x&quot;:1,&quot;y&quot;:1}},&quot;xUnits&quot;:&quot;PATH_LENGTH&quot;,&quot;yUnits&quot;:&quot;STROKE_WIDTH&quot;,&quot;isPremium&quot;:false},&quot;parent&quot;:{&quot;type&quot;:&quot;CHILD&quot;,&quot;parentId&quot;:&quot;df2ac314-d8c7-45c8-8b7c-ac9510057d19&quot;,&quot;order&quot;:&quot;998&quot;},&quot;connectorInfo&quot;:{&quot;connectedObjects&quot;:[],&quot;type&quot;:&quot;QUADRATIC&quot;,&quot;offset&quot;:{&quot;x&quot;:0,&quot;y&quot;:0},&quot;bending&quot;:-0.1,&quot;firstElementIsHead&quot;:false,&quot;customized&quot;:false}},&quot;d9b9fed0-4add-4d39-952d-72cf376732c9&quot;:{&quot;id&quot;:&quot;d9b9fed0-4add-4d39-952d-72cf376732c9&quot;,&quot;name&quot;:&quot;Mouse (symbol)&quot;,&quot;displayName&quot;:&quot;&quot;,&quot;type&quot;:&quot;FIGURE_OBJECT&quot;,&quot;relativeTransform&quot;:{&quot;translate&quot;:{&quot;x&quot;:-80.20015398888542,&quot;y&quot;:210.28480488889102},&quot;rotate&quot;:0,&quot;skewX&quot;:0,&quot;scale&quot;:{&quot;x&quot;:0.6496230797777087,&quot;y&quot;:0.6496230797777087}},&quot;image&quot;:{&quot;url&quot;:&quot;https://icons.biorender.com/biorender/5fb58802d6bd960028582592/mouse-icon.png&quot;,&quot;fallbackUrl&quot;:&quot;https://res.cloudinary.com/dlcjuc3ej/image/upload/v1605732349/ymkk3jf4ramyvf4osgjd.svg#/keystone/api/icons/5fb58802d6bd960028582592/mouse-icon.svg#/keystone/api/icons/5fb58802d6bd960028582592/mouse-icon.svg#/keystone/api/icons/5fb58802d6bd960028582592/mouse-icon.svg#/keystone/api/icons/5fb58802d6bd960028582592/mouse-icon.svg#/keystone/api/icons/5fb58802d6bd960028582592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df2ac314-d8c7-45c8-8b7c-ac9510057d19&quot;,&quot;order&quot;:&quot;9992&quot;}},&quot;b40b7798-d2df-41ad-89f9-4ca49b4cbf62&quot;:{&quot;id&quot;:&quot;b40b7798-d2df-41ad-89f9-4ca49b4cbf62&quot;,&quot;name&quot;:&quot;Mouse (symbol)&quot;,&quot;displayName&quot;:&quot;&quot;,&quot;type&quot;:&quot;FIGURE_OBJECT&quot;,&quot;relativeTransform&quot;:{&quot;translate&quot;:{&quot;x&quot;:-80.20015398888545,&quot;y&quot;:160.96580488889106},&quot;rotate&quot;:0,&quot;skewX&quot;:0,&quot;scale&quot;:{&quot;x&quot;:0.6496230797777087,&quot;y&quot;:0.6496230797777087}},&quot;image&quot;:{&quot;url&quot;:&quot;https://icons.biorender.com/biorender/5fb58802d6bd960028582579/mouse-icon.png&quot;,&quot;fallbackUrl&quot;:&quot;https://res.cloudinary.com/dlcjuc3ej/image/upload/v1605732349/ohzrgti7tgfwvho3ogeq.svg#/keystone/api/icons/5fb58802d6bd960028582579/mouse-icon.svg#/keystone/api/icons/5fb58802d6bd960028582579/mouse-icon.svg#/keystone/api/icons/5fb58802d6bd960028582579/mouse-icon.svg#/keystone/api/icons/5fb58802d6bd960028582579/mouse-icon.svg#/keystone/api/icons/5fb58802d6bd960028582579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df2ac314-d8c7-45c8-8b7c-ac9510057d19&quot;,&quot;order&quot;:&quot;9996&quot;},&quot;opacity&quot;:1,&quot;styles&quot;:{&quot;vector-hidden&quot;:[{&quot;styleName&quot;:&quot;MONOCHROME_COLOR&quot;,&quot;index&quot;:0,&quot;color&quot;:&quot;#000000&quot;}]}},&quot;27ef8c67-8745-40b9-b3d1-a5bf38f5de50&quot;:{&quot;id&quot;:&quot;27ef8c67-8745-40b9-b3d1-a5bf38f5de50&quot;,&quot;name&quot;:&quot;Mouse (symbol)&quot;,&quot;displayName&quot;:&quot;&quot;,&quot;type&quot;:&quot;FIGURE_OBJECT&quot;,&quot;relativeTransform&quot;:{&quot;translate&quot;:{&quot;x&quot;:38.359846011114534,&quot;y&quot;:210.28480488889102},&quot;rotate&quot;:0,&quot;skewX&quot;:0,&quot;scale&quot;:{&quot;x&quot;:0.6496230797777087,&quot;y&quot;:0.6496230797777087}},&quot;image&quot;:{&quot;url&quot;:&quot;https://icons.biorender.com/biorender/5fb58802d6bd96002858258e/mouse-icon.png&quot;,&quot;fallbackUrl&quot;:&quot;https://res.cloudinary.com/dlcjuc3ej/image/upload/v1605732349/plk85kpemudxitasxf8w.svg#/keystone/api/icons/5fb58802d6bd96002858258e/mouse-icon.svg#/keystone/api/icons/5fb58802d6bd96002858258e/mouse-icon.svg#/keystone/api/icons/5fb58802d6bd96002858258e/mouse-icon.svg#/keystone/api/icons/5fb58802d6bd96002858258e/mouse-icon.svg#/keystone/api/icons/5fb58802d6bd96002858258e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df2ac314-d8c7-45c8-8b7c-ac9510057d19&quot;,&quot;order&quot;:&quot;9998&quot;}},&quot;29a9dff2-bf90-44f4-b55d-feac0b251804&quot;:{&quot;id&quot;:&quot;29a9dff2-bf90-44f4-b55d-feac0b251804&quot;,&quot;name&quot;:&quot;Mouse (symbol)&quot;,&quot;displayName&quot;:&quot;&quot;,&quot;type&quot;:&quot;FIGURE_OBJECT&quot;,&quot;relativeTransform&quot;:{&quot;translate&quot;:{&quot;x&quot;:38.35984601111457,&quot;y&quot;:160.96580488889109},&quot;rotate&quot;:0,&quot;skewX&quot;:0,&quot;scale&quot;:{&quot;x&quot;:0.6496230797777087,&quot;y&quot;:0.6496230797777087}},&quot;image&quot;:{&quot;url&quot;:&quot;https://icons.biorender.com/biorender/5fb58802d6bd96002858258b/mouse-icon.png&quot;,&quot;fallbackUrl&quot;:&quot;https://res.cloudinary.com/dlcjuc3ej/image/upload/v1605732349/rimrj4n97wjez1yibmcx.svg#/keystone/api/icons/5fb58802d6bd96002858258b/mouse-icon.svg#/keystone/api/icons/5fb58802d6bd96002858258b/mouse-icon.svg#/keystone/api/icons/5fb58802d6bd96002858258b/mouse-icon.svg#/keystone/api/icons/5fb58802d6bd96002858258b/mouse-icon.svg#/keystone/api/icons/5fb58802d6bd96002858258b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df2ac314-d8c7-45c8-8b7c-ac9510057d19&quot;,&quot;order&quot;:&quot;9999&quot;}},&quot;bf1f5eda-4d6b-4c45-aa7b-6e8d151968b3&quot;:{&quot;type&quot;:&quot;FIGURE_OBJECT&quot;,&quot;id&quot;:&quot;bf1f5eda-4d6b-4c45-aa7b-6e8d151968b3&quot;,&quot;relativeTransform&quot;:{&quot;translate&quot;:{&quot;x&quot;:-31.332499999999982,&quot;y&quot;:9.25},&quot;rotate&quot;:0,&quot;skewX&quot;:0,&quot;scale&quot;:{&quot;x&quot;:1,&quot;y&quot;:1}},&quot;opacity&quot;:1,&quot;path&quot;:{&quot;type&quot;:&quot;RECT&quot;,&quot;size&quot;:{&quot;x&quot;:271.66499999999996,&quot;y&quot;:529.5},&quot;cornerRounding&quot;:{&quot;type&quot;:&quot;ARC_LENGTH&quot;,&quot;global&quot;:0}},&quot;pathStyles&quot;:[{&quot;type&quot;:&quot;FILL&quot;,&quot;fillStyle&quot;:&quot;rgba(243, 246, 251, 1)&quot;},{&quot;type&quot;:&quot;STROKE&quot;,&quot;strokeStyle&quot;:&quot;rgba(133, 148, 182, 1)&quot;,&quot;lineWidth&quot;:2,&quot;lineJoin&quot;:&quot;round&quot;}],&quot;isLocked&quot;:false,&quot;parent&quot;:{&quot;type&quot;:&quot;CHILD&quot;,&quot;parentId&quot;:&quot;df2ac314-d8c7-45c8-8b7c-ac9510057d19&quot;,&quot;order&quot;:&quot;1&quot;}},&quot;cfc4e4d3-a4b9-435f-9932-8de038413dd7&quot;:{&quot;type&quot;:&quot;FIGURE_OBJECT&quot;,&quot;id&quot;:&quot;cfc4e4d3-a4b9-435f-9932-8de038413dd7&quot;,&quot;relativeTransform&quot;:{&quot;translate&quot;:{&quot;x&quot;:-118.262,&quot;y&quot;:33.54829716529153},&quot;rotate&quot;:0,&quot;skewX&quot;:0,&quot;scale&quot;:{&quot;x&quot;:1,&quot;y&quot;:1}},&quot;opacity&quot;:1,&quot;path&quot;:{&quot;type&quot;:&quot;POLY_LINE&quot;,&quot;points&quot;:[{&quot;x&quot;:20.848113955133925,&quot;y&quot;:27.226973246760256},{&quot;x&quot;:34.34563224176311,&quot;y&quot;:68.23109618095708},{&quot;x&quot;:36,&quot;y&quot;:106.94272588872178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&quot;translate&quot;:{&quot;x&quot;:0,&quot;y&quot;:0},&quot;rotate&quot;:3.141592653589793,&quot;skewX&quot;:0,&quot;scale&quot;:{&quot;x&quot;:-1,&quot;y&quot;:1}},&quot;xUnits&quot;:&quot;PATH_LENGTH&quot;,&quot;yUnits&quot;:&quot;STROKE_WIDTH&quot;,&quot;isPremium&quot;:false},&quot;parent&quot;:{&quot;type&quot;:&quot;CHILD&quot;,&quot;parentId&quot;:&quot;df2ac314-d8c7-45c8-8b7c-ac9510057d19&quot;,&quot;order&quot;:&quot;99995&quot;},&quot;connectorInfo&quot;:{&quot;connectedObjects&quot;:[],&quot;type&quot;:&quot;QUADRATIC&quot;,&quot;offset&quot;:{&quot;x&quot;:0,&quot;y&quot;:0},&quot;bending&quot;:-0.1,&quot;firstElementIsHead&quot;:false,&quot;customized&quot;:false}},&quot;2748c3da-1f99-40ab-82d7-a0544ebec54a&quot;:{&quot;type&quot;:&quot;FIGURE_OBJECT&quot;,&quot;id&quot;:&quot;2748c3da-1f99-40ab-82d7-a0544ebec54a&quot;,&quot;relativeTransform&quot;:{&quot;translate&quot;:{&quot;x&quot;:63.872717708113555,&quot;y&quot;:33.54829716529153},&quot;rotate&quot;:-2.4492935982947064e-16,&quot;skewX&quot;:0,&quot;scale&quot;:{&quot;x&quot;:1,&quot;y&quot;:1}},&quot;opacity&quot;:1,&quot;path&quot;:{&quot;type&quot;:&quot;POLY_LINE&quot;,&quot;points&quot;:[{&quot;x&quot;:-20.848113955133925,&quot;y&quot;:27.226973246760256},{&quot;x&quot;:-34.34563224176311,&quot;y&quot;:68.23109618095708},{&quot;x&quot;:-36,&quot;y&quot;:106.94272588872178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&quot;translate&quot;:{&quot;x&quot;:0,&quot;y&quot;:0},&quot;rotate&quot;:1.2246467991473532e-16,&quot;skewX&quot;:0,&quot;scale&quot;:{&quot;x&quot;:1,&quot;y&quot;:1}},&quot;xUnits&quot;:&quot;PATH_LENGTH&quot;,&quot;yUnits&quot;:&quot;STROKE_WIDTH&quot;,&quot;isPremium&quot;:false},&quot;parent&quot;:{&quot;type&quot;:&quot;CHILD&quot;,&quot;parentId&quot;:&quot;df2ac314-d8c7-45c8-8b7c-ac9510057d19&quot;,&quot;order&quot;:&quot;99997&quot;},&quot;connectorInfo&quot;:{&quot;connectedObjects&quot;:[],&quot;type&quot;:&quot;QUADRATIC&quot;,&quot;offset&quot;:{&quot;x&quot;:0,&quot;y&quot;:0},&quot;bending&quot;:-0.1,&quot;firstElementIsHead&quot;:false,&quot;customized&quot;:false}}}}"/>
    <we:property name="66277964f5c91b25d855cd9c_1722948016016" value="{&quot;id&quot;:&quot;61aaac59-55e6-4d6a-bfdb-1abf2c9a6671&quot;,&quot;objects&quot;:{&quot;61aaac59-55e6-4d6a-bfdb-1abf2c9a6671&quot;:{&quot;id&quot;:&quot;61aaac59-55e6-4d6a-bfdb-1abf2c9a6671&quot;,&quot;type&quot;:&quot;FIGURE_OBJECT&quot;,&quot;document&quot;:{&quot;type&quot;:&quot;DOCUMENT_GROUP&quot;,&quot;canvasType&quot;:&quot;FIGURE&quot;,&quot;units&quot;:&quot;in&quot;}},&quot;c535fc97-b801-4581-a1a7-ed84806ca590&quot;:{&quot;id&quot;:&quot;c535fc97-b801-4581-a1a7-ed84806ca590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61aaac59-55e6-4d6a-bfdb-1abf2c9a6671&quot;,&quot;type&quot;:&quot;FRAME&quot;,&quot;order&quot;:&quot;5&quot;}},&quot;df2ac314-d8c7-45c8-8b7c-ac9510057d19&quot;:{&quot;id&quot;:&quot;df2ac314-d8c7-45c8-8b7c-ac9510057d19&quot;,&quot;type&quot;:&quot;FIGURE_OBJECT&quot;,&quot;document&quot;:{&quot;type&quot;:&quot;FIGURE&quot;,&quot;canvasType&quot;:&quot;FIGURE&quot;,&quot;units&quot;:&quot;in&quot;},&quot;parent&quot;:{&quot;parentId&quot;:&quot;61aaac59-55e6-4d6a-bfdb-1abf2c9a6671&quot;,&quot;type&quot;:&quot;DOCUMENT&quot;,&quot;order&quot;:&quot;5&quot;}},&quot;8dcd5594-62c4-42c6-ae1c-a8746d283151&quot;:{&quot;id&quot;:&quot;8dcd5594-62c4-42c6-ae1c-a8746d283151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df2ac314-d8c7-45c8-8b7c-ac9510057d19&quot;,&quot;order&quot;:&quot;5&quot;}},&quot;2049c572-9d28-452b-8a1d-4b2a70176e1e&quot;:{&quot;id&quot;:&quot;2049c572-9d28-452b-8a1d-4b2a70176e1e&quot;,&quot;type&quot;:&quot;FIGURE_OBJECT&quot;,&quot;guide&quot;:{&quot;type&quot;:&quot;GRID&quot;,&quot;distance&quot;:0.5,&quot;units&quot;:&quot;in&quot;},&quot;parent&quot;:{&quot;parentId&quot;:&quot;61aaac59-55e6-4d6a-bfdb-1abf2c9a6671&quot;,&quot;type&quot;:&quot;GUIDE&quot;,&quot;order&quot;:&quot;5&quot;}},&quot;20c28ce5-6b88-48a3-9cbf-b5a5f2f4cb60&quot;:{&quot;id&quot;:&quot;20c28ce5-6b88-48a3-9cbf-b5a5f2f4cb60&quot;,&quot;name&quot;:&quot;Mouse (symbol)&quot;,&quot;displayName&quot;:&quot;&quot;,&quot;type&quot;:&quot;FIGURE_OBJECT&quot;,&quot;relativeTransform&quot;:{&quot;translate&quot;:{&quot;x&quot;:-242.44400000000002,&quot;y&quot;:-143.32099999999997},&quot;rotate&quot;:0,&quot;skewX&quot;:0,&quot;scale&quot;:{&quot;x&quot;:1,&quot;y&quot;:1}},&quot;image&quot;:{&quot;url&quot;:&quot;https://icons.biorender.com/biorender/601c2818b376e300280e707d/mouse-icon.png&quot;,&quot;fallbackUrl&quot;:&quot;https://res.cloudinary.com/dlcjuc3ej/image/upload/v1612458006/kn3jq2u5chw7uq36babw.svg#/keystone/api/icons/601c2818b376e300280e707d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19e95f84-3d2d-43bb-b090-9be05fb9101a&quot;,&quot;order&quot;:&quot;05&quot;}},&quot;6099d7f6-bf3d-48e1-87ec-8f9ffc1e9f4a&quot;:{&quot;id&quot;:&quot;6099d7f6-bf3d-48e1-87ec-8f9ffc1e9f4a&quot;,&quot;name&quot;:&quot;Mouse (symbol)&quot;,&quot;displayName&quot;:&quot;&quot;,&quot;type&quot;:&quot;FIGURE_OBJECT&quot;,&quot;relativeTransform&quot;:{&quot;translate&quot;:{&quot;x&quot;:-239.23200000000003,&quot;y&quot;:-10.737000000000009},&quot;rotate&quot;:0,&quot;skewX&quot;:0,&quot;scale&quot;:{&quot;x&quot;:1,&quot;y&quot;:1}},&quot;image&quot;:{&quot;url&quot;:&quot;https://icons.biorender.com/biorender/5fb58802d6bd96002858258b/mouse-icon.png&quot;,&quot;fallbackUrl&quot;:&quot;https://res.cloudinary.com/dlcjuc3ej/image/upload/v1605732349/rimrj4n97wjez1yibmcx.svg#/keystone/api/icons/5fb58802d6bd96002858258b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19e95f84-3d2d-43bb-b090-9be05fb9101a&quot;,&quot;order&quot;:&quot;1&quot;}},&quot;14ec833c-6250-4c7c-8465-597c5f539007&quot;:{&quot;id&quot;:&quot;14ec833c-6250-4c7c-8465-597c5f539007&quot;,&quot;type&quot;:&quot;FIGURE_OBJECT&quot;,&quot;relativeTransform&quot;:{&quot;translate&quot;:{&quot;x&quot;:-203.0554112548828,&quot;y&quot;:-68.47719432821904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9.640627873825306,&quot;color&quot;:&quot;black&quot;,&quot;fontWeight&quot;:&quot;normal&quot;,&quot;fontStyle&quot;:&quot;normal&quot;,&quot;decoration&quot;:&quot;none&quot;},&quot;range&quot;:[0,1]}],&quot;text&quot;:&quot;WT&quot;},{&quot;runs&quot;:[{&quot;style&quot;:{&quot;fontFamily&quot;:&quot;Roboto&quot;,&quot;fontSize&quot;:19.640627873825306,&quot;color&quot;:&quot;black&quot;,&quot;fontWeight&quot;:&quot;normal&quot;,&quot;fontStyle&quot;:&quot;normal&quot;,&quot;decoration&quot;:&quot;none&quot;},&quot;range&quot;:[0,25]}],&quot;text&quot;:&quot;                          &quot;,&quot;baseStyle&quot;:{&quot;fontFamily&quot;:&quot;Roboto&quot;,&quot;fontSize&quot;:19.640627873825306,&quot;color&quot;:&quot;black&quot;,&quot;fontWeight&quot;:&quot;normal&quot;,&quot;fontStyle&quot;:&quot;normal&quot;,&quot;decoration&quot;:&quot;none&quot;,&quot;script&quot;:&quot;none&quot;}},{&quot;runs&quot;:[],&quot;text&quot;:&quot;&quot;,&quot;baseStyle&quot;:{&quot;fontFamily&quot;:&quot;Roboto&quot;,&quot;fontSize&quot;:19.640627873825306,&quot;color&quot;:&quot;black&quot;,&quot;fontWeight&quot;:&quot;normal&quot;,&quot;fontStyle&quot;:&quot;normal&quot;,&quot;decoration&quot;:&quot;none&quot;}},{&quot;runs&quot;:[],&quot;text&quot;:&quot;&quot;,&quot;baseStyle&quot;:{&quot;fontFamily&quot;:&quot;Roboto&quot;,&quot;fontSize&quot;:19.640627873825306,&quot;color&quot;:&quot;black&quot;,&quot;fontWeight&quot;:&quot;normal&quot;,&quot;fontStyle&quot;:&quot;normal&quot;,&quot;decoration&quot;:&quot;none&quot;}}],&quot;_lastCaretLocation&quot;:{&quot;lineIndex&quot;:3,&quot;runIndex&quot;:-1,&quot;charIndex&quot;:-1,&quot;endOfLine&quot;:true}},&quot;format&quot;:&quot;BETTER_TEXT&quot;,&quot;size&quot;:{&quot;x&quot;:126.41317749023438,&quot;y&quot;:89.72961134356188},&quot;targetSize&quot;:{&quot;x&quot;:126.41317749023438,&quot;y&quot;:89.72961134356188}},&quot;parent&quot;:{&quot;type&quot;:&quot;CHILD&quot;,&quot;parentId&quot;:&quot;19e95f84-3d2d-43bb-b090-9be05fb9101a&quot;,&quot;order&quot;:&quot;15&quot;}},&quot;f07949aa-1d7f-43f0-8e28-6a468b2ff0f6&quot;:{&quot;id&quot;:&quot;f07949aa-1d7f-43f0-8e28-6a468b2ff0f6&quot;,&quot;name&quot;:&quot;Mouse (symbol)&quot;,&quot;displayName&quot;:&quot;&quot;,&quot;type&quot;:&quot;FIGURE_OBJECT&quot;,&quot;relativeTransform&quot;:{&quot;translate&quot;:{&quot;x&quot;:9.475346011114553,&quot;y&quot;:-58.04062287604293},&quot;rotate&quot;:0,&quot;skewX&quot;:0,&quot;scale&quot;:{&quot;x&quot;:1.3485730797777087,&quot;y&quot;:1.3485730797777087}},&quot;image&quot;:{&quot;url&quot;:&quot;https://icons.biorender.com/biorender/601c2818b376e300280e707d/mouse-icon.png&quot;,&quot;fallbackUrl&quot;:&quot;https://res.cloudinary.com/dlcjuc3ej/image/upload/v1612458006/kn3jq2u5chw7uq36babw.svg#/keystone/api/icons/601c2818b376e300280e707d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19e95f84-3d2d-43bb-b090-9be05fb9101a&quot;,&quot;order&quot;:&quot;2&quot;}},&quot;0a89a2ab-34ef-4d20-8668-3b0200128642&quot;:{&quot;id&quot;:&quot;0a89a2ab-34ef-4d20-8668-3b0200128642&quot;,&quot;name&quot;:&quot;Syringe (symbol)&quot;,&quot;displayName&quot;:&quot;&quot;,&quot;type&quot;:&quot;FIGURE_OBJECT&quot;,&quot;relativeTransform&quot;:{&quot;translate&quot;:{&quot;x&quot;:52.903999999999996,&quot;y&quot;:-68.56099999999998},&quot;rotate&quot;:0,&quot;skewX&quot;:0,&quot;scale&quot;:{&quot;x&quot;:0.48,&quot;y&quot;:0.48}},&quot;image&quot;:{&quot;url&quot;:&quot;https://icons.biorender.com/biorender/6329d8138dc9890028b7ac18/20220920151714/image/syringe-symbol.png&quot;,&quot;fallbackUrl&quot;:&quot;https://res.cloudinary.com/dlcjuc3ej/image/upload/v1663687034/m5hsqtsruhjwxxci76ns.svg#/keystone/api/icons/6329d8138dc9890028b7ac18/20220920151714/image/syringe-symbol.svg&quot;,&quot;isPremium&quot;:false,&quot;size&quot;:{&quot;x&quot;:100,&quot;y&quot;:100}},&quot;source&quot;:{&quot;id&quot;:&quot;6329d8138dc9890028b7ac18&quot;,&quot;type&quot;:&quot;ASSETS&quot;},&quot;isPremium&quot;:false,&quot;parent&quot;:{&quot;type&quot;:&quot;CHILD&quot;,&quot;parentId&quot;:&quot;19e95f84-3d2d-43bb-b090-9be05fb9101a&quot;,&quot;order&quot;:&quot;25&quot;}},&quot;1d733c0c-56e4-4402-b695-c9a2fef2337a&quot;:{&quot;id&quot;:&quot;1d733c0c-56e4-4402-b695-c9a2fef2337a&quot;,&quot;type&quot;:&quot;FIGURE_OBJECT&quot;,&quot;relativeTransform&quot;:{&quot;translate&quot;:{&quot;x&quot;:-114.1405,&quot;y&quot;:-61.30864818595654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22.39305536651392,&quot;color&quot;:&quot;black&quot;,&quot;fontWeight&quot;:&quot;normal&quot;,&quot;fontStyle&quot;:&quot;normal&quot;,&quot;decoration&quot;:&quot;none&quot;,&quot;script&quot;:&quot;super&quot;},&quot;range&quot;:[0,12]}],&quot;text&quot;:&quot;Sort 300 HSCs&quot;}],&quot;_lastCaretLocation&quot;:{&quot;lineIndex&quot;:0,&quot;runIndex&quot;:-1,&quot;charIndex&quot;:-1,&quot;endOfLine&quot;:true}},&quot;format&quot;:&quot;BETTER_TEXT&quot;,&quot;size&quot;:{&quot;x&quot;:132.2050000000001,&quot;y&quot;:30.21462970524627},&quot;targetSize&quot;:{&quot;x&quot;:132.2050000000001,&quot;y&quot;:30.21462970524627}},&quot;parent&quot;:{&quot;type&quot;:&quot;CHILD&quot;,&quot;parentId&quot;:&quot;19e95f84-3d2d-43bb-b090-9be05fb9101a&quot;,&quot;order&quot;:&quot;3&quot;}},&quot;07341810-3389-4d8a-a9f1-f4a20e68da61&quot;:{&quot;id&quot;:&quot;07341810-3389-4d8a-a9f1-f4a20e68da61&quot;,&quot;type&quot;:&quot;FIGURE_OBJECT&quot;,&quot;relativeTransform&quot;:{&quot;translate&quot;:{&quot;x&quot;:-245.97650000000004,&quot;y&quot;:-65.52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2,&quot;color&quot;:&quot;black&quot;,&quot;fontWeight&quot;:&quot;normal&quot;,&quot;fontStyle&quot;:&quot;normal&quot;,&quot;decoration&quot;:&quot;underline&quot;},&quot;range&quot;:[0,4]},{&quot;style&quot;:{&quot;fontFamily&quot;:&quot;Roboto&quot;,&quot;fontSize&quot;:12,&quot;color&quot;:&quot;black&quot;,&quot;fontWeight&quot;:&quot;normal&quot;,&quot;fontStyle&quot;:&quot;normal&quot;,&quot;decoration&quot;:&quot;none&quot;},&quot;range&quot;:[5,12]}],&quot;text&quot;:&quot;Donor: CD45.2&quot;}],&quot;_lastCaretLocation&quot;:{&quot;lineIndex&quot;:0,&quot;runIndex&quot;:0,&quot;charIndex&quot;:0}},&quot;format&quot;:&quot;BETTER_TEXT&quot;,&quot;size&quot;:{&quot;x&quot;:86.51100000000002,&quot;y&quot;:18.439999999999998},&quot;targetSize&quot;:{&quot;x&quot;:86.51100000000002,&quot;y&quot;:18.439999999999998}},&quot;parent&quot;:{&quot;type&quot;:&quot;CHILD&quot;,&quot;parentId&quot;:&quot;19e95f84-3d2d-43bb-b090-9be05fb9101a&quot;,&quot;order&quot;:&quot;4&quot;}},&quot;925630b0-ffbf-4ef3-8226-4252bcfaff85&quot;:{&quot;id&quot;:&quot;925630b0-ffbf-4ef3-8226-4252bcfaff85&quot;,&quot;type&quot;:&quot;FIGURE_OBJECT&quot;,&quot;relativeTransform&quot;:{&quot;translate&quot;:{&quot;x&quot;:52.90399999999999,&quot;y&quot;:-134.1689999999999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,&quot;script&quot;:&quot;super&quot;},&quot;range&quot;:[0,2]}],&quot;text&quot;:&quot;9Gy&quot;}],&quot;_lastCaretLocation&quot;:{&quot;lineIndex&quot;:0,&quot;runIndex&quot;:-1,&quot;charIndex&quot;:-1,&quot;endOfLine&quot;:true}},&quot;format&quot;:&quot;BETTER_TEXT&quot;,&quot;size&quot;:{&quot;x&quot;:120,&quot;y&quot;:22},&quot;targetSize&quot;:{&quot;x&quot;:120,&quot;y&quot;:18.439999999999998}},&quot;parent&quot;:{&quot;type&quot;:&quot;CHILD&quot;,&quot;parentId&quot;:&quot;19e95f84-3d2d-43bb-b090-9be05fb9101a&quot;,&quot;order&quot;:&quot;5&quot;}},&quot;e79815ff-56d0-4285-8391-1e854e0de897&quot;:{&quot;id&quot;:&quot;e79815ff-56d0-4285-8391-1e854e0de897&quot;,&quot;type&quot;:&quot;FIGURE_OBJECT&quot;,&quot;relativeTransform&quot;:{&quot;translate&quot;:{&quot;x&quot;:-226.02541125488287,&quot;y&quot;:68.1068056717809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9.640627873825306,&quot;color&quot;:&quot;black&quot;,&quot;fontWeight&quot;:&quot;normal&quot;,&quot;fontStyle&quot;:&quot;normal&quot;,&quot;decoration&quot;:&quot;none&quot;},&quot;range&quot;:[0,3]},{&quot;style&quot;:{&quot;fontFamily&quot;:&quot;Roboto&quot;,&quot;fontSize&quot;:19.640627873825306,&quot;color&quot;:&quot;black&quot;,&quot;fontWeight&quot;:&quot;normal&quot;,&quot;fontStyle&quot;:&quot;normal&quot;,&quot;decoration&quot;:&quot;none&quot;,&quot;script&quot;:&quot;super&quot;},&quot;range&quot;:[4,13]}],&quot;text&quot;:&quot;P2H1Ad. cortex&quot;},{&quot;runs&quot;:[{&quot;style&quot;:{&quot;fontFamily&quot;:&quot;Roboto&quot;,&quot;fontSize&quot;:19.640627873825306,&quot;color&quot;:&quot;black&quot;,&quot;fontWeight&quot;:&quot;normal&quot;,&quot;fontStyle&quot;:&quot;normal&quot;,&quot;decoration&quot;:&quot;none&quot;},&quot;range&quot;:[0,25]}],&quot;text&quot;:&quot;                          &quot;,&quot;baseStyle&quot;:{&quot;fontFamily&quot;:&quot;Roboto&quot;,&quot;fontSize&quot;:19.640627873825306,&quot;color&quot;:&quot;black&quot;,&quot;fontWeight&quot;:&quot;normal&quot;,&quot;fontStyle&quot;:&quot;normal&quot;,&quot;decoration&quot;:&quot;none&quot;,&quot;script&quot;:&quot;none&quot;}},{&quot;runs&quot;:[],&quot;text&quot;:&quot;&quot;,&quot;baseStyle&quot;:{&quot;fontFamily&quot;:&quot;Roboto&quot;,&quot;fontSize&quot;:19.640627873825306,&quot;color&quot;:&quot;black&quot;,&quot;fontWeight&quot;:&quot;normal&quot;,&quot;fontStyle&quot;:&quot;normal&quot;,&quot;decoration&quot;:&quot;none&quot;}},{&quot;runs&quot;:[],&quot;text&quot;:&quot;&quot;,&quot;baseStyle&quot;:{&quot;fontFamily&quot;:&quot;Roboto&quot;,&quot;fontSize&quot;:19.640627873825306,&quot;color&quot;:&quot;black&quot;,&quot;fontWeight&quot;:&quot;normal&quot;,&quot;fontStyle&quot;:&quot;normal&quot;,&quot;decoration&quot;:&quot;none&quot;}}],&quot;_lastCaretLocation&quot;:{&quot;lineIndex&quot;:0,&quot;runIndex&quot;:1,&quot;charIndex&quot;:4}},&quot;format&quot;:&quot;BETTER_TEXT&quot;,&quot;size&quot;:{&quot;x&quot;:126.41317749023438,&quot;y&quot;:89.72961134356188},&quot;targetSize&quot;:{&quot;x&quot;:126.41317749023438,&quot;y&quot;:89.72961134356188}},&quot;parent&quot;:{&quot;type&quot;:&quot;CHILD&quot;,&quot;parentId&quot;:&quot;19e95f84-3d2d-43bb-b090-9be05fb9101a&quot;,&quot;order&quot;:&quot;52&quot;}},&quot;8a9ec158-225e-4539-acdc-0a09fade4b1d&quot;:{&quot;type&quot;:&quot;FIGURE_OBJECT&quot;,&quot;id&quot;:&quot;8a9ec158-225e-4539-acdc-0a09fade4b1d&quot;,&quot;relativeTransform&quot;:{&quot;translate&quot;:{&quot;x&quot;:-132.69400000000002,&quot;y&quot;:-58.309},&quot;rotate&quot;:0,&quot;skewX&quot;:0,&quot;scale&quot;:{&quot;x&quot;:1,&quot;y&quot;:1}},&quot;opacity&quot;:1,&quot;path&quot;:{&quot;type&quot;:&quot;POLY_LINE&quot;,&quot;points&quot;:[{&quot;x&quot;:-51.75,&quot;y&quot;:0},{&quot;x&quot;:51.75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9e95f84-3d2d-43bb-b090-9be05fb9101a&quot;,&quot;order&quot;:&quot;55&quot;},&quot;connectorInfo&quot;:{&quot;connectedObjects&quot;:[],&quot;type&quot;:&quot;LINE&quot;,&quot;offset&quot;:{&quot;x&quot;:0,&quot;y&quot;:0},&quot;bending&quot;:0.1,&quot;firstElementIsHead&quot;:true,&quot;customized&quot;:false}},&quot;04e3a772-013a-41fe-a6ae-099ce36c834f&quot;:{&quot;id&quot;:&quot;04e3a772-013a-41fe-a6ae-099ce36c834f&quot;,&quot;type&quot;:&quot;FIGURE_OBJECT&quot;,&quot;relativeTransform&quot;:{&quot;translate&quot;:{&quot;x&quot;:15.715000000000025,&quot;y&quot;:2.826999999999978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2,&quot;color&quot;:&quot;black&quot;,&quot;fontWeight&quot;:&quot;normal&quot;,&quot;fontStyle&quot;:&quot;normal&quot;,&quot;decoration&quot;:&quot;underline&quot;},&quot;range&quot;:[0,8]},{&quot;style&quot;:{&quot;fontFamily&quot;:&quot;Roboto&quot;,&quot;fontSize&quot;:12,&quot;color&quot;:&quot;black&quot;,&quot;fontWeight&quot;:&quot;normal&quot;,&quot;fontStyle&quot;:&quot;normal&quot;,&quot;decoration&quot;:&quot;none&quot;},&quot;range&quot;:[9,22]}],&quot;text&quot;:&quot;Recipient: F1(CD45.1&amp;2)&quot;}],&quot;_lastCaretLocation&quot;:{&quot;lineIndex&quot;:0,&quot;runIndex&quot;:-1,&quot;charIndex&quot;:-1,&quot;endOfLine&quot;:true}},&quot;format&quot;:&quot;BETTER_TEXT&quot;,&quot;size&quot;:{&quot;x&quot;:141.33600000000004,&quot;y&quot;:27.56},&quot;targetSize&quot;:{&quot;x&quot;:141.33600000000004,&quot;y&quot;:27.56}},&quot;parent&quot;:{&quot;type&quot;:&quot;CHILD&quot;,&quot;parentId&quot;:&quot;19e95f84-3d2d-43bb-b090-9be05fb9101a&quot;,&quot;order&quot;:&quot;6&quot;}},&quot;5d922b5c-9ba1-4f78-8107-7d1be707545b&quot;:{&quot;id&quot;:&quot;5d922b5c-9ba1-4f78-8107-7d1be707545b&quot;,&quot;name&quot;:&quot;Lightning bolt 1&quot;,&quot;displayName&quot;:&quot;&quot;,&quot;type&quot;:&quot;FIGURE_OBJECT&quot;,&quot;relativeTransform&quot;:{&quot;translate&quot;:{&quot;x&quot;:-16.913241482740048,&quot;y&quot;:-113.507},&quot;rotate&quot;:0.3320349990784535,&quot;skewX&quot;:5.149815349435626e-17,&quot;scale&quot;:{&quot;x&quot;:0.36707034069040156,&quot;y&quot;:0.29912499999999986}},&quot;image&quot;:{&quot;url&quot;:&quot;https://icons.biorender.com/biorender/5be5f1197664d21200a3f98a/20190307182952/image/lightning-bolt-3.png&quot;,&quot;fallbackUrl&quot;:&quot;https://res.cloudinary.com/dlcjuc3ej/image/upload/v1551983392/gylv2vvoftxt4iju8wqw.svg#/keystone/api/icons/5be5f1197664d21200a3f98a/20190307182952/image/lightning-bolt-3.svg&quot;,&quot;isPremium&quot;:false,&quot;size&quot;:{&quot;x&quot;:50,&quot;y&quot;:126.98412698412697}},&quot;source&quot;:{&quot;id&quot;:&quot;5be5f1197664d21200a3f98a&quot;,&quot;type&quot;:&quot;ASSETS&quot;},&quot;isPremium&quot;:false,&quot;parent&quot;:{&quot;type&quot;:&quot;CHILD&quot;,&quot;parentId&quot;:&quot;19e95f84-3d2d-43bb-b090-9be05fb9101a&quot;,&quot;order&quot;:&quot;65&quot;}},&quot;0c27f448-a711-46d7-93cd-47b38bee2a1f&quot;:{&quot;id&quot;:&quot;0c27f448-a711-46d7-93cd-47b38bee2a1f&quot;,&quot;type&quot;:&quot;FIGURE_OBJECT&quot;,&quot;relativeTransform&quot;:{&quot;translate&quot;:{&quot;x&quot;:95.00049999999999,&quot;y&quot;:-112.24900000000002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2,&quot;color&quot;:&quot;black&quot;,&quot;fontWeight&quot;:&quot;normal&quot;,&quot;fontStyle&quot;:&quot;normal&quot;,&quot;decoration&quot;:&quot;none&quot;},&quot;range&quot;:[0,5]},{&quot;style&quot;:{&quot;fontFamily&quot;:&quot;Roboto&quot;,&quot;fontSize&quot;:12,&quot;color&quot;:&quot;black&quot;,&quot;fontWeight&quot;:&quot;normal&quot;,&quot;fontStyle&quot;:&quot;normal&quot;,&quot;decoration&quot;:&quot;none&quot;,&quot;script&quot;:&quot;super&quot;},&quot;range&quot;:[6,6]},{&quot;style&quot;:{&quot;fontFamily&quot;:&quot;Roboto&quot;,&quot;fontSize&quot;:12,&quot;color&quot;:&quot;black&quot;,&quot;fontWeight&quot;:&quot;normal&quot;,&quot;fontStyle&quot;:&quot;normal&quot;,&quot;decoration&quot;:&quot;none&quot;},&quot;range&quot;:[7,13]}],&quot;text&quot;:&quot;+ 5x105 CD45.1&quot;,&quot;baseStyle&quot;:{&quot;fontFamily&quot;:&quot;Roboto&quot;,&quot;fontSize&quot;:12,&quot;color&quot;:&quot;black&quot;,&quot;fontWeight&quot;:&quot;normal&quot;,&quot;fontStyle&quot;:&quot;normal&quot;,&quot;decoration&quot;:&quot;none&quot;,&quot;script&quot;:&quot;super&quot;}},{&quot;runs&quot;:[{&quot;style&quot;:{&quot;fontFamily&quot;:&quot;Roboto&quot;,&quot;fontSize&quot;:12,&quot;color&quot;:&quot;black&quot;,&quot;fontWeight&quot;:&quot;normal&quot;,&quot;fontStyle&quot;:&quot;normal&quot;,&quot;decoration&quot;:&quot;none&quot;,&quot;script&quot;:&quot;none&quot;},&quot;range&quot;:[0,13]}],&quot;text&quot;:&quot;competitor TBM&quot;}],&quot;_lastCaretLocation&quot;:{&quot;lineIndex&quot;:1,&quot;runIndex&quot;:-1,&quot;charIndex&quot;:-1,&quot;endOfLine&quot;:true}},&quot;format&quot;:&quot;BETTER_TEXT&quot;,&quot;size&quot;:{&quot;x&quot;:123.05100000000003,&quot;y&quot;:27.56},&quot;targetSize&quot;:{&quot;x&quot;:123.05100000000003,&quot;y&quot;:27.56}},&quot;parent&quot;:{&quot;type&quot;:&quot;CHILD&quot;,&quot;parentId&quot;:&quot;19e95f84-3d2d-43bb-b090-9be05fb9101a&quot;,&quot;order&quot;:&quot;7&quot;}},&quot;60a7c26a-8649-436a-a020-305723579dd5&quot;:{&quot;type&quot;:&quot;FIGURE_OBJECT&quot;,&quot;id&quot;:&quot;60a7c26a-8649-436a-a020-305723579dd5&quot;,&quot;relativeTransform&quot;:{&quot;translate&quot;:{&quot;x&quot;:160.30599999999998,&quot;y&quot;:-58.309},&quot;rotate&quot;:0,&quot;skewX&quot;:0,&quot;scale&quot;:{&quot;x&quot;:1,&quot;y&quot;:1}},&quot;opacity&quot;:1,&quot;path&quot;:{&quot;type&quot;:&quot;POLY_LINE&quot;,&quot;points&quot;:[{&quot;x&quot;:-51.75,&quot;y&quot;:0},{&quot;x&quot;:51.75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9e95f84-3d2d-43bb-b090-9be05fb9101a&quot;,&quot;order&quot;:&quot;72&quot;},&quot;connectorInfo&quot;:{&quot;connectedObjects&quot;:[],&quot;type&quot;:&quot;LINE&quot;,&quot;offset&quot;:{&quot;x&quot;:0,&quot;y&quot;:0},&quot;bending&quot;:0.1,&quot;firstElementIsHead&quot;:true,&quot;customized&quot;:false}},&quot;3b96dbbf-8a48-456e-a3de-71dbb38b0f6b&quot;:{&quot;id&quot;:&quot;3b96dbbf-8a48-456e-a3de-71dbb38b0f6b&quot;,&quot;type&quot;:&quot;FIGURE_OBJECT&quot;,&quot;relativeTransform&quot;:{&quot;translate&quot;:{&quot;x&quot;:319.228,&quot;y&quot;:2.352885809796413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],&quot;text&quot;:&quot;&quot;,&quot;baseStyle&quot;:{&quot;fontFamily&quot;:&quot;Roboto&quot;,&quot;fontSize&quot;:14.932620289647463,&quot;color&quot;:&quot;black&quot;,&quot;fontWeight&quot;:&quot;normal&quot;,&quot;fontStyle&quot;:&quot;normal&quot;,&quot;decoration&quot;:&quot;none&quot;}},{&quot;runs&quot;:[{&quot;style&quot;:{&quot;fontFamily&quot;:&quot;Roboto&quot;,&quot;fontSize&quot;:14.932620289647463,&quot;color&quot;:&quot;black&quot;,&quot;fontWeight&quot;:&quot;normal&quot;,&quot;fontStyle&quot;:&quot;normal&quot;,&quot;decoration&quot;:&quot;none&quot;,&quot;script&quot;:&quot;none&quot;},&quot;range&quot;:[0,21]}],&quot;text&quot;:&quot;Blood and BM analyses &quot;,&quot;baseStyle&quot;:{&quot;fontFamily&quot;:&quot;Roboto&quot;,&quot;fontSize&quot;:14.932620289647463,&quot;color&quot;:&quot;black&quot;,&quot;fontWeight&quot;:&quot;normal&quot;,&quot;fontStyle&quot;:&quot;normal&quot;,&quot;decoration&quot;:&quot;none&quot;,&quot;script&quot;:&quot;none&quot;}}],&quot;_lastCaretLocation&quot;:{&quot;lineIndex&quot;:1,&quot;runIndex&quot;:-1,&quot;charIndex&quot;:-1,&quot;endOfLine&quot;:true}},&quot;format&quot;:&quot;BETTER_TEXT&quot;,&quot;size&quot;:{&quot;x&quot;:201.04399999999995,&quot;y&quot;:67.67531390815002},&quot;targetSize&quot;:{&quot;x&quot;:201.04399999999995,&quot;y&quot;:67.67531390815002}},&quot;parent&quot;:{&quot;type&quot;:&quot;CHILD&quot;,&quot;parentId&quot;:&quot;19e95f84-3d2d-43bb-b090-9be05fb9101a&quot;,&quot;order&quot;:&quot;75&quot;}},&quot;8fc2b113-23f1-4468-a865-047f17669190&quot;:{&quot;id&quot;:&quot;8fc2b113-23f1-4468-a865-047f17669190&quot;,&quot;name&quot;:&quot;Bone marrow (femur, red and yellow)&quot;,&quot;displayName&quot;:&quot;&quot;,&quot;type&quot;:&quot;FIGURE_OBJECT&quot;,&quot;relativeTransform&quot;:{&quot;translate&quot;:{&quot;x&quot;:283.63672549019617,&quot;y&quot;:-55.24899999999998},&quot;rotate&quot;:0,&quot;skewX&quot;:0,&quot;scale&quot;:{&quot;x&quot;:0.3086274509803919,&quot;y&quot;:0.3086274509803919}},&quot;image&quot;:{&quot;url&quot;:&quot;https://icons.biorender.com/biorender/5c0ab6e23fbb901200f2abe1/20181207181034/image/bone-marrow-femur-red-and-yellow.png&quot;,&quot;fallbackUrl&quot;:&quot;https://res.cloudinary.com/dlcjuc3ej/image/upload/v1544206234/nd3qh9ckhxwgmxxajsrx.svg#/keystone/api/icons/5c0ab6e23fbb901200f2abe1/20181207181034/image/bone-marrow-femur-red-and-yellow.svg&quot;,&quot;isPremium&quot;:true,&quot;size&quot;:{&quot;x&quot;:100,&quot;y&quot;:237.2093023255814}},&quot;source&quot;:{&quot;id&quot;:&quot;5c0ab6e23fbb901200f2abe1&quot;,&quot;type&quot;:&quot;ASSETS&quot;},&quot;isPremium&quot;:true,&quot;parent&quot;:{&quot;type&quot;:&quot;CHILD&quot;,&quot;parentId&quot;:&quot;19e95f84-3d2d-43bb-b090-9be05fb9101a&quot;,&quot;order&quot;:&quot;8&quot;}},&quot;5184b5cd-aaa4-48cc-91d6-a4e10e63190b&quot;:{&quot;id&quot;:&quot;5184b5cd-aaa4-48cc-91d6-a4e10e63190b&quot;,&quot;name&quot;:&quot;Blood vial (labelled)&quot;,&quot;displayName&quot;:&quot;&quot;,&quot;type&quot;:&quot;FIGURE_OBJECT&quot;,&quot;relativeTransform&quot;:{&quot;translate&quot;:{&quot;x&quot;:253.93105857740585,&quot;y&quot;:-70.00899999999999},&quot;rotate&quot;:0,&quot;skewX&quot;:0,&quot;scale&quot;:{&quot;x&quot;:0.3309623430962344,&quot;y&quot;:0.3309623430962344}},&quot;image&quot;:{&quot;url&quot;:&quot;https://icons.biorender.com/biorender/5dbafc93c9e7d80004b85b52/20191031152445/image/blood-vial-labelled.png&quot;,&quot;fallbackUrl&quot;:&quot;https://res.cloudinary.com/dlcjuc3ej/image/upload/v1572535485/xokmqyvumsqposaheemj.svg#/keystone/api/icons/5dbafc93c9e7d80004b85b52/20191031152445/image/blood-vial-labelled.svg&quot;,&quot;isPremium&quot;:false,&quot;size&quot;:{&quot;x&quot;:50,&quot;y&quot;:183.84615384615387}},&quot;source&quot;:{&quot;id&quot;:&quot;5dbafc93c9e7d80004b85b52&quot;,&quot;type&quot;:&quot;ASSETS&quot;},&quot;isPremium&quot;:false,&quot;parent&quot;:{&quot;type&quot;:&quot;CHILD&quot;,&quot;parentId&quot;:&quot;19e95f84-3d2d-43bb-b090-9be05fb9101a&quot;,&quot;order&quot;:&quot;9&quot;}},&quot;83722fad-5652-49c1-b8ca-8f633f8a1f12&quot;:{&quot;id&quot;:&quot;83722fad-5652-49c1-b8ca-8f633f8a1f12&quot;,&quot;name&quot;:&quot;Cell sorter (BD FACSAria II)&quot;,&quot;displayName&quot;:&quot;&quot;,&quot;type&quot;:&quot;FIGURE_OBJECT&quot;,&quot;relativeTransform&quot;:{&quot;translate&quot;:{&quot;x&quot;:293.70550000000003,&quot;y&quot;:-84.62739030612244},&quot;rotate&quot;:0,&quot;skewX&quot;:0,&quot;scale&quot;:{&quot;x&quot;:0.6173749999999999,&quot;y&quot;:0.8267634487951808}},&quot;image&quot;:{&quot;url&quot;:&quot;https://icons.biorender.com/biorender/5c98edd48afb2d330057e73e/20190325150511/image/cell-sorter-bd-facsaria-ii.png&quot;,&quot;fallbackUrl&quot;:&quot;https://res.cloudinary.com/dlcjuc3ej/image/upload/v1553526311/perdko6um69f9hwk0zls.svg#/keystone/api/icons/5c98edd48afb2d330057e73e/20190325150511/image/cell-sorter-bd-facsaria-ii.svg&quot;,&quot;isPremium&quot;:false,&quot;size&quot;:{&quot;x&quot;:200,&quot;y&quot;:112.92517006802721}},&quot;source&quot;:{&quot;id&quot;:&quot;5c98edd48afb2d330057e73e&quot;,&quot;type&quot;:&quot;ASSETS&quot;},&quot;isPremium&quot;:false,&quot;parent&quot;:{&quot;type&quot;:&quot;CHILD&quot;,&quot;parentId&quot;:&quot;19e95f84-3d2d-43bb-b090-9be05fb9101a&quot;,&quot;order&quot;:&quot;22&quot;},&quot;opacity&quot;:0.74},&quot;2578ad7e-95e8-48e2-ac2a-a098fc0ba104&quot;:{&quot;type&quot;:&quot;FIGURE_OBJECT&quot;,&quot;id&quot;:&quot;2578ad7e-95e8-48e2-ac2a-a098fc0ba104&quot;,&quot;relativeTransform&quot;:{&quot;translate&quot;:{&quot;x&quot;:26.337000000000117,&quot;y&quot;:-66.31000000000003},&quot;rotate&quot;:0},&quot;opacity&quot;:1,&quot;path&quot;:{&quot;type&quot;:&quot;RECT&quot;,&quot;size&quot;:{&quot;x&quot;:719.2499999999998,&quot;y&quot;:249.4999999999999},&quot;cornerRounding&quot;:{&quot;type&quot;:&quot;ARC_LENGTH&quot;,&quot;global&quot;:15.70796326794896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19e95f84-3d2d-43bb-b090-9be05fb9101a&quot;,&quot;order&quot;:&quot;02&quot;}},&quot;19e95f84-3d2d-43bb-b090-9be05fb9101a&quot;:{&quot;type&quot;:&quot;FIGURE_OBJECT&quot;,&quot;id&quot;:&quot;19e95f84-3d2d-43bb-b090-9be05fb9101a&quot;,&quot;parent&quot;:{&quot;type&quot;:&quot;CHILD&quot;,&quot;parentId&quot;:&quot;df2ac314-d8c7-45c8-8b7c-ac9510057d19&quot;,&quot;order&quot;:&quot;9997&quot;},&quot;relativeTransform&quot;:{}}}}"/>
    <we:property name="66310a031f023443bd053817_1714491586558" value="{&quot;id&quot;:&quot;3ce9aaae-28b1-4c79-8497-f74f88316c6a&quot;,&quot;objects&quot;:{&quot;3ce9aaae-28b1-4c79-8497-f74f88316c6a&quot;:{&quot;id&quot;:&quot;3ce9aaae-28b1-4c79-8497-f74f88316c6a&quot;,&quot;type&quot;:&quot;FIGURE_OBJECT&quot;,&quot;document&quot;:{&quot;type&quot;:&quot;DOCUMENT_GROUP&quot;,&quot;canvasType&quot;:&quot;FIGURE&quot;,&quot;units&quot;:&quot;in&quot;}},&quot;2f595a6a-bbd4-4fc9-a6c2-05bc0fa2219b&quot;:{&quot;id&quot;:&quot;2f595a6a-bbd4-4fc9-a6c2-05bc0fa2219b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3ce9aaae-28b1-4c79-8497-f74f88316c6a&quot;,&quot;type&quot;:&quot;FRAME&quot;,&quot;order&quot;:&quot;5&quot;}},&quot;f5a62bab-889b-4952-a80d-9947ad5d0c8f&quot;:{&quot;id&quot;:&quot;f5a62bab-889b-4952-a80d-9947ad5d0c8f&quot;,&quot;type&quot;:&quot;FIGURE_OBJECT&quot;,&quot;document&quot;:{&quot;type&quot;:&quot;FIGURE&quot;,&quot;canvasType&quot;:&quot;FIGURE&quot;,&quot;units&quot;:&quot;in&quot;},&quot;parent&quot;:{&quot;parentId&quot;:&quot;3ce9aaae-28b1-4c79-8497-f74f88316c6a&quot;,&quot;type&quot;:&quot;DOCUMENT&quot;,&quot;order&quot;:&quot;5&quot;}},&quot;fec4fd23-d6bc-4372-af36-42a7c49b8d44&quot;:{&quot;id&quot;:&quot;fec4fd23-d6bc-4372-af36-42a7c49b8d44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f5a62bab-889b-4952-a80d-9947ad5d0c8f&quot;,&quot;order&quot;:&quot;5&quot;}},&quot;4b3dbb70-541b-486f-92f8-574c41b0b025&quot;:{&quot;id&quot;:&quot;4b3dbb70-541b-486f-92f8-574c41b0b025&quot;,&quot;type&quot;:&quot;FIGURE_OBJECT&quot;,&quot;guide&quot;:{&quot;type&quot;:&quot;GRID&quot;,&quot;distance&quot;:0.5,&quot;units&quot;:&quot;in&quot;},&quot;parent&quot;:{&quot;parentId&quot;:&quot;3ce9aaae-28b1-4c79-8497-f74f88316c6a&quot;,&quot;type&quot;:&quot;GUIDE&quot;,&quot;order&quot;:&quot;5&quot;}},&quot;68470039-b8dd-4add-8aaf-212774608bd2&quot;:{&quot;id&quot;:&quot;68470039-b8dd-4add-8aaf-212774608bd2&quot;,&quot;name&quot;:&quot;B-cell (3D)&quot;,&quot;displayName&quot;:&quot;&quot;,&quot;type&quot;:&quot;FIGURE_OBJECT&quot;,&quot;relativeTransform&quot;:{&quot;translate&quot;:{&quot;x&quot;:-392,&quot;y&quot;:-139.70503595281193},&quot;rotate&quot;:0,&quot;skewX&quot;:0,&quot;scale&quot;:{&quot;x&quot;:1,&quot;y&quot;:0.9106922164658885}},&quot;image&quot;:{&quot;url&quot;:&quot;https://icons.biorender.com/biorender/644a92ebc563ad0020d58f2f/b-cell-3d.png&quot;,&quot;fallbackUrl&quot;:&quot;https://res.cloudinary.com/dlcjuc3ej/image/upload/v1682608868/tinys2redbuysj31frhr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bae4df93-d0ce-4d36-9380-f0ae440aa3c6&quot;,&quot;order&quot;:&quot;2&quot;}},&quot;2d7822a7-d805-4432-bedf-3d15c6011848&quot;:{&quot;id&quot;:&quot;2d7822a7-d805-4432-bedf-3d15c6011848&quot;,&quot;name&quot;:&quot;B-cell (3D)&quot;,&quot;displayName&quot;:&quot;&quot;,&quot;type&quot;:&quot;FIGURE_OBJECT&quot;,&quot;relativeTransform&quot;:{&quot;translate&quot;:{&quot;x&quot;:-329,&quot;y&quot;:-127.86603713875539},&quot;rotate&quot;:0,&quot;skewX&quot;:0,&quot;scale&quot;:{&quot;x&quot;:1,&quot;y&quot;:0.9106922164658885}},&quot;image&quot;:{&quot;url&quot;:&quot;https://icons.biorender.com/biorender/644a92ebc563ad0020d58f2f/b-cell-3d.png&quot;,&quot;fallbackUrl&quot;:&quot;https://res.cloudinary.com/dlcjuc3ej/image/upload/v1682608868/tinys2redbuysj31frhr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bae4df93-d0ce-4d36-9380-f0ae440aa3c6&quot;,&quot;order&quot;:&quot;5&quot;}},&quot;eec0e33b-26d0-4c02-b56b-95fe89a64c47&quot;:{&quot;id&quot;:&quot;eec0e33b-26d0-4c02-b56b-95fe89a64c47&quot;,&quot;name&quot;:&quot;B-cell (3D)&quot;,&quot;displayName&quot;:&quot;&quot;,&quot;type&quot;:&quot;FIGURE_OBJECT&quot;,&quot;relativeTransform&quot;:{&quot;translate&quot;:{&quot;x&quot;:-379,&quot;y&quot;:-89.61696404718806},&quot;rotate&quot;:0,&quot;skewX&quot;:0,&quot;scale&quot;:{&quot;x&quot;:1,&quot;y&quot;:0.9106922164658885}},&quot;image&quot;:{&quot;url&quot;:&quot;https://icons.biorender.com/biorender/644a92ebc563ad0020d58f2f/b-cell-3d.png&quot;,&quot;fallbackUrl&quot;:&quot;https://res.cloudinary.com/dlcjuc3ej/image/upload/v1682608868/tinys2redbuysj31frhr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#/keystone/api/icons/644a92ebc563ad0020d58f2f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bae4df93-d0ce-4d36-9380-f0ae440aa3c6&quot;,&quot;order&quot;:&quot;7&quot;}},&quot;181ad7d3-1ca9-48dd-aedb-06d4e213f227&quot;:{&quot;id&quot;:&quot;181ad7d3-1ca9-48dd-aedb-06d4e213f227&quot;,&quot;name&quot;:&quot;B-cell (3D)&quot;,&quot;displayName&quot;:&quot;&quot;,&quot;type&quot;:&quot;FIGURE_OBJECT&quot;,&quot;relativeTransform&quot;:{&quot;translate&quot;:{&quot;x&quot;:-173,&quot;y&quot;:-139.70503595281193},&quot;rotate&quot;:0,&quot;skewX&quot;:0,&quot;scale&quot;:{&quot;x&quot;:1,&quot;y&quot;:0.9106922164658885}},&quot;image&quot;:{&quot;url&quot;:&quot;https://icons.biorender.com/biorender/644a92ebc563ad0020d58f2e/b-cell-3d.png&quot;,&quot;fallbackUrl&quot;:&quot;https://res.cloudinary.com/dlcjuc3ej/image/upload/v1682608868/pqnismcztavrpklnyaup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77218720-f21b-4853-b92b-11c4d5dd4fbb&quot;,&quot;order&quot;:&quot;2&quot;}},&quot;1ac2d1aa-eb3b-4206-b60b-addc1b2929b2&quot;:{&quot;id&quot;:&quot;1ac2d1aa-eb3b-4206-b60b-addc1b2929b2&quot;,&quot;name&quot;:&quot;B-cell (3D)&quot;,&quot;displayName&quot;:&quot;&quot;,&quot;type&quot;:&quot;FIGURE_OBJECT&quot;,&quot;relativeTransform&quot;:{&quot;translate&quot;:{&quot;x&quot;:-110,&quot;y&quot;:-127.86603713875539},&quot;rotate&quot;:0,&quot;skewX&quot;:0,&quot;scale&quot;:{&quot;x&quot;:1,&quot;y&quot;:0.9106922164658885}},&quot;image&quot;:{&quot;url&quot;:&quot;https://icons.biorender.com/biorender/644a92ebc563ad0020d58f2e/b-cell-3d.png&quot;,&quot;fallbackUrl&quot;:&quot;https://res.cloudinary.com/dlcjuc3ej/image/upload/v1682608868/pqnismcztavrpklnyaup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77218720-f21b-4853-b92b-11c4d5dd4fbb&quot;,&quot;order&quot;:&quot;5&quot;}},&quot;e1a961c2-8930-4a27-bee4-c902225a2ed8&quot;:{&quot;id&quot;:&quot;e1a961c2-8930-4a27-bee4-c902225a2ed8&quot;,&quot;name&quot;:&quot;B-cell (3D)&quot;,&quot;displayName&quot;:&quot;&quot;,&quot;type&quot;:&quot;FIGURE_OBJECT&quot;,&quot;relativeTransform&quot;:{&quot;translate&quot;:{&quot;x&quot;:-160,&quot;y&quot;:-89.61696404718806},&quot;rotate&quot;:0,&quot;skewX&quot;:0,&quot;scale&quot;:{&quot;x&quot;:1,&quot;y&quot;:0.9106922164658885}},&quot;image&quot;:{&quot;url&quot;:&quot;https://icons.biorender.com/biorender/644a92ebc563ad0020d58f2e/b-cell-3d.png&quot;,&quot;fallbackUrl&quot;:&quot;https://res.cloudinary.com/dlcjuc3ej/image/upload/v1682608868/pqnismcztavrpklnyaup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#/keystone/api/icons/644a92ebc563ad0020d58f2e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77218720-f21b-4853-b92b-11c4d5dd4fbb&quot;,&quot;order&quot;:&quot;7&quot;}},&quot;ba225702-34c6-4b43-be01-b7bc2b453e8d&quot;:{&quot;id&quot;:&quot;ba225702-34c6-4b43-be01-b7bc2b453e8d&quot;,&quot;name&quot;:&quot;B-cell (3D)&quot;,&quot;displayName&quot;:&quot;&quot;,&quot;type&quot;:&quot;FIGURE_OBJECT&quot;,&quot;relativeTransform&quot;:{&quot;translate&quot;:{&quot;x&quot;:46,&quot;y&quot;:-139.70503595281193},&quot;rotate&quot;:0,&quot;skewX&quot;:0,&quot;scale&quot;:{&quot;x&quot;:1,&quot;y&quot;:0.9106922164658885}},&quot;image&quot;:{&quot;url&quot;:&quot;https://icons.biorender.com/biorender/644a92ebc563ad0020d58f31/b-cell-3d.png&quot;,&quot;fallbackUrl&quot;:&quot;https://res.cloudinary.com/dlcjuc3ej/image/upload/v1682608868/pevbw0fcqg8ldoibfy4t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abd2c075-8687-493d-a266-8afbe8746ef2&quot;,&quot;order&quot;:&quot;2&quot;}},&quot;769d769e-7d3a-4c16-be0e-49ccfb7b6f0d&quot;:{&quot;id&quot;:&quot;769d769e-7d3a-4c16-be0e-49ccfb7b6f0d&quot;,&quot;name&quot;:&quot;B-cell (3D)&quot;,&quot;displayName&quot;:&quot;&quot;,&quot;type&quot;:&quot;FIGURE_OBJECT&quot;,&quot;relativeTransform&quot;:{&quot;translate&quot;:{&quot;x&quot;:109,&quot;y&quot;:-127.86603713875539},&quot;rotate&quot;:0,&quot;skewX&quot;:0,&quot;scale&quot;:{&quot;x&quot;:1,&quot;y&quot;:0.9106922164658885}},&quot;image&quot;:{&quot;url&quot;:&quot;https://icons.biorender.com/biorender/644a92ebc563ad0020d58f31/b-cell-3d.png&quot;,&quot;fallbackUrl&quot;:&quot;https://res.cloudinary.com/dlcjuc3ej/image/upload/v1682608868/pevbw0fcqg8ldoibfy4t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abd2c075-8687-493d-a266-8afbe8746ef2&quot;,&quot;order&quot;:&quot;5&quot;}},&quot;9f5f2059-38c9-4019-845e-bc7856e17361&quot;:{&quot;id&quot;:&quot;9f5f2059-38c9-4019-845e-bc7856e17361&quot;,&quot;name&quot;:&quot;B-cell (3D)&quot;,&quot;displayName&quot;:&quot;&quot;,&quot;type&quot;:&quot;FIGURE_OBJECT&quot;,&quot;relativeTransform&quot;:{&quot;translate&quot;:{&quot;x&quot;:59,&quot;y&quot;:-89.61696404718806},&quot;rotate&quot;:0,&quot;skewX&quot;:0,&quot;scale&quot;:{&quot;x&quot;:1,&quot;y&quot;:0.9106922164658885}},&quot;image&quot;:{&quot;url&quot;:&quot;https://icons.biorender.com/biorender/644a92ebc563ad0020d58f31/b-cell-3d.png&quot;,&quot;fallbackUrl&quot;:&quot;https://res.cloudinary.com/dlcjuc3ej/image/upload/v1682608868/pevbw0fcqg8ldoibfy4t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#/keystone/api/icons/644a92ebc563ad0020d58f31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abd2c075-8687-493d-a266-8afbe8746ef2&quot;,&quot;order&quot;:&quot;7&quot;}},&quot;8179ec21-6fd3-4628-94ae-a127b4761809&quot;:{&quot;id&quot;:&quot;8179ec21-6fd3-4628-94ae-a127b4761809&quot;,&quot;name&quot;:&quot;B-cell (3D)&quot;,&quot;displayName&quot;:&quot;&quot;,&quot;type&quot;:&quot;FIGURE_OBJECT&quot;,&quot;relativeTransform&quot;:{&quot;translate&quot;:{&quot;x&quot;:291,&quot;y&quot;:-139.70503595281193},&quot;rotate&quot;:0,&quot;skewX&quot;:0,&quot;scale&quot;:{&quot;x&quot;:1,&quot;y&quot;:0.9106922164658885}},&quot;image&quot;:{&quot;url&quot;:&quot;https://icons.biorender.com/biorender/644a92ebc563ad0020d58f30/b-cell-3d.png&quot;,&quot;fallbackUrl&quot;:&quot;https://res.cloudinary.com/dlcjuc3ej/image/upload/v1682608868/g4v1xjqqlbjq64qhyyoj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59a5b085-120a-40e1-a984-550ccd4d843d&quot;,&quot;order&quot;:&quot;2&quot;}},&quot;2c4b7c8a-8d84-4910-8d3a-1e4dfaeda700&quot;:{&quot;id&quot;:&quot;2c4b7c8a-8d84-4910-8d3a-1e4dfaeda700&quot;,&quot;name&quot;:&quot;B-cell (3D)&quot;,&quot;displayName&quot;:&quot;&quot;,&quot;type&quot;:&quot;FIGURE_OBJECT&quot;,&quot;relativeTransform&quot;:{&quot;translate&quot;:{&quot;x&quot;:363,&quot;y&quot;:-139.70453713875537},&quot;rotate&quot;:0,&quot;skewX&quot;:0,&quot;scale&quot;:{&quot;x&quot;:1,&quot;y&quot;:0.7943512741581962}},&quot;image&quot;:{&quot;url&quot;:&quot;https://icons.biorender.com/biorender/644a92ebc563ad0020d58f30/b-cell-3d.png&quot;,&quot;fallbackUrl&quot;:&quot;https://res.cloudinary.com/dlcjuc3ej/image/upload/v1682608868/g4v1xjqqlbjq64qhyyoj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59a5b085-120a-40e1-a984-550ccd4d843d&quot;,&quot;order&quot;:&quot;5&quot;}},&quot;a2018b52-4321-4354-90f2-d6dbdbe7cc9a&quot;:{&quot;id&quot;:&quot;a2018b52-4321-4354-90f2-d6dbdbe7cc9a&quot;,&quot;name&quot;:&quot;B-cell (3D)&quot;,&quot;displayName&quot;:&quot;&quot;,&quot;type&quot;:&quot;FIGURE_OBJECT&quot;,&quot;relativeTransform&quot;:{&quot;translate&quot;:{&quot;x&quot;:328,&quot;y&quot;:-80.02508904718806},&quot;rotate&quot;:0,&quot;skewX&quot;:0,&quot;scale&quot;:{&quot;x&quot;:1,&quot;y&quot;:0.7221749808889655}},&quot;image&quot;:{&quot;url&quot;:&quot;https://icons.biorender.com/biorender/644a92ebc563ad0020d58f30/b-cell-3d.png&quot;,&quot;fallbackUrl&quot;:&quot;https://res.cloudinary.com/dlcjuc3ej/image/upload/v1682608868/g4v1xjqqlbjq64qhyyoj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#/keystone/api/icons/644a92ebc563ad0020d58f30/b-cell-3d.svg&quot;,&quot;isPremium&quot;:true,&quot;size&quot;:{&quot;x&quot;:100,&quot;y&quot;:101.76125244618395}},&quot;source&quot;:{&quot;id&quot;:&quot;644a91b3c563ad0020d58eff&quot;,&quot;version&quot;:1682608868,&quot;type&quot;:&quot;ASSETS&quot;},&quot;isPremium&quot;:true,&quot;parent&quot;:{&quot;type&quot;:&quot;CHILD&quot;,&quot;parentId&quot;:&quot;59a5b085-120a-40e1-a984-550ccd4d843d&quot;,&quot;order&quot;:&quot;7&quot;}},&quot;d4a6c9d9-b6c9-400b-bbd9-2a10512cdb44&quot;:{&quot;id&quot;:&quot;d4a6c9d9-b6c9-400b-bbd9-2a10512cdb44&quot;,&quot;type&quot;:&quot;FIGURE_OBJECT&quot;,&quot;relativeTransform&quot;:{&quot;translate&quot;:{&quot;x&quot;:-380,&quot;y&quot;:-192.651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13]}],&quot;text&quot;:&quot;pre-pro-B cell&quot;}],&quot;_lastCaretLocation&quot;:{&quot;lineIndex&quot;:0,&quot;runIndex&quot;:0,&quot;charIndex&quot;:8}},&quot;format&quot;:&quot;BETTER_TEXT&quot;,&quot;size&quot;:{&quot;x&quot;:120,&quot;y&quot;:24.24},&quot;targetSize&quot;:{&quot;x&quot;:120,&quot;y&quot;:24.24}},&quot;parent&quot;:{&quot;type&quot;:&quot;CHILD&quot;,&quot;parentId&quot;:&quot;0136aadf-2d1d-4007-aa27-48d911f34f19&quot;,&quot;order&quot;:&quot;5&quot;}},&quot;bae4df93-d0ce-4d36-9380-f0ae440aa3c6&quot;:{&quot;type&quot;:&quot;FIGURE_OBJECT&quot;,&quot;id&quot;:&quot;bae4df93-d0ce-4d36-9380-f0ae440aa3c6&quot;,&quot;parent&quot;:{&quot;type&quot;:&quot;CHILD&quot;,&quot;parentId&quot;:&quot;0136aadf-2d1d-4007-aa27-48d911f34f19&quot;,&quot;order&quot;:&quot;2&quot;},&quot;relativeTransform&quot;:{&quot;translate&quot;:{&quot;x&quot;:-18,&quot;y&quot;:18.729},&quot;rotate&quot;:0,&quot;skewX&quot;:0,&quot;scale&quot;:{&quot;x&quot;:1,&quot;y&quot;:1}}},&quot;77218720-f21b-4853-b92b-11c4d5dd4fbb&quot;:{&quot;type&quot;:&quot;FIGURE_OBJECT&quot;,&quot;id&quot;:&quot;77218720-f21b-4853-b92b-11c4d5dd4fbb&quot;,&quot;parent&quot;:{&quot;type&quot;:&quot;CHILD&quot;,&quot;parentId&quot;:&quot;7e7c7817-eac5-4199-abca-bd903f3adb9f&quot;,&quot;order&quot;:&quot;2&quot;},&quot;relativeTransform&quot;:{&quot;translate&quot;:{&quot;x&quot;:5.663999999999987,&quot;y&quot;:18.729000000000013},&quot;rotate&quot;:0,&quot;skewX&quot;:0,&quot;scale&quot;:{&quot;x&quot;:1,&quot;y&quot;:1}}},&quot;abd2c075-8687-493d-a266-8afbe8746ef2&quot;:{&quot;type&quot;:&quot;FIGURE_OBJECT&quot;,&quot;id&quot;:&quot;abd2c075-8687-493d-a266-8afbe8746ef2&quot;,&quot;parent&quot;:{&quot;type&quot;:&quot;CHILD&quot;,&quot;parentId&quot;:&quot;d788417b-1fc7-4f59-8eae-70605ccaa256&quot;,&quot;order&quot;:&quot;2&quot;},&quot;relativeTransform&quot;:{}},&quot;59a5b085-120a-40e1-a984-550ccd4d843d&quot;:{&quot;type&quot;:&quot;FIGURE_OBJECT&quot;,&quot;id&quot;:&quot;59a5b085-120a-40e1-a984-550ccd4d843d&quot;,&quot;parent&quot;:{&quot;type&quot;:&quot;CHILD&quot;,&quot;parentId&quot;:&quot;4e1000f4-7398-4fc3-ba4b-bd87962ba772&quot;,&quot;order&quot;:&quot;2&quot;},&quot;relativeTransform&quot;:{&quot;translate&quot;:{&quot;x&quot;:15.5,&quot;y&quot;:-1},&quot;rotate&quot;:0,&quot;skewX&quot;:0,&quot;scale&quot;:{&quot;x&quot;:1,&quot;y&quot;:1}}},&quot;39cd2f7e-6fe9-42f4-889d-6e366264535f&quot;:{&quot;id&quot;:&quot;39cd2f7e-6fe9-42f4-889d-6e366264535f&quot;,&quot;type&quot;:&quot;FIGURE_OBJECT&quot;,&quot;relativeTransform&quot;:{&quot;translate&quot;:{&quot;x&quot;:-135.836,&quot;y&quot;:-192.65099999999998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9]}],&quot;text&quot;:&quot;pro-B cell&quot;}],&quot;_lastCaretLocation&quot;:{&quot;lineIndex&quot;:0,&quot;runIndex&quot;:0,&quot;charIndex&quot;:4}},&quot;format&quot;:&quot;BETTER_TEXT&quot;,&quot;size&quot;:{&quot;x&quot;:82,&quot;y&quot;:24.24},&quot;targetSize&quot;:{&quot;x&quot;:82,&quot;y&quot;:24.24}},&quot;parent&quot;:{&quot;type&quot;:&quot;CHILD&quot;,&quot;parentId&quot;:&quot;7e7c7817-eac5-4199-abca-bd903f3adb9f&quot;,&quot;order&quot;:&quot;5&quot;}},&quot;9d3b7d7f-4a5c-4e35-9718-e3c275422526&quot;:{&quot;id&quot;:&quot;9d3b7d7f-4a5c-4e35-9718-e3c275422526&quot;,&quot;type&quot;:&quot;FIGURE_OBJECT&quot;,&quot;relativeTransform&quot;:{&quot;translate&quot;:{&quot;x&quot;:77.5,&quot;y&quot;:-211.38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9]}],&quot;text&quot;:&quot;pre-B cell&quot;}],&quot;_lastCaretLocation&quot;:{&quot;lineIndex&quot;:0,&quot;runIndex&quot;:0,&quot;charIndex&quot;:4}},&quot;format&quot;:&quot;BETTER_TEXT&quot;,&quot;size&quot;:{&quot;x&quot;:83,&quot;y&quot;:24.24},&quot;targetSize&quot;:{&quot;x&quot;:83,&quot;y&quot;:24.24}},&quot;parent&quot;:{&quot;type&quot;:&quot;CHILD&quot;,&quot;parentId&quot;:&quot;d788417b-1fc7-4f59-8eae-70605ccaa256&quot;,&quot;order&quot;:&quot;5&quot;}},&quot;f93dee06-32bb-49f0-9a52-cfd8f2aaf507&quot;:{&quot;id&quot;:&quot;f93dee06-32bb-49f0-9a52-cfd8f2aaf507&quot;,&quot;type&quot;:&quot;FIGURE_OBJECT&quot;,&quot;relativeTransform&quot;:{&quot;translate&quot;:{&quot;x&quot;:342.5,&quot;y&quot;:-208.95333333333332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14]}],&quot;text&quot;:&quot;Immature B cell&quot;}],&quot;_lastCaretLocation&quot;:{&quot;lineIndex&quot;:0,&quot;runIndex&quot;:-1,&quot;charIndex&quot;:-1,&quot;endOfLine&quot;:true}},&quot;format&quot;:&quot;BETTER_TEXT&quot;,&quot;size&quot;:{&quot;x&quot;:139,&quot;y&quot;:31.093333333333348},&quot;targetSize&quot;:{&quot;x&quot;:139,&quot;y&quot;:31.093333333333348}},&quot;parent&quot;:{&quot;type&quot;:&quot;CHILD&quot;,&quot;parentId&quot;:&quot;4e1000f4-7398-4fc3-ba4b-bd87962ba772&quot;,&quot;order&quot;:&quot;5&quot;}},&quot;6b669855-354c-48e7-861e-e7ee2eb82d9a&quot;:{&quot;id&quot;:&quot;6b669855-354c-48e7-861e-e7ee2eb82d9a&quot;,&quot;type&quot;:&quot;FIGURE_OBJECT&quot;,&quot;relativeTransform&quot;:{&quot;translate&quot;:{&quot;x&quot;:-378.5000029296875,&quot;y&quot;:-95.93200000000002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bold&quot;,&quot;fontStyle&quot;:&quot;normal&quot;,&quot;decoration&quot;:&quot;none&quot;},&quot;range&quot;:[0,2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3,3]}],&quot;text&quot;:&quot;IgM-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19-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43+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super&quot;}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24-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_lastCaretLocation&quot;:{&quot;lineIndex&quot;:2,&quot;runIndex&quot;:1,&quot;charIndex&quot;:4}},&quot;format&quot;:&quot;BETTER_TEXT&quot;,&quot;size&quot;:{&quot;x&quot;:104.343994140625,&quot;y&quot;:85.27999999999999},&quot;targetSize&quot;:{&quot;x&quot;:55.000000000000014,&quot;y&quot;:85.27999999999999}},&quot;parent&quot;:{&quot;type&quot;:&quot;CHILD&quot;,&quot;parentId&quot;:&quot;0136aadf-2d1d-4007-aa27-48d911f34f19&quot;,&quot;order&quot;:&quot;7&quot;}},&quot;987c5ba9-7244-4403-b6b7-0cc216e63ad0&quot;:{&quot;id&quot;:&quot;987c5ba9-7244-4403-b6b7-0cc216e63ad0&quot;,&quot;type&quot;:&quot;FIGURE_OBJECT&quot;,&quot;relativeTransform&quot;:{&quot;translate&quot;:{&quot;x&quot;:-157.50023107910155,&quot;y&quot;:-90.69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bold&quot;,&quot;fontStyle&quot;:&quot;normal&quot;,&quot;decoration&quot;:&quot;none&quot;},&quot;range&quot;:[0,2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3,3]}],&quot;text&quot;:&quot;IgM-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19+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43+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6]}],&quot;text&quot;:&quot;CD24int&quot;}],&quot;_lastCaretLocation&quot;:{&quot;lineIndex&quot;:1,&quot;runIndex&quot;:1,&quot;charIndex&quot;:4}},&quot;format&quot;:&quot;BETTER_TEXT&quot;,&quot;size&quot;:{&quot;x&quot;:66.25753784179688,&quot;y&quot;:85.27999999999999},&quot;targetSize&quot;:{&quot;x&quot;:55.000000000000014,&quot;y&quot;:85.27999999999999}},&quot;parent&quot;:{&quot;type&quot;:&quot;CHILD&quot;,&quot;parentId&quot;:&quot;7e7c7817-eac5-4199-abca-bd903f3adb9f&quot;,&quot;order&quot;:&quot;7&quot;}},&quot;cd9a1e0f-e1f6-452a-82e3-6251ed03981f&quot;:{&quot;id&quot;:&quot;cd9a1e0f-e1f6-452a-82e3-6251ed03981f&quot;,&quot;type&quot;:&quot;FIGURE_OBJECT&quot;,&quot;relativeTransform&quot;:{&quot;translate&quot;:{&quot;x&quot;:58.89922039794922,&quot;y&quot;:-114.6609999999999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bold&quot;,&quot;fontStyle&quot;:&quot;normal&quot;,&quot;decoration&quot;:&quot;none&quot;},&quot;range&quot;:[0,2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3,3]}],&quot;text&quot;:&quot;IgM-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19+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6]}],&quot;text&quot;:&quot;CD43low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24+&quot;,&quot;baseStyle&quot;:{&quot;fontFamily&quot;:&quot;Roboto&quot;,&quot;fontSize&quot;:40,&quot;color&quot;:&quot;black&quot;,&quot;fontWeight&quot;:&quot;normal&quot;,&quot;fontStyle&quot;:&quot;normal&quot;,&quot;decoration&quot;:&quot;none&quot;,&quot;script&quot;:&quot;super&quot;}}],&quot;_lastCaretLocation&quot;:{&quot;lineIndex&quot;:2,&quot;runIndex&quot;:1,&quot;charIndex&quot;:4}},&quot;format&quot;:&quot;BETTER_TEXT&quot;,&quot;size&quot;:{&quot;x&quot;:67.14244079589844,&quot;y&quot;:85.27999999999999},&quot;targetSize&quot;:{&quot;x&quot;:55.000000000000014,&quot;y&quot;:85.27999999999999}},&quot;parent&quot;:{&quot;type&quot;:&quot;CHILD&quot;,&quot;parentId&quot;:&quot;d788417b-1fc7-4f59-8eae-70605ccaa256&quot;,&quot;order&quot;:&quot;7&quot;}},&quot;09d2174d-db2f-4ff6-8666-d0f087399ef2&quot;:{&quot;id&quot;:&quot;09d2174d-db2f-4ff6-8666-d0f087399ef2&quot;,&quot;type&quot;:&quot;FIGURE_OBJECT&quot;,&quot;relativeTransform&quot;:{&quot;translate&quot;:{&quot;x&quot;:351.5030212402344,&quot;y&quot;:-45.42200000000001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bold&quot;,&quot;fontStyle&quot;:&quot;normal&quot;,&quot;decoration&quot;:&quot;none&quot;},&quot;range&quot;:[0,2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3,3]}],&quot;text&quot;:&quot;IgM+&quot;},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super&quot;},&quot;range&quot;:[4,4]}],&quot;text&quot;:&quot;CD19+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super&quot;}}],&quot;_lastCaretLocation&quot;:{&quot;lineIndex&quot;:0,&quot;runIndex&quot;:1,&quot;charIndex&quot;:3}},&quot;format&quot;:&quot;BETTER_TEXT&quot;,&quot;size&quot;:{&quot;x&quot;:59.00604248046875,&quot;y&quot;:85.27999999999999},&quot;targetSize&quot;:{&quot;x&quot;:55.000000000000014,&quot;y&quot;:85.27999999999999}},&quot;parent&quot;:{&quot;type&quot;:&quot;CHILD&quot;,&quot;parentId&quot;:&quot;f5a62bab-889b-4952-a80d-9947ad5d0c8f&quot;,&quot;order&quot;:&quot;99997&quot;}},&quot;767e47f6-79c1-4b12-bba2-ff4f5424f747&quot;:{&quot;type&quot;:&quot;FIGURE_OBJECT&quot;,&quot;id&quot;:&quot;767e47f6-79c1-4b12-bba2-ff4f5424f747&quot;,&quot;relativeTransform&quot;:{&quot;translate&quot;:{&quot;x&quot;:-241,&quot;y&quot;:-63.422},&quot;rotate&quot;:0,&quot;skewX&quot;:0,&quot;scale&quot;:{&quot;x&quot;:1,&quot;y&quot;:1}},&quot;opacity&quot;:1,&quot;path&quot;:{&quot;type&quot;:&quot;POLY_LINE&quot;,&quot;points&quot;:[{&quot;x&quot;:-28,&quot;y&quot;:0},{&quot;x&quot;:28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},&quot;xUnits&quot;:&quot;PATH_LENGTH&quot;,&quot;yUnits&quot;:&quot;STROKE_WIDTH&quot;,&quot;isPremium&quot;:false},&quot;parent&quot;:{&quot;type&quot;:&quot;CHILD&quot;,&quot;parentId&quot;:&quot;f5a62bab-889b-4952-a80d-9947ad5d0c8f&quot;,&quot;order&quot;:&quot;99998&quot;},&quot;connectorInfo&quot;:{&quot;connectedObjects&quot;:[],&quot;type&quot;:&quot;LINE&quot;,&quot;offset&quot;:{&quot;x&quot;:0,&quot;y&quot;:0},&quot;bending&quot;:0.1,&quot;firstElementIsHead&quot;:true,&quot;customized&quot;:false}},&quot;0136aadf-2d1d-4007-aa27-48d911f34f19&quot;:{&quot;type&quot;:&quot;FIGURE_OBJECT&quot;,&quot;id&quot;:&quot;0136aadf-2d1d-4007-aa27-48d911f34f19&quot;,&quot;parent&quot;:{&quot;type&quot;:&quot;CHILD&quot;,&quot;parentId&quot;:&quot;f5a62bab-889b-4952-a80d-9947ad5d0c8f&quot;,&quot;order&quot;:&quot;9998&quot;},&quot;relativeTransform&quot;:{&quot;translate&quot;:{&quot;x&quot;:11,&quot;y&quot;:46},&quot;rotate&quot;:0,&quot;skewX&quot;:0,&quot;scale&quot;:{&quot;x&quot;:1,&quot;y&quot;:1}}},&quot;7e7c7817-eac5-4199-abca-bd903f3adb9f&quot;:{&quot;type&quot;:&quot;FIGURE_OBJECT&quot;,&quot;id&quot;:&quot;7e7c7817-eac5-4199-abca-bd903f3adb9f&quot;,&quot;parent&quot;:{&quot;type&quot;:&quot;CHILD&quot;,&quot;parentId&quot;:&quot;f5a62bab-889b-4952-a80d-9947ad5d0c8f&quot;,&quot;order&quot;:&quot;9999&quot;},&quot;relativeTransform&quot;:{&quot;translate&quot;:{&quot;x&quot;:11,&quot;y&quot;:46},&quot;rotate&quot;:0,&quot;skewX&quot;:0,&quot;scale&quot;:{&quot;x&quot;:1,&quot;y&quot;:1}}},&quot;04dc002e-5e7b-42e3-95cc-65df9b9fe569&quot;:{&quot;type&quot;:&quot;FIGURE_OBJECT&quot;,&quot;id&quot;:&quot;04dc002e-5e7b-42e3-95cc-65df9b9fe569&quot;,&quot;relativeTransform&quot;:{&quot;translate&quot;:{&quot;x&quot;:251.124,&quot;y&quot;:-59.422},&quot;rotate&quot;:0,&quot;skewX&quot;:0,&quot;scale&quot;:{&quot;x&quot;:1,&quot;y&quot;:1}},&quot;opacity&quot;:1,&quot;path&quot;:{&quot;type&quot;:&quot;POLY_LINE&quot;,&quot;points&quot;:[{&quot;x&quot;:-28,&quot;y&quot;:0},{&quot;x&quot;:28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},&quot;xUnits&quot;:&quot;PATH_LENGTH&quot;,&quot;yUnits&quot;:&quot;STROKE_WIDTH&quot;,&quot;isPremium&quot;:false},&quot;parent&quot;:{&quot;type&quot;:&quot;CHILD&quot;,&quot;parentId&quot;:&quot;f5a62bab-889b-4952-a80d-9947ad5d0c8f&quot;,&quot;order&quot;:&quot;99999&quot;},&quot;connectorInfo&quot;:{&quot;connectedObjects&quot;:[],&quot;type&quot;:&quot;LINE&quot;,&quot;offset&quot;:{&quot;x&quot;:0,&quot;y&quot;:0},&quot;bending&quot;:0.1,&quot;firstElementIsHead&quot;:true,&quot;customized&quot;:false}},&quot;2c199352-ccef-4685-a08f-e69d16614ad4&quot;:{&quot;type&quot;:&quot;FIGURE_OBJECT&quot;,&quot;id&quot;:&quot;2c199352-ccef-4685-a08f-e69d16614ad4&quot;,&quot;relativeTransform&quot;:{&quot;translate&quot;:{&quot;x&quot;:-3.5039999999999907,&quot;y&quot;:-61.422},&quot;rotate&quot;:0,&quot;skewX&quot;:0,&quot;scale&quot;:{&quot;x&quot;:1,&quot;y&quot;:1}},&quot;opacity&quot;:1,&quot;path&quot;:{&quot;type&quot;:&quot;POLY_LINE&quot;,&quot;points&quot;:[{&quot;x&quot;:-28,&quot;y&quot;:0},{&quot;x&quot;:28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},&quot;xUnits&quot;:&quot;PATH_LENGTH&quot;,&quot;yUnits&quot;:&quot;STROKE_WIDTH&quot;,&quot;isPremium&quot;:false},&quot;parent&quot;:{&quot;type&quot;:&quot;CHILD&quot;,&quot;parentId&quot;:&quot;f5a62bab-889b-4952-a80d-9947ad5d0c8f&quot;,&quot;order&quot;:&quot;999995&quot;},&quot;connectorInfo&quot;:{&quot;connectedObjects&quot;:[],&quot;type&quot;:&quot;LINE&quot;,&quot;offset&quot;:{&quot;x&quot;:0,&quot;y&quot;:0},&quot;bending&quot;:0.1,&quot;firstElementIsHead&quot;:true,&quot;customized&quot;:false}},&quot;d788417b-1fc7-4f59-8eae-70605ccaa256&quot;:{&quot;type&quot;:&quot;FIGURE_OBJECT&quot;,&quot;id&quot;:&quot;d788417b-1fc7-4f59-8eae-70605ccaa256&quot;,&quot;parent&quot;:{&quot;type&quot;:&quot;CHILD&quot;,&quot;parentId&quot;:&quot;f5a62bab-889b-4952-a80d-9947ad5d0c8f&quot;,&quot;order&quot;:&quot;99995&quot;},&quot;relativeTransform&quot;:{&quot;translate&quot;:{&quot;x&quot;:48.41600000000001,&quot;y&quot;:64.729},&quot;rotate&quot;:0,&quot;skewX&quot;:0,&quot;scale&quot;:{&quot;x&quot;:1,&quot;y&quot;:1}}},&quot;4e1000f4-7398-4fc3-ba4b-bd87962ba772&quot;:{&quot;type&quot;:&quot;FIGURE_OBJECT&quot;,&quot;id&quot;:&quot;4e1000f4-7398-4fc3-ba4b-bd87962ba772&quot;,&quot;parent&quot;:{&quot;type&quot;:&quot;CHILD&quot;,&quot;parentId&quot;:&quot;f5a62bab-889b-4952-a80d-9947ad5d0c8f&quot;,&quot;order&quot;:&quot;9997&quot;},&quot;relativeTransform&quot;:{&quot;translate&quot;:{&quot;x&quot;:38.331999999999994,&quot;y&quot;:65.729},&quot;rotate&quot;:0,&quot;skewX&quot;:0,&quot;scale&quot;:{&quot;x&quot;:1,&quot;y&quot;:1}}}}}"/>
    <we:property name="66f52decf0b7b326262ee29f_1727344842863" value="{&quot;id&quot;:&quot;4d88cd9f-0e66-4345-9f4d-ba0af53c89dc&quot;,&quot;objects&quot;:{&quot;4d88cd9f-0e66-4345-9f4d-ba0af53c89dc&quot;:{&quot;id&quot;:&quot;4d88cd9f-0e66-4345-9f4d-ba0af53c89dc&quot;,&quot;type&quot;:&quot;FIGURE_OBJECT&quot;,&quot;document&quot;:{&quot;type&quot;:&quot;DOCUMENT_GROUP&quot;,&quot;canvasType&quot;:&quot;FIGURE&quot;,&quot;units&quot;:&quot;in&quot;}},&quot;f09b374c-75af-4b39-b8a2-ad6bdc18618f&quot;:{&quot;id&quot;:&quot;f09b374c-75af-4b39-b8a2-ad6bdc18618f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4d88cd9f-0e66-4345-9f4d-ba0af53c89dc&quot;,&quot;type&quot;:&quot;FRAME&quot;,&quot;order&quot;:&quot;5&quot;}},&quot;4c440177-a32b-4666-8298-fe8cd531eb60&quot;:{&quot;id&quot;:&quot;4c440177-a32b-4666-8298-fe8cd531eb60&quot;,&quot;type&quot;:&quot;FIGURE_OBJECT&quot;,&quot;document&quot;:{&quot;type&quot;:&quot;FIGURE&quot;,&quot;canvasType&quot;:&quot;FIGURE&quot;,&quot;units&quot;:&quot;in&quot;},&quot;parent&quot;:{&quot;parentId&quot;:&quot;4d88cd9f-0e66-4345-9f4d-ba0af53c89dc&quot;,&quot;type&quot;:&quot;DOCUMENT&quot;,&quot;order&quot;:&quot;5&quot;},&quot;layout&quot;:{&quot;sizeRatio&quot;:{&quot;x&quot;:0.88,&quot;y&quot;:0.88},&quot;keepAspectRatio&quot;:false}},&quot;addc93bc-7293-4f28-b6b7-e46e2d83fbc5&quot;:{&quot;id&quot;:&quot;addc93bc-7293-4f28-b6b7-e46e2d83fbc5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4c440177-a32b-4666-8298-fe8cd531eb60&quot;,&quot;order&quot;:&quot;5&quot;}},&quot;77edc7e2-bb7c-459b-b8e2-da24e7714ce9&quot;:{&quot;id&quot;:&quot;77edc7e2-bb7c-459b-b8e2-da24e7714ce9&quot;,&quot;type&quot;:&quot;FIGURE_OBJECT&quot;,&quot;guide&quot;:{&quot;type&quot;:&quot;GRID&quot;,&quot;distance&quot;:0.5,&quot;units&quot;:&quot;in&quot;},&quot;parent&quot;:{&quot;parentId&quot;:&quot;4d88cd9f-0e66-4345-9f4d-ba0af53c89dc&quot;,&quot;type&quot;:&quot;GUIDE&quot;,&quot;order&quot;:&quot;5&quot;}},&quot;8bb56151-18d8-4ab9-9959-591b6737725c&quot;:{&quot;id&quot;:&quot;8bb56151-18d8-4ab9-9959-591b6737725c&quot;,&quot;name&quot;:&quot;Mouse (symbol)&quot;,&quot;displayName&quot;:&quot;&quot;,&quot;type&quot;:&quot;FIGURE_OBJECT&quot;,&quot;relativeTransform&quot;:{&quot;translate&quot;:{&quot;x&quot;:-77.1948055805056,&quot;y&quot;:-110.8532211542191},&quot;rotate&quot;:0,&quot;skewX&quot;:0,&quot;scale&quot;:{&quot;x&quot;:0.9006710766240088,&quot;y&quot;:0.9006710766240088}},&quot;image&quot;:{&quot;url&quot;:&quot;https://icons.biorender.com/biorender/601c2818b376e300280e707d/mouse-icon.png&quot;,&quot;fallbackUrl&quot;:&quot;https://res.cloudinary.com/dlcjuc3ej/image/upload/v1612458006/kn3jq2u5chw7uq36babw.svg#/keystone/api/icons/601c2818b376e300280e707d/mouse-icon.svg#/keystone/api/icons/601c2818b376e300280e707d/mouse-icon.svg#/keystone/api/icons/601c2818b376e300280e707d/mouse-icon.svg#/keystone/api/icons/601c2818b376e300280e707d/mouse-icon.svg#/keystone/api/icons/601c2818b376e300280e707d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4c440177-a32b-4666-8298-fe8cd531eb60&quot;,&quot;order&quot;:&quot;9972&quot;}},&quot;8d410f31-af40-4c27-b301-23c65f9bd430&quot;:{&quot;id&quot;:&quot;8d410f31-af40-4c27-b301-23c65f9bd430&quot;,&quot;name&quot;:&quot;Mouse (symbol)&quot;,&quot;displayName&quot;:&quot;&quot;,&quot;type&quot;:&quot;FIGURE_OBJECT&quot;,&quot;relativeTransform&quot;:{&quot;translate&quot;:{&quot;x&quot;:58.14615872415131,&quot;y&quot;:-110.83843500681658},&quot;rotate&quot;:0,&quot;skewX&quot;:0,&quot;scale&quot;:{&quot;x&quot;:0.9001810766240091,&quot;y&quot;:0.9001810766240091}},&quot;image&quot;:{&quot;url&quot;:&quot;https://icons.biorender.com/biorender/5fb58802d6bd96002858258b/mouse-icon.png&quot;,&quot;fallbackUrl&quot;:&quot;https://res.cloudinary.com/dlcjuc3ej/image/upload/v1605732349/rimrj4n97wjez1yibmcx.svg#/keystone/api/icons/5fb58802d6bd96002858258b/mouse-icon.svg#/keystone/api/icons/5fb58802d6bd96002858258b/mouse-icon.svg#/keystone/api/icons/5fb58802d6bd96002858258b/mouse-icon.svg#/keystone/api/icons/5fb58802d6bd96002858258b/mouse-icon.svg#/keystone/api/icons/5fb58802d6bd96002858258b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4c440177-a32b-4666-8298-fe8cd531eb60&quot;,&quot;order&quot;:&quot;9975&quot;}},&quot;5133087f-9ab8-4e81-ba6d-4f67e1437bca&quot;:{&quot;id&quot;:&quot;5133087f-9ab8-4e81-ba6d-4f67e1437bca&quot;,&quot;name&quot;:&quot;Cell sorter (BD FACSAria II)&quot;,&quot;displayName&quot;:&quot;&quot;,&quot;type&quot;:&quot;FIGURE_OBJECT&quot;,&quot;relativeTransform&quot;:{&quot;translate&quot;:{&quot;x&quot;:-10.540816869141214,&quot;y&quot;:71.89234719729649},&quot;rotate&quot;:0,&quot;skewX&quot;:0,&quot;scale&quot;:{&quot;x&quot;:0.6315360146045844,&quot;y&quot;:0.6315360146045844}},&quot;image&quot;:{&quot;url&quot;:&quot;https://icons.biorender.com/biorender/5c98edd48afb2d330057e73e/20190325150511/image/cell-sorter-bd-facsaria-ii.png&quot;,&quot;fallbackUrl&quot;:&quot;https://res.cloudinary.com/dlcjuc3ej/image/upload/v1553526311/perdko6um69f9hwk0zls.svg#/keystone/api/icons/5c98edd48afb2d330057e73e/20190325150511/image/cell-sorter-bd-facsaria-ii.svg&quot;,&quot;isPremium&quot;:false,&quot;size&quot;:{&quot;x&quot;:200,&quot;y&quot;:112.92517006802721}},&quot;source&quot;:{&quot;id&quot;:&quot;5c98edd48afb2d330057e73e&quot;,&quot;type&quot;:&quot;ASSETS&quot;},&quot;isPremium&quot;:false,&quot;parent&quot;:{&quot;type&quot;:&quot;CHILD&quot;,&quot;parentId&quot;:&quot;4c440177-a32b-4666-8298-fe8cd531eb60&quot;,&quot;order&quot;:&quot;99995&quot;},&quot;opacity&quot;:0.44},&quot;2c6943b7-bfa5-4c3a-8210-cab8ac7dc7c9&quot;:{&quot;id&quot;:&quot;2c6943b7-bfa5-4c3a-8210-cab8ac7dc7c9&quot;,&quot;type&quot;:&quot;FIGURE_OBJECT&quot;,&quot;relativeTransform&quot;:{&quot;translate&quot;:{&quot;x&quot;:-14.546992206467458,&quot;y&quot;:71.89166299361665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range&quot;:[0,2],&quot;style&quot;:{&quot;fontWeight&quot;:&quot;normal&quot;,&quot;fontStyle&quot;:&quot;normal&quot;,&quot;fontSize&quot;:13.633638433682004,&quot;fontFamily&quot;:&quot;Roboto&quot;,&quot;color&quot;:&quot;black&quot;,&quot;decoration&quot;:&quot;none&quot;}},{&quot;range&quot;:[3,4],&quot;style&quot;:{&quot;fontWeight&quot;:&quot;normal&quot;,&quot;fontStyle&quot;:&quot;normal&quot;,&quot;script&quot;:&quot;super&quot;,&quot;fontSize&quot;:13.633638433682004,&quot;fontFamily&quot;:&quot;Roboto&quot;,&quot;color&quot;:&quot;black&quot;,&quot;decoration&quot;:&quot;none&quot;}},{&quot;range&quot;:[5,7],&quot;style&quot;:{&quot;fontWeight&quot;:&quot;normal&quot;,&quot;fontStyle&quot;:&quot;normal&quot;,&quot;fontSize&quot;:13.633638433682004,&quot;fontFamily&quot;:&quot;Roboto&quot;,&quot;color&quot;:&quot;black&quot;,&quot;decoration&quot;:&quot;none&quot;}},{&quot;range&quot;:[8,9],&quot;style&quot;:{&quot;fontWeight&quot;:&quot;normal&quot;,&quot;fontStyle&quot;:&quot;normal&quot;,&quot;script&quot;:&quot;super&quot;,&quot;fontSize&quot;:13.633638433682004,&quot;fontFamily&quot;:&quot;Roboto&quot;,&quot;color&quot;:&quot;black&quot;,&quot;decoration&quot;:&quot;none&quot;}},{&quot;range&quot;:[10,12],&quot;style&quot;:{&quot;fontWeight&quot;:&quot;normal&quot;,&quot;fontStyle&quot;:&quot;normal&quot;,&quot;fontSize&quot;:13.633638433682004,&quot;fontFamily&quot;:&quot;Roboto&quot;,&quot;color&quot;:&quot;black&quot;,&quot;decoration&quot;:&quot;none&quot;}},{&quot;range&quot;:[13,13],&quot;style&quot;:{&quot;fontWeight&quot;:&quot;normal&quot;,&quot;fontStyle&quot;:&quot;normal&quot;,&quot;script&quot;:&quot;super&quot;,&quot;fontSize&quot;:13.633638433682004,&quot;fontFamily&quot;:&quot;Roboto&quot;,&quot;color&quot;:&quot;black&quot;,&quot;decoration&quot;:&quot;none&quot;}}],&quot;text&quot;:&quot;Lin- Kit+ Sca+&quot;},{&quot;runs&quot;:[{&quot;range&quot;:[0,3],&quot;style&quot;:{&quot;fontWeight&quot;:&quot;normal&quot;,&quot;fontStyle&quot;:&quot;normal&quot;,&quot;fontSize&quot;:13.633638433682004,&quot;fontFamily&quot;:&quot;Roboto&quot;,&quot;color&quot;:&quot;black&quot;,&quot;decoration&quot;:&quot;none&quot;}},{&quot;range&quot;:[4,5],&quot;style&quot;:{&quot;fontWeight&quot;:&quot;normal&quot;,&quot;fontStyle&quot;:&quot;normal&quot;,&quot;script&quot;:&quot;super&quot;,&quot;fontSize&quot;:13.633638433682004,&quot;fontFamily&quot;:&quot;Roboto&quot;,&quot;color&quot;:&quot;black&quot;,&quot;decoration&quot;:&quot;none&quot;}},{&quot;range&quot;:[6,10],&quot;style&quot;:{&quot;fontWeight&quot;:&quot;normal&quot;,&quot;fontStyle&quot;:&quot;normal&quot;,&quot;fontSize&quot;:13.633638433682004,&quot;fontFamily&quot;:&quot;Roboto&quot;,&quot;color&quot;:&quot;black&quot;,&quot;decoration&quot;:&quot;none&quot;}},{&quot;range&quot;:[11,11],&quot;style&quot;:{&quot;fontWeight&quot;:&quot;normal&quot;,&quot;fontStyle&quot;:&quot;normal&quot;,&quot;script&quot;:&quot;super&quot;,&quot;fontSize&quot;:13.633638433682004,&quot;fontFamily&quot;:&quot;Roboto&quot;,&quot;color&quot;:&quot;black&quot;,&quot;decoration&quot;:&quot;none&quot;}}],&quot;text&quot;:&quot;CD48- CD150+&quot;}],&quot;_lastCaretLocation&quot;:{&quot;lineIndex&quot;:1,&quot;runIndex&quot;:2,&quot;charIndex&quot;:6}},&quot;format&quot;:&quot;BETTER_TEXT&quot;,&quot;size&quot;:{&quot;x&quot;:118.29446594782247,&quot;y&quot;:31.474228155471604},&quot;targetSize&quot;:{&quot;x&quot;:118.29446594782247,&quot;y&quot;:31.474228155471604}},&quot;parent&quot;:{&quot;type&quot;:&quot;CHILD&quot;,&quot;parentId&quot;:&quot;4c440177-a32b-4666-8298-fe8cd531eb60&quot;,&quot;order&quot;:&quot;99997&quot;}},&quot;1e845433-6dc8-4295-863c-8062f1d1e8aa&quot;:{&quot;id&quot;:&quot;1e845433-6dc8-4295-863c-8062f1d1e8aa&quot;,&quot;name&quot;:&quot;Mouse femur (medial)&quot;,&quot;displayName&quot;:&quot;Mouse femur (medial)&quot;,&quot;type&quot;:&quot;FIGURE_OBJECT&quot;,&quot;relativeTransform&quot;:{&quot;translate&quot;:{&quot;x&quot;:-6.458228716827438,&quot;y&quot;:-18.411167783908716},&quot;rotate&quot;:-1.800040822834396,&quot;skewX&quot;:1.6964724338884539e-16,&quot;scale&quot;:{&quot;x&quot;:0.6395459013157464,&quot;y&quot;:0.6395459013157474}},&quot;image&quot;:{&quot;url&quot;:&quot;https://icons.biorender.com/biorender/5cf18c2948bc020400d6b447/20190531202258/image/mouse-leg-bone-femur.png&quot;,&quot;fallbackUrl&quot;:&quot;https://res.cloudinary.com/dlcjuc3ej/image/upload/v1559334178/gwkysko8kegku192nb9i.svg#/keystone/api/icons/5cf18c2948bc020400d6b447/20190531202258/image/mouse-leg-bone-femur.svg&quot;,&quot;isPremium&quot;:false,&quot;size&quot;:{&quot;x&quot;:50,&quot;y&quot;:152.2922636103152}},&quot;source&quot;:{&quot;id&quot;:&quot;5cf18c2948bc020400d6b447&quot;,&quot;type&quot;:&quot;ASSETS&quot;},&quot;isPremium&quot;:false,&quot;parent&quot;:{&quot;type&quot;:&quot;CHILD&quot;,&quot;parentId&quot;:&quot;4c440177-a32b-4666-8298-fe8cd531eb60&quot;,&quot;order&quot;:&quot;9999995&quot;}},&quot;13c0bdec-ca16-40f9-9c33-cf95f4cc3f86&quot;:{&quot;id&quot;:&quot;13c0bdec-ca16-40f9-9c33-cf95f4cc3f86&quot;,&quot;type&quot;:&quot;FIGURE_OBJECT&quot;,&quot;relativeTransform&quot;:{&quot;translate&quot;:{&quot;x&quot;:-10.058831788027994,&quot;y&quot;:131.207766396950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23.57943324757713,&quot;color&quot;:&quot;black&quot;,&quot;fontWeight&quot;:&quot;normal&quot;,&quot;fontStyle&quot;:&quot;normal&quot;,&quot;decoration&quot;:&quot;none&quot;},&quot;range&quot;:[0,5]}],&quot;text&quot;:&quot;RNAseq&quot;}]},&quot;format&quot;:&quot;BETTER_TEXT&quot;,&quot;size&quot;:{&quot;x&quot;:90.46811225905208,&quot;y&quot;:30.619578317210873},&quot;targetSize&quot;:{&quot;x&quot;:90.46811225905208,&quot;y&quot;:30.619578317210873}},&quot;parent&quot;:{&quot;type&quot;:&quot;CHILD&quot;,&quot;parentId&quot;:&quot;4c440177-a32b-4666-8298-fe8cd531eb60&quot;,&quot;order&quot;:&quot;999995&quot;}},&quot;1be83998-337f-489e-bc8f-6e0f6bf7ca4a&quot;:{&quot;type&quot;:&quot;FIGURE_OBJECT&quot;,&quot;id&quot;:&quot;1be83998-337f-489e-bc8f-6e0f6bf7ca4a&quot;,&quot;relativeTransform&quot;:{&quot;translate&quot;:{&quot;x&quot;:-63.93,&quot;y&quot;:-80.05670283470847},&quot;rotate&quot;:0,&quot;skewX&quot;:0,&quot;scale&quot;:{&quot;x&quot;:1,&quot;y&quot;:1}},&quot;opacity&quot;:1,&quot;path&quot;:{&quot;type&quot;:&quot;POLY_LINE&quot;,&quot;points&quot;:[{&quot;x&quot;:20.848113955133925,&quot;y&quot;:27.226973246760256},{&quot;x&quot;:34.34563224176311,&quot;y&quot;:68.23109618095708},{&quot;x&quot;:36,&quot;y&quot;:106.94272588872178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&quot;translate&quot;:{&quot;x&quot;:0,&quot;y&quot;:0},&quot;rotate&quot;:3.141592653589793,&quot;skewX&quot;:0,&quot;scale&quot;:{&quot;x&quot;:-1,&quot;y&quot;:1}},&quot;xUnits&quot;:&quot;PATH_LENGTH&quot;,&quot;yUnits&quot;:&quot;STROKE_WIDTH&quot;,&quot;isPremium&quot;:false},&quot;parent&quot;:{&quot;type&quot;:&quot;CHILD&quot;,&quot;parentId&quot;:&quot;4c440177-a32b-4666-8298-fe8cd531eb60&quot;,&quot;order&quot;:&quot;999997&quot;},&quot;connectorInfo&quot;:{&quot;connectedObjects&quot;:[],&quot;type&quot;:&quot;QUADRATIC&quot;,&quot;offset&quot;:{&quot;x&quot;:0,&quot;y&quot;:0},&quot;bending&quot;:-0.1,&quot;firstElementIsHead&quot;:false,&quot;customized&quot;:false}},&quot;317798ba-09fb-469d-b5fd-ccfa4c7a90db&quot;:{&quot;id&quot;:&quot;317798ba-09fb-469d-b5fd-ccfa4c7a90db&quot;,&quot;type&quot;:&quot;FIGURE_OBJECT&quot;,&quot;relativeTransform&quot;:{&quot;translate&quot;:{&quot;x&quot;:72.047,&quot;y&quot;:-65.9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range&quot;:[0,3],&quot;style&quot;:{&quot;fontWeight&quot;:&quot;normal&quot;,&quot;fontStyle&quot;:&quot;normal&quot;,&quot;fontSize&quot;:18.666666666666664,&quot;fontFamily&quot;:&quot;Roboto&quot;,&quot;color&quot;:&quot;black&quot;,&quot;decoration&quot;:&quot;none&quot;}},{&quot;range&quot;:[4,12],&quot;style&quot;:{&quot;fontWeight&quot;:&quot;normal&quot;,&quot;fontStyle&quot;:&quot;normal&quot;,&quot;script&quot;:&quot;super&quot;,&quot;fontSize&quot;:18.666666666666664,&quot;fontFamily&quot;:&quot;Roboto&quot;,&quot;color&quot;:&quot;black&quot;,&quot;decoration&quot;:&quot;none&quot;}}],&quot;text&quot;:&quot;P2H1Ad.Cortex&quot;}],&quot;_lastCaretLocation&quot;:{&quot;lineIndex&quot;:0,&quot;runIndex&quot;:-1,&quot;charIndex&quot;:-1,&quot;endOfLine&quot;:true}},&quot;format&quot;:&quot;BETTER_TEXT&quot;,&quot;size&quot;:{&quot;x&quot;:120,&quot;y&quot;:24.24},&quot;targetSize&quot;:{&quot;x&quot;:120,&quot;y&quot;:24.24}},&quot;parent&quot;:{&quot;type&quot;:&quot;CHILD&quot;,&quot;parentId&quot;:&quot;4c440177-a32b-4666-8298-fe8cd531eb60&quot;,&quot;order&quot;:&quot;999998&quot;}},&quot;37dabfd7-f1f2-48fa-9de5-7ae1414f0e87&quot;:{&quot;type&quot;:&quot;FIGURE_OBJECT&quot;,&quot;id&quot;:&quot;37dabfd7-f1f2-48fa-9de5-7ae1414f0e87&quot;,&quot;relativeTransform&quot;:{&quot;translate&quot;:{&quot;x&quot;:43.180717708113555,&quot;y&quot;:-80.05670283470847},&quot;rotate&quot;:-2.4492935982947064e-16,&quot;skewX&quot;:0,&quot;scale&quot;:{&quot;x&quot;:1,&quot;y&quot;:1}},&quot;opacity&quot;:1,&quot;path&quot;:{&quot;type&quot;:&quot;POLY_LINE&quot;,&quot;points&quot;:[{&quot;x&quot;:-20.848113955133925,&quot;y&quot;:27.226973246760256},{&quot;x&quot;:-34.34563224176311,&quot;y&quot;:68.23109618095708},{&quot;x&quot;:-36,&quot;y&quot;:106.94272588872178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thPattern&quot;:{&quot;type&quot;:&quot;ROW&quot;,&quot;patternObject&quot;:{&quot;name&quot;:&quot;triangle&quot;,&quot;path&quot;:{&quot;type&quot;:&quot;SPLINE&quot;,&quot;spline&quot;:{&quot;points&quot;:[{&quot;x&quot;:0,&quot;y&quot;:0,&quot;isEndPoint&quot;:true},{&quot;x&quot;:1,&quot;y&quot;:0.5,&quot;isEndPoint&quot;:true},{&quot;x&quot;:1,&quot;y&quot;:-0.5,&quot;isEndPoint&quot;:true}],&quot;closed&quot;:true}},&quot;pathStyles&quot;:[{&quot;type&quot;:&quot;FILL&quot;,&quot;fillStyle&quot;:&quot;context-stroke&quot;}]},&quot;bending&quot;:true,&quot;patternTransform&quot;:{&quot;translate&quot;:{&quot;x&quot;:0,&quot;y&quot;:0},&quot;rotate&quot;:1.2246467991473532e-16,&quot;skewX&quot;:0,&quot;scale&quot;:{&quot;x&quot;:1,&quot;y&quot;:1}},&quot;xUnits&quot;:&quot;PATH_LENGTH&quot;,&quot;yUnits&quot;:&quot;STROKE_WIDTH&quot;,&quot;isPremium&quot;:false},&quot;parent&quot;:{&quot;type&quot;:&quot;CHILD&quot;,&quot;parentId&quot;:&quot;4c440177-a32b-4666-8298-fe8cd531eb60&quot;,&quot;order&quot;:&quot;999999&quot;},&quot;connectorInfo&quot;:{&quot;connectedObjects&quot;:[],&quot;type&quot;:&quot;QUADRATIC&quot;,&quot;offset&quot;:{&quot;x&quot;:0,&quot;y&quot;:0},&quot;bending&quot;:-0.1,&quot;firstElementIsHead&quot;:false,&quot;customized&quot;:false}},&quot;667a73d1-c4d4-461f-8b13-343869482a08&quot;:{&quot;id&quot;:&quot;667a73d1-c4d4-461f-8b13-343869482a08&quot;,&quot;type&quot;:&quot;FIGURE_OBJECT&quot;,&quot;relativeTransform&quot;:{&quot;translate&quot;:{&quot;x&quot;:-61.86900000000002,&quot;y&quot;:-65.9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,&quot;range&quot;:[0,1]}],&quot;text&quot;:&quot;WT&quot;}],&quot;_lastCaretLocation&quot;:{&quot;lineIndex&quot;:0,&quot;runIndex&quot;:-1,&quot;charIndex&quot;:-1,&quot;endOfLine&quot;:true}},&quot;format&quot;:&quot;BETTER_TEXT&quot;,&quot;size&quot;:{&quot;x&quot;:52.14600000000001,&quot;y&quot;:24.24},&quot;targetSize&quot;:{&quot;x&quot;:52.14600000000001,&quot;y&quot;:24.24}},&quot;parent&quot;:{&quot;type&quot;:&quot;CHILD&quot;,&quot;parentId&quot;:&quot;4c440177-a32b-4666-8298-fe8cd531eb60&quot;,&quot;order&quot;:&quot;9999995&quot;}},&quot;faf22317-69a0-496e-b12d-a3076faabb0d&quot;:{&quot;type&quot;:&quot;FIGURE_OBJECT&quot;,&quot;id&quot;:&quot;faf22317-69a0-496e-b12d-a3076faabb0d&quot;,&quot;relativeTransform&quot;:{&quot;translate&quot;:{&quot;x&quot;:-9.71100000000002,&quot;y&quot;:2.842170943040401e-14},&quot;rotate&quot;:0},&quot;opacity&quot;:1,&quot;path&quot;:{&quot;type&quot;:&quot;RECT&quot;,&quot;size&quot;:{&quot;x&quot;:253.67200000000003,&quot;y&quot;:327.50000000000006},&quot;cornerRounding&quot;:{&quot;type&quot;:&quot;ARC_LENGTH&quot;,&quot;global&quot;:15.707963267948966}},&quot;pathStyles&quot;:[{&quot;type&quot;:&quot;FILL&quot;,&quot;fillStyle&quot;:&quot;rgba(255,255,255,1)&quot;},{&quot;type&quot;:&quot;STROKE&quot;,&quot;strokeStyle&quot;:&quot;rgba(112,112,113,1)&quot;,&quot;lineWidth&quot;:2,&quot;lineJoin&quot;:&quot;round&quot;}],&quot;isLocked&quot;:false,&quot;parent&quot;:{&quot;type&quot;:&quot;CHILD&quot;,&quot;parentId&quot;:&quot;4c440177-a32b-4666-8298-fe8cd531eb60&quot;,&quot;order&quot;:&quot;4&quot;}}}}"/>
    <we:property name="has-seen-first-time-experience" value="true"/>
    <we:property name="has-user-completed-add" value="true"/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ppt/webextensions/webextension2.xml><?xml version="1.0" encoding="utf-8"?>
<we:webextension xmlns:we="http://schemas.microsoft.com/office/webextensions/webextension/2010/11" id="{7C69E4AC-E9F4-449E-94FF-31ACFCC62941}">
  <we:reference id="wa200003915" version="2.0.0.0" store="en-US" storeType="OMEX"/>
  <we:alternateReferences>
    <we:reference id="WA200003915" version="2.0.0.0" store="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01</Words>
  <Application>Microsoft Office PowerPoint</Application>
  <PresentationFormat>Widescreen</PresentationFormat>
  <Paragraphs>40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10</vt:lpstr>
      <vt:lpstr>Prism 9</vt:lpstr>
      <vt:lpstr>PowerPoint Presentation</vt:lpstr>
      <vt:lpstr>PowerPoint Presentation</vt:lpstr>
      <vt:lpstr>PowerPoint Presentation</vt:lpstr>
    </vt:vector>
  </TitlesOfParts>
  <Company>uk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tts, Deepika</dc:creator>
  <cp:lastModifiedBy>Ben Wielockx</cp:lastModifiedBy>
  <cp:revision>214</cp:revision>
  <dcterms:created xsi:type="dcterms:W3CDTF">2022-07-12T11:14:03Z</dcterms:created>
  <dcterms:modified xsi:type="dcterms:W3CDTF">2025-03-25T22:49:54Z</dcterms:modified>
</cp:coreProperties>
</file>